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66" r:id="rId2"/>
    <p:sldId id="258" r:id="rId3"/>
    <p:sldId id="257" r:id="rId4"/>
    <p:sldId id="259" r:id="rId5"/>
    <p:sldId id="260" r:id="rId6"/>
    <p:sldId id="268" r:id="rId7"/>
    <p:sldId id="267" r:id="rId8"/>
    <p:sldId id="265"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Lindsay Hall (IFR)" initials="LH" lastIdx="2" clrIdx="0"/>
  <p:cmAuthor id="1" name="Melissa Lawson (QIB)" initials="ML(" lastIdx="4" clrIdx="1">
    <p:extLst>
      <p:ext uri="{19B8F6BF-5375-455C-9EA6-DF929625EA0E}">
        <p15:presenceInfo xmlns:p15="http://schemas.microsoft.com/office/powerpoint/2012/main" userId="S::lawsonm@nbi.ac.uk::df5f2281-4e38-4800-89f4-d0f7e3c40821" providerId="AD"/>
      </p:ext>
    </p:extLst>
  </p:cmAuthor>
  <p:cmAuthor id="2" name="Editor" initials="Editor" lastIdx="1" clrIdx="2">
    <p:extLst>
      <p:ext uri="{19B8F6BF-5375-455C-9EA6-DF929625EA0E}">
        <p15:presenceInfo xmlns:p15="http://schemas.microsoft.com/office/powerpoint/2012/main" userId="Editor" providerId="None"/>
      </p:ext>
    </p:extLst>
  </p:cmAuthor>
  <p:cmAuthor id="3" name="Deborah" initials="D" lastIdx="2" clrIdx="3">
    <p:extLst>
      <p:ext uri="{19B8F6BF-5375-455C-9EA6-DF929625EA0E}">
        <p15:presenceInfo xmlns:p15="http://schemas.microsoft.com/office/powerpoint/2012/main" userId="Deborah"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6019" autoAdjust="0"/>
    <p:restoredTop sz="96374" autoAdjust="0"/>
  </p:normalViewPr>
  <p:slideViewPr>
    <p:cSldViewPr snapToGrid="0">
      <p:cViewPr>
        <p:scale>
          <a:sx n="120" d="100"/>
          <a:sy n="120" d="100"/>
        </p:scale>
        <p:origin x="750" y="-60"/>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7D01795-42D5-45A3-A9A6-97AE68DB7805}" type="datetimeFigureOut">
              <a:rPr lang="en-GB" smtClean="0"/>
              <a:t>16/12/2019</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28E0052-E825-48D2-993D-F2A9D5C4B081}" type="slidenum">
              <a:rPr lang="en-GB" smtClean="0"/>
              <a:t>‹#›</a:t>
            </a:fld>
            <a:endParaRPr lang="en-GB"/>
          </a:p>
        </p:txBody>
      </p:sp>
    </p:spTree>
    <p:extLst>
      <p:ext uri="{BB962C8B-B14F-4D97-AF65-F5344CB8AC3E}">
        <p14:creationId xmlns:p14="http://schemas.microsoft.com/office/powerpoint/2010/main" val="38424526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Matthew re-doing</a:t>
            </a:r>
          </a:p>
        </p:txBody>
      </p:sp>
      <p:sp>
        <p:nvSpPr>
          <p:cNvPr id="4" name="Slide Number Placeholder 3"/>
          <p:cNvSpPr>
            <a:spLocks noGrp="1"/>
          </p:cNvSpPr>
          <p:nvPr>
            <p:ph type="sldNum" sz="quarter" idx="5"/>
          </p:nvPr>
        </p:nvSpPr>
        <p:spPr/>
        <p:txBody>
          <a:bodyPr/>
          <a:lstStyle/>
          <a:p>
            <a:fld id="{C28E0052-E825-48D2-993D-F2A9D5C4B081}" type="slidenum">
              <a:rPr lang="en-GB" smtClean="0"/>
              <a:t>4</a:t>
            </a:fld>
            <a:endParaRPr lang="en-GB"/>
          </a:p>
        </p:txBody>
      </p:sp>
    </p:spTree>
    <p:extLst>
      <p:ext uri="{BB962C8B-B14F-4D97-AF65-F5344CB8AC3E}">
        <p14:creationId xmlns:p14="http://schemas.microsoft.com/office/powerpoint/2010/main" val="243615124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err="1"/>
              <a:t>Shab</a:t>
            </a:r>
            <a:r>
              <a:rPr lang="en-GB" dirty="0"/>
              <a:t> is doing another Figure for this.</a:t>
            </a:r>
          </a:p>
          <a:p>
            <a:r>
              <a:rPr lang="en-GB" dirty="0"/>
              <a:t>The quality also needs to be improved as it is too pixelated to read at higher magnification. Bacteria names also need to be in italics</a:t>
            </a:r>
          </a:p>
          <a:p>
            <a:r>
              <a:rPr lang="en-GB" dirty="0"/>
              <a:t>I think this would be better drawn in zones and highlighting just the major ones that change (as noted in the text) and then have all the raw reads at the end as a supplementary table</a:t>
            </a:r>
          </a:p>
        </p:txBody>
      </p:sp>
      <p:sp>
        <p:nvSpPr>
          <p:cNvPr id="4" name="Slide Number Placeholder 3"/>
          <p:cNvSpPr>
            <a:spLocks noGrp="1"/>
          </p:cNvSpPr>
          <p:nvPr>
            <p:ph type="sldNum" sz="quarter" idx="5"/>
          </p:nvPr>
        </p:nvSpPr>
        <p:spPr/>
        <p:txBody>
          <a:bodyPr/>
          <a:lstStyle/>
          <a:p>
            <a:fld id="{C28E0052-E825-48D2-993D-F2A9D5C4B081}" type="slidenum">
              <a:rPr lang="en-GB" smtClean="0"/>
              <a:t>5</a:t>
            </a:fld>
            <a:endParaRPr lang="en-GB"/>
          </a:p>
        </p:txBody>
      </p:sp>
    </p:spTree>
    <p:extLst>
      <p:ext uri="{BB962C8B-B14F-4D97-AF65-F5344CB8AC3E}">
        <p14:creationId xmlns:p14="http://schemas.microsoft.com/office/powerpoint/2010/main" val="5994210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C7CDCCEA-9A8D-4B0F-B86D-925C7972A319}" type="datetimeFigureOut">
              <a:rPr lang="en-GB" smtClean="0"/>
              <a:t>16/12/2019</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082F9236-A8FB-402C-BB8B-5A08FFC81867}" type="slidenum">
              <a:rPr lang="en-GB" smtClean="0"/>
              <a:t>‹#›</a:t>
            </a:fld>
            <a:endParaRPr lang="en-GB" dirty="0"/>
          </a:p>
        </p:txBody>
      </p:sp>
    </p:spTree>
    <p:extLst>
      <p:ext uri="{BB962C8B-B14F-4D97-AF65-F5344CB8AC3E}">
        <p14:creationId xmlns:p14="http://schemas.microsoft.com/office/powerpoint/2010/main" val="42771651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C7CDCCEA-9A8D-4B0F-B86D-925C7972A319}" type="datetimeFigureOut">
              <a:rPr lang="en-GB" smtClean="0"/>
              <a:t>16/12/2019</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082F9236-A8FB-402C-BB8B-5A08FFC81867}" type="slidenum">
              <a:rPr lang="en-GB" smtClean="0"/>
              <a:t>‹#›</a:t>
            </a:fld>
            <a:endParaRPr lang="en-GB" dirty="0"/>
          </a:p>
        </p:txBody>
      </p:sp>
    </p:spTree>
    <p:extLst>
      <p:ext uri="{BB962C8B-B14F-4D97-AF65-F5344CB8AC3E}">
        <p14:creationId xmlns:p14="http://schemas.microsoft.com/office/powerpoint/2010/main" val="8803312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C7CDCCEA-9A8D-4B0F-B86D-925C7972A319}" type="datetimeFigureOut">
              <a:rPr lang="en-GB" smtClean="0"/>
              <a:t>16/12/2019</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082F9236-A8FB-402C-BB8B-5A08FFC81867}" type="slidenum">
              <a:rPr lang="en-GB" smtClean="0"/>
              <a:t>‹#›</a:t>
            </a:fld>
            <a:endParaRPr lang="en-GB" dirty="0"/>
          </a:p>
        </p:txBody>
      </p:sp>
    </p:spTree>
    <p:extLst>
      <p:ext uri="{BB962C8B-B14F-4D97-AF65-F5344CB8AC3E}">
        <p14:creationId xmlns:p14="http://schemas.microsoft.com/office/powerpoint/2010/main" val="29704263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C7CDCCEA-9A8D-4B0F-B86D-925C7972A319}" type="datetimeFigureOut">
              <a:rPr lang="en-GB" smtClean="0"/>
              <a:t>16/12/2019</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082F9236-A8FB-402C-BB8B-5A08FFC81867}" type="slidenum">
              <a:rPr lang="en-GB" smtClean="0"/>
              <a:t>‹#›</a:t>
            </a:fld>
            <a:endParaRPr lang="en-GB" dirty="0"/>
          </a:p>
        </p:txBody>
      </p:sp>
    </p:spTree>
    <p:extLst>
      <p:ext uri="{BB962C8B-B14F-4D97-AF65-F5344CB8AC3E}">
        <p14:creationId xmlns:p14="http://schemas.microsoft.com/office/powerpoint/2010/main" val="12786062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7CDCCEA-9A8D-4B0F-B86D-925C7972A319}" type="datetimeFigureOut">
              <a:rPr lang="en-GB" smtClean="0"/>
              <a:t>16/12/2019</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082F9236-A8FB-402C-BB8B-5A08FFC81867}" type="slidenum">
              <a:rPr lang="en-GB" smtClean="0"/>
              <a:t>‹#›</a:t>
            </a:fld>
            <a:endParaRPr lang="en-GB" dirty="0"/>
          </a:p>
        </p:txBody>
      </p:sp>
    </p:spTree>
    <p:extLst>
      <p:ext uri="{BB962C8B-B14F-4D97-AF65-F5344CB8AC3E}">
        <p14:creationId xmlns:p14="http://schemas.microsoft.com/office/powerpoint/2010/main" val="28748116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C7CDCCEA-9A8D-4B0F-B86D-925C7972A319}" type="datetimeFigureOut">
              <a:rPr lang="en-GB" smtClean="0"/>
              <a:t>16/12/2019</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082F9236-A8FB-402C-BB8B-5A08FFC81867}" type="slidenum">
              <a:rPr lang="en-GB" smtClean="0"/>
              <a:t>‹#›</a:t>
            </a:fld>
            <a:endParaRPr lang="en-GB" dirty="0"/>
          </a:p>
        </p:txBody>
      </p:sp>
    </p:spTree>
    <p:extLst>
      <p:ext uri="{BB962C8B-B14F-4D97-AF65-F5344CB8AC3E}">
        <p14:creationId xmlns:p14="http://schemas.microsoft.com/office/powerpoint/2010/main" val="32975448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C7CDCCEA-9A8D-4B0F-B86D-925C7972A319}" type="datetimeFigureOut">
              <a:rPr lang="en-GB" smtClean="0"/>
              <a:t>16/12/2019</a:t>
            </a:fld>
            <a:endParaRPr lang="en-GB" dirty="0"/>
          </a:p>
        </p:txBody>
      </p:sp>
      <p:sp>
        <p:nvSpPr>
          <p:cNvPr id="8" name="Footer Placeholder 7"/>
          <p:cNvSpPr>
            <a:spLocks noGrp="1"/>
          </p:cNvSpPr>
          <p:nvPr>
            <p:ph type="ftr" sz="quarter" idx="11"/>
          </p:nvPr>
        </p:nvSpPr>
        <p:spPr/>
        <p:txBody>
          <a:bodyPr/>
          <a:lstStyle/>
          <a:p>
            <a:endParaRPr lang="en-GB" dirty="0"/>
          </a:p>
        </p:txBody>
      </p:sp>
      <p:sp>
        <p:nvSpPr>
          <p:cNvPr id="9" name="Slide Number Placeholder 8"/>
          <p:cNvSpPr>
            <a:spLocks noGrp="1"/>
          </p:cNvSpPr>
          <p:nvPr>
            <p:ph type="sldNum" sz="quarter" idx="12"/>
          </p:nvPr>
        </p:nvSpPr>
        <p:spPr/>
        <p:txBody>
          <a:bodyPr/>
          <a:lstStyle/>
          <a:p>
            <a:fld id="{082F9236-A8FB-402C-BB8B-5A08FFC81867}" type="slidenum">
              <a:rPr lang="en-GB" smtClean="0"/>
              <a:t>‹#›</a:t>
            </a:fld>
            <a:endParaRPr lang="en-GB" dirty="0"/>
          </a:p>
        </p:txBody>
      </p:sp>
    </p:spTree>
    <p:extLst>
      <p:ext uri="{BB962C8B-B14F-4D97-AF65-F5344CB8AC3E}">
        <p14:creationId xmlns:p14="http://schemas.microsoft.com/office/powerpoint/2010/main" val="30996506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C7CDCCEA-9A8D-4B0F-B86D-925C7972A319}" type="datetimeFigureOut">
              <a:rPr lang="en-GB" smtClean="0"/>
              <a:t>16/12/2019</a:t>
            </a:fld>
            <a:endParaRPr lang="en-GB" dirty="0"/>
          </a:p>
        </p:txBody>
      </p:sp>
      <p:sp>
        <p:nvSpPr>
          <p:cNvPr id="4" name="Footer Placeholder 3"/>
          <p:cNvSpPr>
            <a:spLocks noGrp="1"/>
          </p:cNvSpPr>
          <p:nvPr>
            <p:ph type="ftr" sz="quarter" idx="11"/>
          </p:nvPr>
        </p:nvSpPr>
        <p:spPr/>
        <p:txBody>
          <a:bodyPr/>
          <a:lstStyle/>
          <a:p>
            <a:endParaRPr lang="en-GB" dirty="0"/>
          </a:p>
        </p:txBody>
      </p:sp>
      <p:sp>
        <p:nvSpPr>
          <p:cNvPr id="5" name="Slide Number Placeholder 4"/>
          <p:cNvSpPr>
            <a:spLocks noGrp="1"/>
          </p:cNvSpPr>
          <p:nvPr>
            <p:ph type="sldNum" sz="quarter" idx="12"/>
          </p:nvPr>
        </p:nvSpPr>
        <p:spPr/>
        <p:txBody>
          <a:bodyPr/>
          <a:lstStyle/>
          <a:p>
            <a:fld id="{082F9236-A8FB-402C-BB8B-5A08FFC81867}" type="slidenum">
              <a:rPr lang="en-GB" smtClean="0"/>
              <a:t>‹#›</a:t>
            </a:fld>
            <a:endParaRPr lang="en-GB" dirty="0"/>
          </a:p>
        </p:txBody>
      </p:sp>
    </p:spTree>
    <p:extLst>
      <p:ext uri="{BB962C8B-B14F-4D97-AF65-F5344CB8AC3E}">
        <p14:creationId xmlns:p14="http://schemas.microsoft.com/office/powerpoint/2010/main" val="9386233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CDCCEA-9A8D-4B0F-B86D-925C7972A319}" type="datetimeFigureOut">
              <a:rPr lang="en-GB" smtClean="0"/>
              <a:t>16/12/2019</a:t>
            </a:fld>
            <a:endParaRPr lang="en-GB" dirty="0"/>
          </a:p>
        </p:txBody>
      </p:sp>
      <p:sp>
        <p:nvSpPr>
          <p:cNvPr id="3" name="Footer Placeholder 2"/>
          <p:cNvSpPr>
            <a:spLocks noGrp="1"/>
          </p:cNvSpPr>
          <p:nvPr>
            <p:ph type="ftr" sz="quarter" idx="11"/>
          </p:nvPr>
        </p:nvSpPr>
        <p:spPr/>
        <p:txBody>
          <a:bodyPr/>
          <a:lstStyle/>
          <a:p>
            <a:endParaRPr lang="en-GB" dirty="0"/>
          </a:p>
        </p:txBody>
      </p:sp>
      <p:sp>
        <p:nvSpPr>
          <p:cNvPr id="4" name="Slide Number Placeholder 3"/>
          <p:cNvSpPr>
            <a:spLocks noGrp="1"/>
          </p:cNvSpPr>
          <p:nvPr>
            <p:ph type="sldNum" sz="quarter" idx="12"/>
          </p:nvPr>
        </p:nvSpPr>
        <p:spPr/>
        <p:txBody>
          <a:bodyPr/>
          <a:lstStyle/>
          <a:p>
            <a:fld id="{082F9236-A8FB-402C-BB8B-5A08FFC81867}" type="slidenum">
              <a:rPr lang="en-GB" smtClean="0"/>
              <a:t>‹#›</a:t>
            </a:fld>
            <a:endParaRPr lang="en-GB" dirty="0"/>
          </a:p>
        </p:txBody>
      </p:sp>
    </p:spTree>
    <p:extLst>
      <p:ext uri="{BB962C8B-B14F-4D97-AF65-F5344CB8AC3E}">
        <p14:creationId xmlns:p14="http://schemas.microsoft.com/office/powerpoint/2010/main" val="15459928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7CDCCEA-9A8D-4B0F-B86D-925C7972A319}" type="datetimeFigureOut">
              <a:rPr lang="en-GB" smtClean="0"/>
              <a:t>16/12/2019</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082F9236-A8FB-402C-BB8B-5A08FFC81867}" type="slidenum">
              <a:rPr lang="en-GB" smtClean="0"/>
              <a:t>‹#›</a:t>
            </a:fld>
            <a:endParaRPr lang="en-GB" dirty="0"/>
          </a:p>
        </p:txBody>
      </p:sp>
    </p:spTree>
    <p:extLst>
      <p:ext uri="{BB962C8B-B14F-4D97-AF65-F5344CB8AC3E}">
        <p14:creationId xmlns:p14="http://schemas.microsoft.com/office/powerpoint/2010/main" val="39882156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7CDCCEA-9A8D-4B0F-B86D-925C7972A319}" type="datetimeFigureOut">
              <a:rPr lang="en-GB" smtClean="0"/>
              <a:t>16/12/2019</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082F9236-A8FB-402C-BB8B-5A08FFC81867}" type="slidenum">
              <a:rPr lang="en-GB" smtClean="0"/>
              <a:t>‹#›</a:t>
            </a:fld>
            <a:endParaRPr lang="en-GB" dirty="0"/>
          </a:p>
        </p:txBody>
      </p:sp>
    </p:spTree>
    <p:extLst>
      <p:ext uri="{BB962C8B-B14F-4D97-AF65-F5344CB8AC3E}">
        <p14:creationId xmlns:p14="http://schemas.microsoft.com/office/powerpoint/2010/main" val="4886424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7CDCCEA-9A8D-4B0F-B86D-925C7972A319}" type="datetimeFigureOut">
              <a:rPr lang="en-GB" smtClean="0"/>
              <a:t>16/12/2019</a:t>
            </a:fld>
            <a:endParaRPr lang="en-GB"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82F9236-A8FB-402C-BB8B-5A08FFC81867}" type="slidenum">
              <a:rPr lang="en-GB" smtClean="0"/>
              <a:t>‹#›</a:t>
            </a:fld>
            <a:endParaRPr lang="en-GB" dirty="0"/>
          </a:p>
        </p:txBody>
      </p:sp>
    </p:spTree>
    <p:extLst>
      <p:ext uri="{BB962C8B-B14F-4D97-AF65-F5344CB8AC3E}">
        <p14:creationId xmlns:p14="http://schemas.microsoft.com/office/powerpoint/2010/main" val="351504637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slideLayout" Target="../slideLayouts/slideLayout1.xml"/><Relationship Id="rId1" Type="http://schemas.openxmlformats.org/officeDocument/2006/relationships/vmlDrawing" Target="../drawings/vmlDrawing1.vml"/><Relationship Id="rId5" Type="http://schemas.openxmlformats.org/officeDocument/2006/relationships/image" Target="../media/image1.emf"/><Relationship Id="rId4" Type="http://schemas.openxmlformats.org/officeDocument/2006/relationships/oleObject" Target="../embeddings/oleObject1.bin"/></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7.xml"/><Relationship Id="rId4" Type="http://schemas.openxmlformats.org/officeDocument/2006/relationships/image" Target="../media/image5.emf"/></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8" Type="http://schemas.openxmlformats.org/officeDocument/2006/relationships/image" Target="../media/image15.png"/><Relationship Id="rId3" Type="http://schemas.openxmlformats.org/officeDocument/2006/relationships/image" Target="../media/image10.png"/><Relationship Id="rId7" Type="http://schemas.openxmlformats.org/officeDocument/2006/relationships/image" Target="../media/image14.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s>
</file>

<file path=ppt/slides/_rels/slide6.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7.xml"/><Relationship Id="rId4" Type="http://schemas.openxmlformats.org/officeDocument/2006/relationships/image" Target="../media/image19.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D851C1E-C9EE-E845-8392-2EDBFF68C259}"/>
              </a:ext>
            </a:extLst>
          </p:cNvPr>
          <p:cNvPicPr/>
          <p:nvPr/>
        </p:nvPicPr>
        <p:blipFill>
          <a:blip r:embed="rId3"/>
          <a:stretch>
            <a:fillRect/>
          </a:stretch>
        </p:blipFill>
        <p:spPr>
          <a:xfrm>
            <a:off x="128444" y="446935"/>
            <a:ext cx="4837814" cy="3842005"/>
          </a:xfrm>
          <a:prstGeom prst="rect">
            <a:avLst/>
          </a:prstGeom>
        </p:spPr>
      </p:pic>
      <p:sp>
        <p:nvSpPr>
          <p:cNvPr id="5" name="TextBox 4"/>
          <p:cNvSpPr txBox="1"/>
          <p:nvPr/>
        </p:nvSpPr>
        <p:spPr>
          <a:xfrm>
            <a:off x="205562" y="262269"/>
            <a:ext cx="412292" cy="369332"/>
          </a:xfrm>
          <a:prstGeom prst="rect">
            <a:avLst/>
          </a:prstGeom>
          <a:noFill/>
        </p:spPr>
        <p:txBody>
          <a:bodyPr wrap="none" rtlCol="0">
            <a:spAutoFit/>
          </a:bodyPr>
          <a:lstStyle/>
          <a:p>
            <a:r>
              <a:rPr lang="en-GB" b="1" dirty="0"/>
              <a:t>a. </a:t>
            </a:r>
          </a:p>
        </p:txBody>
      </p:sp>
      <p:sp>
        <p:nvSpPr>
          <p:cNvPr id="7" name="TextBox 6"/>
          <p:cNvSpPr txBox="1"/>
          <p:nvPr/>
        </p:nvSpPr>
        <p:spPr>
          <a:xfrm>
            <a:off x="5043376" y="262269"/>
            <a:ext cx="421910" cy="369332"/>
          </a:xfrm>
          <a:prstGeom prst="rect">
            <a:avLst/>
          </a:prstGeom>
          <a:noFill/>
        </p:spPr>
        <p:txBody>
          <a:bodyPr wrap="none" rtlCol="0">
            <a:spAutoFit/>
          </a:bodyPr>
          <a:lstStyle/>
          <a:p>
            <a:r>
              <a:rPr lang="en-GB" b="1" dirty="0"/>
              <a:t>b. </a:t>
            </a:r>
          </a:p>
        </p:txBody>
      </p:sp>
      <p:sp>
        <p:nvSpPr>
          <p:cNvPr id="8" name="TextBox 7"/>
          <p:cNvSpPr txBox="1"/>
          <p:nvPr/>
        </p:nvSpPr>
        <p:spPr>
          <a:xfrm>
            <a:off x="617854" y="4861311"/>
            <a:ext cx="11154663" cy="861774"/>
          </a:xfrm>
          <a:prstGeom prst="rect">
            <a:avLst/>
          </a:prstGeom>
          <a:noFill/>
        </p:spPr>
        <p:txBody>
          <a:bodyPr wrap="square" rtlCol="0">
            <a:spAutoFit/>
          </a:bodyPr>
          <a:lstStyle/>
          <a:p>
            <a:pPr algn="just"/>
            <a:r>
              <a:rPr lang="en-GB" b="1" dirty="0"/>
              <a:t>Supplementary Figure 1: EPS-associated gene expression. </a:t>
            </a:r>
            <a:r>
              <a:rPr lang="en-GB" sz="1600" b="1" dirty="0"/>
              <a:t>(a) </a:t>
            </a:r>
            <a:r>
              <a:rPr lang="en-GB" sz="1600" dirty="0"/>
              <a:t>Principle component analysis plot of </a:t>
            </a:r>
            <a:r>
              <a:rPr lang="en-GB" sz="1600" dirty="0" err="1"/>
              <a:t>RNASeq</a:t>
            </a:r>
            <a:r>
              <a:rPr lang="en-GB" sz="1600" dirty="0"/>
              <a:t> data from EPS+ and EPS- grown in rich media. Plots generated using normalised and regularised log transformed gene counts. </a:t>
            </a:r>
            <a:r>
              <a:rPr lang="en-GB" sz="1600" b="1" dirty="0"/>
              <a:t>(b) </a:t>
            </a:r>
            <a:r>
              <a:rPr lang="en-GB" sz="1600" dirty="0"/>
              <a:t>Growth kinetics of EPS+ and EPS- in MRS media plated in duplicate, error bars are</a:t>
            </a:r>
            <a:r>
              <a:rPr lang="en-GB" sz="1600" dirty="0">
                <a:solidFill>
                  <a:srgbClr val="FF0000"/>
                </a:solidFill>
              </a:rPr>
              <a:t> </a:t>
            </a:r>
            <a:r>
              <a:rPr lang="en-GB" sz="1600" dirty="0"/>
              <a:t>± standard deviation from three independent experiments.</a:t>
            </a:r>
            <a:endParaRPr lang="en-GB" dirty="0"/>
          </a:p>
        </p:txBody>
      </p:sp>
      <p:graphicFrame>
        <p:nvGraphicFramePr>
          <p:cNvPr id="10" name="Object 9">
            <a:extLst>
              <a:ext uri="{FF2B5EF4-FFF2-40B4-BE49-F238E27FC236}">
                <a16:creationId xmlns:a16="http://schemas.microsoft.com/office/drawing/2014/main" id="{3448E3E9-416F-6046-884C-73D640ADD008}"/>
              </a:ext>
            </a:extLst>
          </p:cNvPr>
          <p:cNvGraphicFramePr>
            <a:graphicFrameLocks noChangeAspect="1"/>
          </p:cNvGraphicFramePr>
          <p:nvPr>
            <p:extLst>
              <p:ext uri="{D42A27DB-BD31-4B8C-83A1-F6EECF244321}">
                <p14:modId xmlns:p14="http://schemas.microsoft.com/office/powerpoint/2010/main" val="2036967561"/>
              </p:ext>
            </p:extLst>
          </p:nvPr>
        </p:nvGraphicFramePr>
        <p:xfrm>
          <a:off x="5542404" y="446935"/>
          <a:ext cx="4973196" cy="4175816"/>
        </p:xfrm>
        <a:graphic>
          <a:graphicData uri="http://schemas.openxmlformats.org/presentationml/2006/ole">
            <mc:AlternateContent xmlns:mc="http://schemas.openxmlformats.org/markup-compatibility/2006">
              <mc:Choice xmlns:v="urn:schemas-microsoft-com:vml" Requires="v">
                <p:oleObj spid="_x0000_s1051" name="Prism 5" r:id="rId4" imgW="3593880" imgH="3017520" progId="Prism5.Document">
                  <p:embed/>
                </p:oleObj>
              </mc:Choice>
              <mc:Fallback>
                <p:oleObj name="Prism 5" r:id="rId4" imgW="3593880" imgH="3017520" progId="Prism5.Document">
                  <p:embed/>
                  <p:pic>
                    <p:nvPicPr>
                      <p:cNvPr id="2" name="Object 1">
                        <a:extLst>
                          <a:ext uri="{FF2B5EF4-FFF2-40B4-BE49-F238E27FC236}">
                            <a16:creationId xmlns:a16="http://schemas.microsoft.com/office/drawing/2014/main" id="{33669952-E02A-4AB7-A46D-EFF4DA2D6A88}"/>
                          </a:ext>
                        </a:extLst>
                      </p:cNvPr>
                      <p:cNvPicPr/>
                      <p:nvPr/>
                    </p:nvPicPr>
                    <p:blipFill>
                      <a:blip r:embed="rId5"/>
                      <a:stretch>
                        <a:fillRect/>
                      </a:stretch>
                    </p:blipFill>
                    <p:spPr>
                      <a:xfrm>
                        <a:off x="5542404" y="446935"/>
                        <a:ext cx="4973196" cy="4175816"/>
                      </a:xfrm>
                      <a:prstGeom prst="rect">
                        <a:avLst/>
                      </a:prstGeom>
                    </p:spPr>
                  </p:pic>
                </p:oleObj>
              </mc:Fallback>
            </mc:AlternateContent>
          </a:graphicData>
        </a:graphic>
      </p:graphicFrame>
    </p:spTree>
    <p:extLst>
      <p:ext uri="{BB962C8B-B14F-4D97-AF65-F5344CB8AC3E}">
        <p14:creationId xmlns:p14="http://schemas.microsoft.com/office/powerpoint/2010/main" val="10679712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87935" y="4620173"/>
            <a:ext cx="10298426" cy="338554"/>
          </a:xfrm>
          <a:prstGeom prst="rect">
            <a:avLst/>
          </a:prstGeom>
          <a:noFill/>
        </p:spPr>
        <p:txBody>
          <a:bodyPr wrap="square" rtlCol="0">
            <a:spAutoFit/>
          </a:bodyPr>
          <a:lstStyle/>
          <a:p>
            <a:r>
              <a:rPr lang="en-GB" sz="1600" b="1" dirty="0"/>
              <a:t>Supplementary Figure 2: </a:t>
            </a:r>
            <a:r>
              <a:rPr lang="en-GB" sz="1400" dirty="0"/>
              <a:t>Microbiota profiles for starting material used to inoculate </a:t>
            </a:r>
            <a:r>
              <a:rPr lang="en-GB" sz="1400" b="1" dirty="0"/>
              <a:t>(a) </a:t>
            </a:r>
            <a:r>
              <a:rPr lang="en-GB" sz="1400" dirty="0"/>
              <a:t>EPS+ and </a:t>
            </a:r>
            <a:r>
              <a:rPr lang="en-GB" sz="1400" b="1" dirty="0"/>
              <a:t>(b) </a:t>
            </a:r>
            <a:r>
              <a:rPr lang="en-GB" sz="1400" dirty="0"/>
              <a:t>EPS- vessels. </a:t>
            </a:r>
            <a:endParaRPr lang="en-GB" sz="1600" dirty="0"/>
          </a:p>
        </p:txBody>
      </p:sp>
      <p:pic>
        <p:nvPicPr>
          <p:cNvPr id="5" name="Picture 4">
            <a:extLst>
              <a:ext uri="{FF2B5EF4-FFF2-40B4-BE49-F238E27FC236}">
                <a16:creationId xmlns:a16="http://schemas.microsoft.com/office/drawing/2014/main" id="{5B735B70-703C-43D6-96BD-A60A1BED45A8}"/>
              </a:ext>
            </a:extLst>
          </p:cNvPr>
          <p:cNvPicPr>
            <a:picLocks noChangeAspect="1"/>
          </p:cNvPicPr>
          <p:nvPr/>
        </p:nvPicPr>
        <p:blipFill>
          <a:blip r:embed="rId2"/>
          <a:stretch>
            <a:fillRect/>
          </a:stretch>
        </p:blipFill>
        <p:spPr>
          <a:xfrm>
            <a:off x="5001423" y="329128"/>
            <a:ext cx="3168941" cy="3202151"/>
          </a:xfrm>
          <a:prstGeom prst="rect">
            <a:avLst/>
          </a:prstGeom>
        </p:spPr>
      </p:pic>
      <p:pic>
        <p:nvPicPr>
          <p:cNvPr id="7" name="Picture 6">
            <a:extLst>
              <a:ext uri="{FF2B5EF4-FFF2-40B4-BE49-F238E27FC236}">
                <a16:creationId xmlns:a16="http://schemas.microsoft.com/office/drawing/2014/main" id="{1EE8F45F-9D1D-42C4-BFB3-3BF6AFADFD66}"/>
              </a:ext>
            </a:extLst>
          </p:cNvPr>
          <p:cNvPicPr>
            <a:picLocks noChangeAspect="1"/>
          </p:cNvPicPr>
          <p:nvPr/>
        </p:nvPicPr>
        <p:blipFill>
          <a:blip r:embed="rId3"/>
          <a:stretch>
            <a:fillRect/>
          </a:stretch>
        </p:blipFill>
        <p:spPr>
          <a:xfrm>
            <a:off x="8587923" y="144462"/>
            <a:ext cx="1685395" cy="4409956"/>
          </a:xfrm>
          <a:prstGeom prst="rect">
            <a:avLst/>
          </a:prstGeom>
        </p:spPr>
      </p:pic>
      <p:pic>
        <p:nvPicPr>
          <p:cNvPr id="8" name="Picture 7">
            <a:extLst>
              <a:ext uri="{FF2B5EF4-FFF2-40B4-BE49-F238E27FC236}">
                <a16:creationId xmlns:a16="http://schemas.microsoft.com/office/drawing/2014/main" id="{BAF943DF-6873-4170-88B5-8EE9B7FDF92F}"/>
              </a:ext>
            </a:extLst>
          </p:cNvPr>
          <p:cNvPicPr>
            <a:picLocks noChangeAspect="1"/>
          </p:cNvPicPr>
          <p:nvPr/>
        </p:nvPicPr>
        <p:blipFill>
          <a:blip r:embed="rId4"/>
          <a:stretch>
            <a:fillRect/>
          </a:stretch>
        </p:blipFill>
        <p:spPr>
          <a:xfrm>
            <a:off x="673992" y="428830"/>
            <a:ext cx="3168941" cy="3181950"/>
          </a:xfrm>
          <a:prstGeom prst="rect">
            <a:avLst/>
          </a:prstGeom>
        </p:spPr>
      </p:pic>
      <p:sp>
        <p:nvSpPr>
          <p:cNvPr id="10" name="TextBox 9">
            <a:extLst>
              <a:ext uri="{FF2B5EF4-FFF2-40B4-BE49-F238E27FC236}">
                <a16:creationId xmlns:a16="http://schemas.microsoft.com/office/drawing/2014/main" id="{4C34E8DE-76B2-4FB5-9551-E280CD25AB7C}"/>
              </a:ext>
            </a:extLst>
          </p:cNvPr>
          <p:cNvSpPr txBox="1"/>
          <p:nvPr/>
        </p:nvSpPr>
        <p:spPr>
          <a:xfrm>
            <a:off x="448523" y="144462"/>
            <a:ext cx="359394" cy="369332"/>
          </a:xfrm>
          <a:prstGeom prst="rect">
            <a:avLst/>
          </a:prstGeom>
          <a:noFill/>
        </p:spPr>
        <p:txBody>
          <a:bodyPr wrap="none" rtlCol="0">
            <a:spAutoFit/>
          </a:bodyPr>
          <a:lstStyle/>
          <a:p>
            <a:r>
              <a:rPr lang="en-GB" b="1" dirty="0"/>
              <a:t>a.</a:t>
            </a:r>
          </a:p>
        </p:txBody>
      </p:sp>
      <p:sp>
        <p:nvSpPr>
          <p:cNvPr id="11" name="TextBox 10">
            <a:extLst>
              <a:ext uri="{FF2B5EF4-FFF2-40B4-BE49-F238E27FC236}">
                <a16:creationId xmlns:a16="http://schemas.microsoft.com/office/drawing/2014/main" id="{932FBCEE-F561-40EF-97E8-3FF867CAC454}"/>
              </a:ext>
            </a:extLst>
          </p:cNvPr>
          <p:cNvSpPr txBox="1"/>
          <p:nvPr/>
        </p:nvSpPr>
        <p:spPr>
          <a:xfrm>
            <a:off x="4813313" y="144462"/>
            <a:ext cx="369012" cy="369332"/>
          </a:xfrm>
          <a:prstGeom prst="rect">
            <a:avLst/>
          </a:prstGeom>
          <a:noFill/>
        </p:spPr>
        <p:txBody>
          <a:bodyPr wrap="none" rtlCol="0">
            <a:spAutoFit/>
          </a:bodyPr>
          <a:lstStyle/>
          <a:p>
            <a:r>
              <a:rPr lang="en-GB" b="1" dirty="0"/>
              <a:t>b.</a:t>
            </a:r>
          </a:p>
        </p:txBody>
      </p:sp>
      <p:sp>
        <p:nvSpPr>
          <p:cNvPr id="9" name="TextBox 8">
            <a:extLst>
              <a:ext uri="{FF2B5EF4-FFF2-40B4-BE49-F238E27FC236}">
                <a16:creationId xmlns:a16="http://schemas.microsoft.com/office/drawing/2014/main" id="{C7125B20-19A0-854A-883C-144B33775E2B}"/>
              </a:ext>
            </a:extLst>
          </p:cNvPr>
          <p:cNvSpPr txBox="1"/>
          <p:nvPr/>
        </p:nvSpPr>
        <p:spPr>
          <a:xfrm>
            <a:off x="1272453" y="144462"/>
            <a:ext cx="1972019" cy="369332"/>
          </a:xfrm>
          <a:prstGeom prst="rect">
            <a:avLst/>
          </a:prstGeom>
          <a:noFill/>
        </p:spPr>
        <p:txBody>
          <a:bodyPr wrap="square" rtlCol="0">
            <a:spAutoFit/>
          </a:bodyPr>
          <a:lstStyle/>
          <a:p>
            <a:pPr algn="ctr"/>
            <a:r>
              <a:rPr lang="en-US" u="sng" dirty="0"/>
              <a:t>EPS + vessel</a:t>
            </a:r>
          </a:p>
        </p:txBody>
      </p:sp>
      <p:sp>
        <p:nvSpPr>
          <p:cNvPr id="12" name="TextBox 11">
            <a:extLst>
              <a:ext uri="{FF2B5EF4-FFF2-40B4-BE49-F238E27FC236}">
                <a16:creationId xmlns:a16="http://schemas.microsoft.com/office/drawing/2014/main" id="{9C957F03-9B8C-4147-BE78-531481BBB952}"/>
              </a:ext>
            </a:extLst>
          </p:cNvPr>
          <p:cNvSpPr txBox="1"/>
          <p:nvPr/>
        </p:nvSpPr>
        <p:spPr>
          <a:xfrm>
            <a:off x="5599884" y="144462"/>
            <a:ext cx="1972019" cy="369332"/>
          </a:xfrm>
          <a:prstGeom prst="rect">
            <a:avLst/>
          </a:prstGeom>
          <a:noFill/>
        </p:spPr>
        <p:txBody>
          <a:bodyPr wrap="square" rtlCol="0">
            <a:spAutoFit/>
          </a:bodyPr>
          <a:lstStyle/>
          <a:p>
            <a:pPr algn="ctr"/>
            <a:r>
              <a:rPr lang="en-US" u="sng" dirty="0"/>
              <a:t>EPS - vessel</a:t>
            </a:r>
          </a:p>
        </p:txBody>
      </p:sp>
    </p:spTree>
    <p:extLst>
      <p:ext uri="{BB962C8B-B14F-4D97-AF65-F5344CB8AC3E}">
        <p14:creationId xmlns:p14="http://schemas.microsoft.com/office/powerpoint/2010/main" val="31680450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descr="A close up of a map&#10;&#10;Description automatically generated">
            <a:extLst>
              <a:ext uri="{FF2B5EF4-FFF2-40B4-BE49-F238E27FC236}">
                <a16:creationId xmlns:a16="http://schemas.microsoft.com/office/drawing/2014/main" id="{471D143F-F51F-465C-8955-3B088B361A95}"/>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3427" r="14262"/>
          <a:stretch/>
        </p:blipFill>
        <p:spPr>
          <a:xfrm>
            <a:off x="4740900" y="381425"/>
            <a:ext cx="4452122" cy="2978916"/>
          </a:xfrm>
          <a:prstGeom prst="rect">
            <a:avLst/>
          </a:prstGeom>
        </p:spPr>
      </p:pic>
      <p:pic>
        <p:nvPicPr>
          <p:cNvPr id="16" name="Picture 15" descr="A picture containing screenshot&#10;&#10;Description automatically generated">
            <a:extLst>
              <a:ext uri="{FF2B5EF4-FFF2-40B4-BE49-F238E27FC236}">
                <a16:creationId xmlns:a16="http://schemas.microsoft.com/office/drawing/2014/main" id="{7CF4A947-8894-42D5-89FA-4ECC82F13E11}"/>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4221" r="16152"/>
          <a:stretch/>
        </p:blipFill>
        <p:spPr>
          <a:xfrm>
            <a:off x="349765" y="381425"/>
            <a:ext cx="4319081" cy="3001272"/>
          </a:xfrm>
          <a:prstGeom prst="rect">
            <a:avLst/>
          </a:prstGeom>
        </p:spPr>
      </p:pic>
      <p:sp>
        <p:nvSpPr>
          <p:cNvPr id="6" name="TextBox 5"/>
          <p:cNvSpPr txBox="1"/>
          <p:nvPr/>
        </p:nvSpPr>
        <p:spPr>
          <a:xfrm>
            <a:off x="349765" y="3487291"/>
            <a:ext cx="11292736" cy="615553"/>
          </a:xfrm>
          <a:prstGeom prst="rect">
            <a:avLst/>
          </a:prstGeom>
          <a:noFill/>
        </p:spPr>
        <p:txBody>
          <a:bodyPr wrap="square" rtlCol="0">
            <a:spAutoFit/>
          </a:bodyPr>
          <a:lstStyle/>
          <a:p>
            <a:r>
              <a:rPr lang="en-GB" b="1" dirty="0"/>
              <a:t>Supplementary Figure 3: </a:t>
            </a:r>
            <a:r>
              <a:rPr lang="en-GB" sz="1600" dirty="0"/>
              <a:t>Microbial changes over time as depicted using a NMDS plot using a Bray-Curtis dissimilarity calculation for </a:t>
            </a:r>
            <a:r>
              <a:rPr lang="en-GB" sz="1600" b="1" dirty="0"/>
              <a:t>(a) </a:t>
            </a:r>
            <a:r>
              <a:rPr lang="en-GB" sz="1600" dirty="0"/>
              <a:t>EPS+ ◻︎ and</a:t>
            </a:r>
            <a:r>
              <a:rPr lang="en-GB" sz="1600" b="1" dirty="0"/>
              <a:t> (b) </a:t>
            </a:r>
            <a:r>
              <a:rPr lang="en-GB" sz="1600" dirty="0"/>
              <a:t>EPS- △ vessels. Colour change denotes change in time from t=0 (yellow) to t=408h (red). </a:t>
            </a:r>
            <a:endParaRPr lang="en-GB" dirty="0"/>
          </a:p>
        </p:txBody>
      </p:sp>
      <p:sp>
        <p:nvSpPr>
          <p:cNvPr id="5" name="TextBox 4"/>
          <p:cNvSpPr txBox="1"/>
          <p:nvPr/>
        </p:nvSpPr>
        <p:spPr>
          <a:xfrm>
            <a:off x="4740900" y="196759"/>
            <a:ext cx="421910" cy="369332"/>
          </a:xfrm>
          <a:prstGeom prst="rect">
            <a:avLst/>
          </a:prstGeom>
          <a:noFill/>
        </p:spPr>
        <p:txBody>
          <a:bodyPr wrap="none" rtlCol="0">
            <a:spAutoFit/>
          </a:bodyPr>
          <a:lstStyle/>
          <a:p>
            <a:r>
              <a:rPr lang="en-GB" b="1" dirty="0"/>
              <a:t>b.</a:t>
            </a:r>
            <a:r>
              <a:rPr lang="en-GB" dirty="0"/>
              <a:t> </a:t>
            </a:r>
          </a:p>
        </p:txBody>
      </p:sp>
      <p:sp>
        <p:nvSpPr>
          <p:cNvPr id="4" name="TextBox 3"/>
          <p:cNvSpPr txBox="1"/>
          <p:nvPr/>
        </p:nvSpPr>
        <p:spPr>
          <a:xfrm>
            <a:off x="332020" y="196759"/>
            <a:ext cx="412292" cy="369332"/>
          </a:xfrm>
          <a:prstGeom prst="rect">
            <a:avLst/>
          </a:prstGeom>
          <a:noFill/>
        </p:spPr>
        <p:txBody>
          <a:bodyPr wrap="none" rtlCol="0">
            <a:spAutoFit/>
          </a:bodyPr>
          <a:lstStyle/>
          <a:p>
            <a:r>
              <a:rPr lang="en-GB" b="1" dirty="0"/>
              <a:t>a.</a:t>
            </a:r>
            <a:r>
              <a:rPr lang="en-GB" dirty="0"/>
              <a:t> </a:t>
            </a:r>
          </a:p>
        </p:txBody>
      </p:sp>
      <p:sp>
        <p:nvSpPr>
          <p:cNvPr id="2" name="TextBox 1">
            <a:extLst>
              <a:ext uri="{FF2B5EF4-FFF2-40B4-BE49-F238E27FC236}">
                <a16:creationId xmlns:a16="http://schemas.microsoft.com/office/drawing/2014/main" id="{AE27A2BF-F911-DA41-8A12-88498C592E4C}"/>
              </a:ext>
            </a:extLst>
          </p:cNvPr>
          <p:cNvSpPr txBox="1"/>
          <p:nvPr/>
        </p:nvSpPr>
        <p:spPr>
          <a:xfrm>
            <a:off x="1429199" y="144462"/>
            <a:ext cx="1972019" cy="369332"/>
          </a:xfrm>
          <a:prstGeom prst="rect">
            <a:avLst/>
          </a:prstGeom>
          <a:noFill/>
        </p:spPr>
        <p:txBody>
          <a:bodyPr wrap="square" rtlCol="0">
            <a:spAutoFit/>
          </a:bodyPr>
          <a:lstStyle/>
          <a:p>
            <a:pPr algn="ctr"/>
            <a:r>
              <a:rPr lang="en-US" u="sng" dirty="0"/>
              <a:t>EPS + vessel</a:t>
            </a:r>
          </a:p>
        </p:txBody>
      </p:sp>
      <p:sp>
        <p:nvSpPr>
          <p:cNvPr id="3" name="Rectangle 2">
            <a:extLst>
              <a:ext uri="{FF2B5EF4-FFF2-40B4-BE49-F238E27FC236}">
                <a16:creationId xmlns:a16="http://schemas.microsoft.com/office/drawing/2014/main" id="{E4EF7458-4586-3445-946D-BB5CEA611369}"/>
              </a:ext>
            </a:extLst>
          </p:cNvPr>
          <p:cNvSpPr/>
          <p:nvPr/>
        </p:nvSpPr>
        <p:spPr>
          <a:xfrm>
            <a:off x="3624549" y="286439"/>
            <a:ext cx="1044297" cy="69406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1265C7B7-A544-7A41-8A55-46F27E79CF74}"/>
              </a:ext>
            </a:extLst>
          </p:cNvPr>
          <p:cNvSpPr/>
          <p:nvPr/>
        </p:nvSpPr>
        <p:spPr>
          <a:xfrm>
            <a:off x="7974377" y="196759"/>
            <a:ext cx="1044297" cy="69406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B3404ABD-82B9-344C-A411-BA695D55262D}"/>
              </a:ext>
            </a:extLst>
          </p:cNvPr>
          <p:cNvSpPr txBox="1"/>
          <p:nvPr/>
        </p:nvSpPr>
        <p:spPr>
          <a:xfrm>
            <a:off x="5577064" y="144462"/>
            <a:ext cx="1972019" cy="369332"/>
          </a:xfrm>
          <a:prstGeom prst="rect">
            <a:avLst/>
          </a:prstGeom>
          <a:noFill/>
        </p:spPr>
        <p:txBody>
          <a:bodyPr wrap="square" rtlCol="0">
            <a:spAutoFit/>
          </a:bodyPr>
          <a:lstStyle/>
          <a:p>
            <a:pPr algn="ctr"/>
            <a:r>
              <a:rPr lang="en-US" u="sng" dirty="0"/>
              <a:t>EPS - vessel</a:t>
            </a:r>
          </a:p>
        </p:txBody>
      </p:sp>
    </p:spTree>
    <p:extLst>
      <p:ext uri="{BB962C8B-B14F-4D97-AF65-F5344CB8AC3E}">
        <p14:creationId xmlns:p14="http://schemas.microsoft.com/office/powerpoint/2010/main" val="23364866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500941" y="5236198"/>
            <a:ext cx="9136349" cy="1107996"/>
          </a:xfrm>
          <a:prstGeom prst="rect">
            <a:avLst/>
          </a:prstGeom>
          <a:noFill/>
        </p:spPr>
        <p:txBody>
          <a:bodyPr wrap="square" rtlCol="0">
            <a:spAutoFit/>
          </a:bodyPr>
          <a:lstStyle/>
          <a:p>
            <a:pPr algn="just"/>
            <a:r>
              <a:rPr lang="en-GB" b="1" dirty="0"/>
              <a:t>Supplementary Figure 4: </a:t>
            </a:r>
            <a:r>
              <a:rPr lang="en-GB" sz="1600" dirty="0"/>
              <a:t>16S rRNA reads from each vessel</a:t>
            </a:r>
            <a:r>
              <a:rPr lang="en-GB" sz="1600" b="1" dirty="0"/>
              <a:t> (a) </a:t>
            </a:r>
            <a:r>
              <a:rPr lang="en-GB" sz="1600" dirty="0"/>
              <a:t>EPS + and</a:t>
            </a:r>
            <a:r>
              <a:rPr lang="en-GB" sz="1600" b="1" dirty="0"/>
              <a:t> (b) </a:t>
            </a:r>
            <a:r>
              <a:rPr lang="en-GB" sz="1600" dirty="0"/>
              <a:t>EPS – that correspond to the total abundancy of </a:t>
            </a:r>
            <a:r>
              <a:rPr lang="en-GB" sz="1600" i="1" dirty="0"/>
              <a:t>Bifidobacterium</a:t>
            </a:r>
            <a:r>
              <a:rPr lang="en-GB" sz="1600" dirty="0"/>
              <a:t> reads in each vessels (white bars) and </a:t>
            </a:r>
            <a:r>
              <a:rPr lang="en-GB" sz="1600" i="1" dirty="0"/>
              <a:t>B. breve</a:t>
            </a:r>
            <a:r>
              <a:rPr lang="en-GB" sz="1600" dirty="0"/>
              <a:t> proportion (orange bars) over 72h. Note time point 0 correlates to the abundance of </a:t>
            </a:r>
            <a:r>
              <a:rPr lang="en-GB" sz="1600" i="1" dirty="0"/>
              <a:t>Bifidobacterium</a:t>
            </a:r>
            <a:r>
              <a:rPr lang="en-GB" sz="1600" dirty="0"/>
              <a:t> reads prior to inoculation with </a:t>
            </a:r>
            <a:r>
              <a:rPr lang="en-GB" sz="1600" i="1" dirty="0"/>
              <a:t>B. breve</a:t>
            </a:r>
            <a:r>
              <a:rPr lang="en-GB" sz="1600" dirty="0"/>
              <a:t> strains. </a:t>
            </a:r>
            <a:endParaRPr lang="en-GB" dirty="0"/>
          </a:p>
        </p:txBody>
      </p:sp>
      <p:pic>
        <p:nvPicPr>
          <p:cNvPr id="5" name="Picture 4" descr="A close up of a logo&#10;&#10;Description automatically generated">
            <a:extLst>
              <a:ext uri="{FF2B5EF4-FFF2-40B4-BE49-F238E27FC236}">
                <a16:creationId xmlns:a16="http://schemas.microsoft.com/office/drawing/2014/main" id="{25397948-17AD-864E-AE8F-0644E04597BE}"/>
              </a:ext>
            </a:extLst>
          </p:cNvPr>
          <p:cNvPicPr>
            <a:picLocks noChangeAspect="1"/>
          </p:cNvPicPr>
          <p:nvPr/>
        </p:nvPicPr>
        <p:blipFill rotWithShape="1">
          <a:blip r:embed="rId3">
            <a:extLst>
              <a:ext uri="{28A0092B-C50C-407E-A947-70E740481C1C}">
                <a14:useLocalDpi xmlns:a14="http://schemas.microsoft.com/office/drawing/2010/main" val="0"/>
              </a:ext>
            </a:extLst>
          </a:blip>
          <a:srcRect r="62303" b="16099"/>
          <a:stretch/>
        </p:blipFill>
        <p:spPr>
          <a:xfrm>
            <a:off x="6410473" y="468831"/>
            <a:ext cx="2797322" cy="4618673"/>
          </a:xfrm>
          <a:prstGeom prst="rect">
            <a:avLst/>
          </a:prstGeom>
        </p:spPr>
      </p:pic>
      <p:pic>
        <p:nvPicPr>
          <p:cNvPr id="6" name="Picture 5" descr="A close up of a logo&#10;&#10;Description automatically generated">
            <a:extLst>
              <a:ext uri="{FF2B5EF4-FFF2-40B4-BE49-F238E27FC236}">
                <a16:creationId xmlns:a16="http://schemas.microsoft.com/office/drawing/2014/main" id="{CFD27EB4-E774-124E-A8C7-71B5497693AF}"/>
              </a:ext>
            </a:extLst>
          </p:cNvPr>
          <p:cNvPicPr>
            <a:picLocks noChangeAspect="1"/>
          </p:cNvPicPr>
          <p:nvPr/>
        </p:nvPicPr>
        <p:blipFill rotWithShape="1">
          <a:blip r:embed="rId4">
            <a:extLst>
              <a:ext uri="{28A0092B-C50C-407E-A947-70E740481C1C}">
                <a14:useLocalDpi xmlns:a14="http://schemas.microsoft.com/office/drawing/2010/main" val="0"/>
              </a:ext>
            </a:extLst>
          </a:blip>
          <a:srcRect r="61879" b="18120"/>
          <a:stretch/>
        </p:blipFill>
        <p:spPr>
          <a:xfrm>
            <a:off x="2241630" y="492587"/>
            <a:ext cx="2828829" cy="4507365"/>
          </a:xfrm>
          <a:prstGeom prst="rect">
            <a:avLst/>
          </a:prstGeom>
        </p:spPr>
      </p:pic>
      <p:sp>
        <p:nvSpPr>
          <p:cNvPr id="7" name="TextBox 6">
            <a:extLst>
              <a:ext uri="{FF2B5EF4-FFF2-40B4-BE49-F238E27FC236}">
                <a16:creationId xmlns:a16="http://schemas.microsoft.com/office/drawing/2014/main" id="{D40773DB-4237-154D-8F08-0D4B2388AFA2}"/>
              </a:ext>
            </a:extLst>
          </p:cNvPr>
          <p:cNvSpPr txBox="1"/>
          <p:nvPr/>
        </p:nvSpPr>
        <p:spPr>
          <a:xfrm>
            <a:off x="1702539" y="782895"/>
            <a:ext cx="359394" cy="369332"/>
          </a:xfrm>
          <a:prstGeom prst="rect">
            <a:avLst/>
          </a:prstGeom>
          <a:noFill/>
        </p:spPr>
        <p:txBody>
          <a:bodyPr wrap="none" rtlCol="0">
            <a:spAutoFit/>
          </a:bodyPr>
          <a:lstStyle/>
          <a:p>
            <a:r>
              <a:rPr lang="en-GB" b="1" dirty="0"/>
              <a:t>a.</a:t>
            </a:r>
          </a:p>
        </p:txBody>
      </p:sp>
      <p:sp>
        <p:nvSpPr>
          <p:cNvPr id="8" name="TextBox 7">
            <a:extLst>
              <a:ext uri="{FF2B5EF4-FFF2-40B4-BE49-F238E27FC236}">
                <a16:creationId xmlns:a16="http://schemas.microsoft.com/office/drawing/2014/main" id="{EC83458C-511A-A14A-97C9-D990B6F78F76}"/>
              </a:ext>
            </a:extLst>
          </p:cNvPr>
          <p:cNvSpPr txBox="1"/>
          <p:nvPr/>
        </p:nvSpPr>
        <p:spPr>
          <a:xfrm>
            <a:off x="6041461" y="782895"/>
            <a:ext cx="369012" cy="369332"/>
          </a:xfrm>
          <a:prstGeom prst="rect">
            <a:avLst/>
          </a:prstGeom>
          <a:noFill/>
        </p:spPr>
        <p:txBody>
          <a:bodyPr wrap="none" rtlCol="0">
            <a:spAutoFit/>
          </a:bodyPr>
          <a:lstStyle/>
          <a:p>
            <a:r>
              <a:rPr lang="en-GB" b="1" dirty="0"/>
              <a:t>b.</a:t>
            </a:r>
          </a:p>
        </p:txBody>
      </p:sp>
      <p:pic>
        <p:nvPicPr>
          <p:cNvPr id="9" name="Picture 8" descr="A close up of a logo&#10;&#10;Description automatically generated">
            <a:extLst>
              <a:ext uri="{FF2B5EF4-FFF2-40B4-BE49-F238E27FC236}">
                <a16:creationId xmlns:a16="http://schemas.microsoft.com/office/drawing/2014/main" id="{DB5C0FA7-FAF6-4E4F-97B2-DB01EA5DE94D}"/>
              </a:ext>
            </a:extLst>
          </p:cNvPr>
          <p:cNvPicPr>
            <a:picLocks noChangeAspect="1"/>
          </p:cNvPicPr>
          <p:nvPr/>
        </p:nvPicPr>
        <p:blipFill rotWithShape="1">
          <a:blip r:embed="rId3">
            <a:extLst>
              <a:ext uri="{28A0092B-C50C-407E-A947-70E740481C1C}">
                <a14:useLocalDpi xmlns:a14="http://schemas.microsoft.com/office/drawing/2010/main" val="0"/>
              </a:ext>
            </a:extLst>
          </a:blip>
          <a:srcRect l="28893" t="83325" r="46922" b="6731"/>
          <a:stretch/>
        </p:blipFill>
        <p:spPr>
          <a:xfrm>
            <a:off x="8546464" y="967561"/>
            <a:ext cx="1987065" cy="606058"/>
          </a:xfrm>
          <a:prstGeom prst="rect">
            <a:avLst/>
          </a:prstGeom>
        </p:spPr>
      </p:pic>
      <p:pic>
        <p:nvPicPr>
          <p:cNvPr id="10" name="Picture 9" descr="A close up of a logo&#10;&#10;Description automatically generated">
            <a:extLst>
              <a:ext uri="{FF2B5EF4-FFF2-40B4-BE49-F238E27FC236}">
                <a16:creationId xmlns:a16="http://schemas.microsoft.com/office/drawing/2014/main" id="{CA59A6DA-1C8A-7A41-9CD4-CB87C1F4C419}"/>
              </a:ext>
            </a:extLst>
          </p:cNvPr>
          <p:cNvPicPr>
            <a:picLocks noChangeAspect="1"/>
          </p:cNvPicPr>
          <p:nvPr/>
        </p:nvPicPr>
        <p:blipFill rotWithShape="1">
          <a:blip r:embed="rId3">
            <a:extLst>
              <a:ext uri="{28A0092B-C50C-407E-A947-70E740481C1C}">
                <a14:useLocalDpi xmlns:a14="http://schemas.microsoft.com/office/drawing/2010/main" val="0"/>
              </a:ext>
            </a:extLst>
          </a:blip>
          <a:srcRect l="53183" t="83325" r="24994" b="6731"/>
          <a:stretch/>
        </p:blipFill>
        <p:spPr>
          <a:xfrm>
            <a:off x="8789893" y="1436897"/>
            <a:ext cx="1792942" cy="606058"/>
          </a:xfrm>
          <a:prstGeom prst="rect">
            <a:avLst/>
          </a:prstGeom>
        </p:spPr>
      </p:pic>
    </p:spTree>
    <p:extLst>
      <p:ext uri="{BB962C8B-B14F-4D97-AF65-F5344CB8AC3E}">
        <p14:creationId xmlns:p14="http://schemas.microsoft.com/office/powerpoint/2010/main" val="24396048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8630" y="6221282"/>
            <a:ext cx="12192000" cy="584775"/>
          </a:xfrm>
          <a:prstGeom prst="rect">
            <a:avLst/>
          </a:prstGeom>
          <a:noFill/>
        </p:spPr>
        <p:txBody>
          <a:bodyPr wrap="square" rtlCol="0">
            <a:spAutoFit/>
          </a:bodyPr>
          <a:lstStyle/>
          <a:p>
            <a:r>
              <a:rPr lang="en-GB" sz="1600" b="1" dirty="0"/>
              <a:t>Supplementary Figure 5: </a:t>
            </a:r>
            <a:r>
              <a:rPr lang="en-GB" sz="1600" dirty="0"/>
              <a:t> </a:t>
            </a:r>
            <a:r>
              <a:rPr lang="en-GB" sz="1600" b="1" dirty="0"/>
              <a:t>16S rRNA genus bubble plot from the (a) EPS+ and (b) EPS- vessels in each phase. </a:t>
            </a:r>
            <a:r>
              <a:rPr lang="en-GB" sz="1600" dirty="0"/>
              <a:t>Read counts were transferred into reference values to identify small abundance taxa. Samples are clustered on genera abundance. </a:t>
            </a:r>
          </a:p>
        </p:txBody>
      </p:sp>
      <p:pic>
        <p:nvPicPr>
          <p:cNvPr id="5" name="Picture 4" descr="A screenshot of a cell phone&#10;&#10;Description automatically generated">
            <a:extLst>
              <a:ext uri="{FF2B5EF4-FFF2-40B4-BE49-F238E27FC236}">
                <a16:creationId xmlns:a16="http://schemas.microsoft.com/office/drawing/2014/main" id="{1BB95F16-F9B3-9D4A-96E9-035201F5DBB6}"/>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647119" y="3153785"/>
            <a:ext cx="1523117" cy="3046233"/>
          </a:xfrm>
          <a:prstGeom prst="rect">
            <a:avLst/>
          </a:prstGeom>
        </p:spPr>
      </p:pic>
      <p:pic>
        <p:nvPicPr>
          <p:cNvPr id="6" name="Picture 5" descr="A screenshot of a cell phone&#10;&#10;Description automatically generated">
            <a:extLst>
              <a:ext uri="{FF2B5EF4-FFF2-40B4-BE49-F238E27FC236}">
                <a16:creationId xmlns:a16="http://schemas.microsoft.com/office/drawing/2014/main" id="{072C0670-8BD0-A342-B66A-ABE7005432DC}"/>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114630" y="3175049"/>
            <a:ext cx="2436986" cy="3046233"/>
          </a:xfrm>
          <a:prstGeom prst="rect">
            <a:avLst/>
          </a:prstGeom>
        </p:spPr>
      </p:pic>
      <p:pic>
        <p:nvPicPr>
          <p:cNvPr id="7" name="Picture 6" descr="A screenshot of a cell phone&#10;&#10;Description automatically generated">
            <a:extLst>
              <a:ext uri="{FF2B5EF4-FFF2-40B4-BE49-F238E27FC236}">
                <a16:creationId xmlns:a16="http://schemas.microsoft.com/office/drawing/2014/main" id="{E0A67C48-6548-004D-A3E0-B3CB28DA6AB3}"/>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282696" y="3136434"/>
            <a:ext cx="1523117" cy="3046233"/>
          </a:xfrm>
          <a:prstGeom prst="rect">
            <a:avLst/>
          </a:prstGeom>
        </p:spPr>
      </p:pic>
      <p:sp>
        <p:nvSpPr>
          <p:cNvPr id="8" name="TextBox 7">
            <a:extLst>
              <a:ext uri="{FF2B5EF4-FFF2-40B4-BE49-F238E27FC236}">
                <a16:creationId xmlns:a16="http://schemas.microsoft.com/office/drawing/2014/main" id="{C415E7E1-477F-244D-A796-69A934784AB0}"/>
              </a:ext>
            </a:extLst>
          </p:cNvPr>
          <p:cNvSpPr txBox="1"/>
          <p:nvPr/>
        </p:nvSpPr>
        <p:spPr>
          <a:xfrm>
            <a:off x="2287725" y="116562"/>
            <a:ext cx="359394" cy="369332"/>
          </a:xfrm>
          <a:prstGeom prst="rect">
            <a:avLst/>
          </a:prstGeom>
          <a:noFill/>
        </p:spPr>
        <p:txBody>
          <a:bodyPr wrap="none" rtlCol="0">
            <a:spAutoFit/>
          </a:bodyPr>
          <a:lstStyle/>
          <a:p>
            <a:r>
              <a:rPr lang="en-GB" b="1" dirty="0"/>
              <a:t>a.</a:t>
            </a:r>
          </a:p>
        </p:txBody>
      </p:sp>
      <p:sp>
        <p:nvSpPr>
          <p:cNvPr id="9" name="TextBox 8">
            <a:extLst>
              <a:ext uri="{FF2B5EF4-FFF2-40B4-BE49-F238E27FC236}">
                <a16:creationId xmlns:a16="http://schemas.microsoft.com/office/drawing/2014/main" id="{B24ACEA1-FB27-7A4E-9BB3-5003619354A9}"/>
              </a:ext>
            </a:extLst>
          </p:cNvPr>
          <p:cNvSpPr txBox="1"/>
          <p:nvPr/>
        </p:nvSpPr>
        <p:spPr>
          <a:xfrm>
            <a:off x="2448222" y="2951768"/>
            <a:ext cx="369012" cy="369332"/>
          </a:xfrm>
          <a:prstGeom prst="rect">
            <a:avLst/>
          </a:prstGeom>
          <a:noFill/>
        </p:spPr>
        <p:txBody>
          <a:bodyPr wrap="none" rtlCol="0">
            <a:spAutoFit/>
          </a:bodyPr>
          <a:lstStyle/>
          <a:p>
            <a:r>
              <a:rPr lang="en-GB" b="1" dirty="0"/>
              <a:t>b.</a:t>
            </a:r>
          </a:p>
        </p:txBody>
      </p:sp>
      <p:sp>
        <p:nvSpPr>
          <p:cNvPr id="4" name="TextBox 3">
            <a:extLst>
              <a:ext uri="{FF2B5EF4-FFF2-40B4-BE49-F238E27FC236}">
                <a16:creationId xmlns:a16="http://schemas.microsoft.com/office/drawing/2014/main" id="{E6AEC02A-8BE6-3148-8F1D-82B8D4074AEC}"/>
              </a:ext>
            </a:extLst>
          </p:cNvPr>
          <p:cNvSpPr txBox="1"/>
          <p:nvPr/>
        </p:nvSpPr>
        <p:spPr>
          <a:xfrm>
            <a:off x="3318721" y="2990383"/>
            <a:ext cx="851515" cy="369332"/>
          </a:xfrm>
          <a:prstGeom prst="rect">
            <a:avLst/>
          </a:prstGeom>
          <a:solidFill>
            <a:schemeClr val="bg1"/>
          </a:solidFill>
        </p:spPr>
        <p:txBody>
          <a:bodyPr wrap="none" rtlCol="0">
            <a:spAutoFit/>
          </a:bodyPr>
          <a:lstStyle/>
          <a:p>
            <a:r>
              <a:rPr lang="en-US" dirty="0"/>
              <a:t>Phase I</a:t>
            </a:r>
          </a:p>
        </p:txBody>
      </p:sp>
      <p:sp>
        <p:nvSpPr>
          <p:cNvPr id="11" name="TextBox 10">
            <a:extLst>
              <a:ext uri="{FF2B5EF4-FFF2-40B4-BE49-F238E27FC236}">
                <a16:creationId xmlns:a16="http://schemas.microsoft.com/office/drawing/2014/main" id="{BDC46396-188A-8947-AB2A-9D5E90C55551}"/>
              </a:ext>
            </a:extLst>
          </p:cNvPr>
          <p:cNvSpPr txBox="1"/>
          <p:nvPr/>
        </p:nvSpPr>
        <p:spPr>
          <a:xfrm>
            <a:off x="4954298" y="2990383"/>
            <a:ext cx="909223" cy="369332"/>
          </a:xfrm>
          <a:prstGeom prst="rect">
            <a:avLst/>
          </a:prstGeom>
          <a:solidFill>
            <a:schemeClr val="bg1"/>
          </a:solidFill>
        </p:spPr>
        <p:txBody>
          <a:bodyPr wrap="none" rtlCol="0">
            <a:spAutoFit/>
          </a:bodyPr>
          <a:lstStyle/>
          <a:p>
            <a:r>
              <a:rPr lang="en-US" dirty="0"/>
              <a:t>Phase II</a:t>
            </a:r>
          </a:p>
        </p:txBody>
      </p:sp>
      <p:sp>
        <p:nvSpPr>
          <p:cNvPr id="12" name="TextBox 11">
            <a:extLst>
              <a:ext uri="{FF2B5EF4-FFF2-40B4-BE49-F238E27FC236}">
                <a16:creationId xmlns:a16="http://schemas.microsoft.com/office/drawing/2014/main" id="{508CF41F-ADD6-8F4C-A6B8-DF6707C257C5}"/>
              </a:ext>
            </a:extLst>
          </p:cNvPr>
          <p:cNvSpPr txBox="1"/>
          <p:nvPr/>
        </p:nvSpPr>
        <p:spPr>
          <a:xfrm>
            <a:off x="6898692" y="2998354"/>
            <a:ext cx="966931" cy="369332"/>
          </a:xfrm>
          <a:prstGeom prst="rect">
            <a:avLst/>
          </a:prstGeom>
          <a:solidFill>
            <a:schemeClr val="bg1"/>
          </a:solidFill>
        </p:spPr>
        <p:txBody>
          <a:bodyPr wrap="none" rtlCol="0">
            <a:spAutoFit/>
          </a:bodyPr>
          <a:lstStyle/>
          <a:p>
            <a:r>
              <a:rPr lang="en-US" dirty="0"/>
              <a:t>Phase III</a:t>
            </a:r>
          </a:p>
        </p:txBody>
      </p:sp>
      <p:pic>
        <p:nvPicPr>
          <p:cNvPr id="21" name="Picture 20" descr="A screenshot of a cell phone&#10;&#10;Description automatically generated">
            <a:extLst>
              <a:ext uri="{FF2B5EF4-FFF2-40B4-BE49-F238E27FC236}">
                <a16:creationId xmlns:a16="http://schemas.microsoft.com/office/drawing/2014/main" id="{2F43F5A4-9309-3D43-B020-FDFD621A5BCF}"/>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746980" y="212725"/>
            <a:ext cx="1404430" cy="2808859"/>
          </a:xfrm>
          <a:prstGeom prst="rect">
            <a:avLst/>
          </a:prstGeom>
        </p:spPr>
      </p:pic>
      <p:pic>
        <p:nvPicPr>
          <p:cNvPr id="22" name="Picture 21" descr="A screenshot of a social media post&#10;&#10;Description automatically generated">
            <a:extLst>
              <a:ext uri="{FF2B5EF4-FFF2-40B4-BE49-F238E27FC236}">
                <a16:creationId xmlns:a16="http://schemas.microsoft.com/office/drawing/2014/main" id="{04D269D7-B802-014F-8250-02A189B1D333}"/>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6288309" y="244624"/>
            <a:ext cx="2247087" cy="2808859"/>
          </a:xfrm>
          <a:prstGeom prst="rect">
            <a:avLst/>
          </a:prstGeom>
        </p:spPr>
      </p:pic>
      <p:pic>
        <p:nvPicPr>
          <p:cNvPr id="23" name="Picture 22" descr="A screenshot of a cell phone&#10;&#10;Description automatically generated">
            <a:extLst>
              <a:ext uri="{FF2B5EF4-FFF2-40B4-BE49-F238E27FC236}">
                <a16:creationId xmlns:a16="http://schemas.microsoft.com/office/drawing/2014/main" id="{33FE9739-079D-EB40-8D7B-900D8C15EA66}"/>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476798" y="213081"/>
            <a:ext cx="1404430" cy="2808859"/>
          </a:xfrm>
          <a:prstGeom prst="rect">
            <a:avLst/>
          </a:prstGeom>
        </p:spPr>
      </p:pic>
      <p:sp>
        <p:nvSpPr>
          <p:cNvPr id="25" name="TextBox 24">
            <a:extLst>
              <a:ext uri="{FF2B5EF4-FFF2-40B4-BE49-F238E27FC236}">
                <a16:creationId xmlns:a16="http://schemas.microsoft.com/office/drawing/2014/main" id="{1447B1E2-2064-2E47-82F8-1F4D63E42489}"/>
              </a:ext>
            </a:extLst>
          </p:cNvPr>
          <p:cNvSpPr txBox="1"/>
          <p:nvPr/>
        </p:nvSpPr>
        <p:spPr>
          <a:xfrm>
            <a:off x="3336428" y="80524"/>
            <a:ext cx="851515" cy="369332"/>
          </a:xfrm>
          <a:prstGeom prst="rect">
            <a:avLst/>
          </a:prstGeom>
          <a:solidFill>
            <a:schemeClr val="bg1"/>
          </a:solidFill>
        </p:spPr>
        <p:txBody>
          <a:bodyPr wrap="none" rtlCol="0">
            <a:spAutoFit/>
          </a:bodyPr>
          <a:lstStyle/>
          <a:p>
            <a:r>
              <a:rPr lang="en-US" dirty="0"/>
              <a:t>Phase I</a:t>
            </a:r>
          </a:p>
        </p:txBody>
      </p:sp>
      <p:sp>
        <p:nvSpPr>
          <p:cNvPr id="26" name="TextBox 25">
            <a:extLst>
              <a:ext uri="{FF2B5EF4-FFF2-40B4-BE49-F238E27FC236}">
                <a16:creationId xmlns:a16="http://schemas.microsoft.com/office/drawing/2014/main" id="{9A70DCA9-FCD4-ED44-A745-4BE00257D062}"/>
              </a:ext>
            </a:extLst>
          </p:cNvPr>
          <p:cNvSpPr txBox="1"/>
          <p:nvPr/>
        </p:nvSpPr>
        <p:spPr>
          <a:xfrm>
            <a:off x="4972005" y="80524"/>
            <a:ext cx="909223" cy="369332"/>
          </a:xfrm>
          <a:prstGeom prst="rect">
            <a:avLst/>
          </a:prstGeom>
          <a:solidFill>
            <a:schemeClr val="bg1"/>
          </a:solidFill>
        </p:spPr>
        <p:txBody>
          <a:bodyPr wrap="none" rtlCol="0">
            <a:spAutoFit/>
          </a:bodyPr>
          <a:lstStyle/>
          <a:p>
            <a:r>
              <a:rPr lang="en-US" dirty="0"/>
              <a:t>Phase II</a:t>
            </a:r>
          </a:p>
        </p:txBody>
      </p:sp>
      <p:sp>
        <p:nvSpPr>
          <p:cNvPr id="27" name="TextBox 26">
            <a:extLst>
              <a:ext uri="{FF2B5EF4-FFF2-40B4-BE49-F238E27FC236}">
                <a16:creationId xmlns:a16="http://schemas.microsoft.com/office/drawing/2014/main" id="{47817C86-B84E-804B-84FD-6A15E02574FA}"/>
              </a:ext>
            </a:extLst>
          </p:cNvPr>
          <p:cNvSpPr txBox="1"/>
          <p:nvPr/>
        </p:nvSpPr>
        <p:spPr>
          <a:xfrm>
            <a:off x="6916399" y="88495"/>
            <a:ext cx="966931" cy="369332"/>
          </a:xfrm>
          <a:prstGeom prst="rect">
            <a:avLst/>
          </a:prstGeom>
          <a:solidFill>
            <a:schemeClr val="bg1"/>
          </a:solidFill>
        </p:spPr>
        <p:txBody>
          <a:bodyPr wrap="none" rtlCol="0">
            <a:spAutoFit/>
          </a:bodyPr>
          <a:lstStyle/>
          <a:p>
            <a:r>
              <a:rPr lang="en-US" dirty="0"/>
              <a:t>Phase III</a:t>
            </a:r>
          </a:p>
        </p:txBody>
      </p:sp>
    </p:spTree>
    <p:extLst>
      <p:ext uri="{BB962C8B-B14F-4D97-AF65-F5344CB8AC3E}">
        <p14:creationId xmlns:p14="http://schemas.microsoft.com/office/powerpoint/2010/main" val="27673841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504BA44B-EEFB-BD4A-AE02-8CB68B13891F}"/>
              </a:ext>
            </a:extLst>
          </p:cNvPr>
          <p:cNvSpPr/>
          <p:nvPr/>
        </p:nvSpPr>
        <p:spPr>
          <a:xfrm>
            <a:off x="379380" y="5552581"/>
            <a:ext cx="11527276" cy="584775"/>
          </a:xfrm>
          <a:prstGeom prst="rect">
            <a:avLst/>
          </a:prstGeom>
        </p:spPr>
        <p:txBody>
          <a:bodyPr wrap="square">
            <a:spAutoFit/>
          </a:bodyPr>
          <a:lstStyle/>
          <a:p>
            <a:r>
              <a:rPr lang="en-GB" sz="1600" b="1" dirty="0"/>
              <a:t>Supplementary Figure 6: </a:t>
            </a:r>
            <a:r>
              <a:rPr lang="en-GB" sz="1600" dirty="0"/>
              <a:t>Correlation of either </a:t>
            </a:r>
            <a:r>
              <a:rPr lang="en-GB" sz="1600" i="1" dirty="0"/>
              <a:t>Bifidobacterium </a:t>
            </a:r>
            <a:r>
              <a:rPr lang="en-GB" sz="1600" dirty="0"/>
              <a:t>or </a:t>
            </a:r>
            <a:r>
              <a:rPr lang="en-GB" sz="1600" i="1" dirty="0"/>
              <a:t>B. breve </a:t>
            </a:r>
            <a:r>
              <a:rPr lang="en-GB" sz="1600" dirty="0"/>
              <a:t>with other genera in EPS+ and EPS- vessels (t=1-36h) using a </a:t>
            </a:r>
            <a:r>
              <a:rPr lang="en-US" sz="1600" dirty="0"/>
              <a:t>Kendall rank correlation coefficient analysis </a:t>
            </a:r>
            <a:r>
              <a:rPr lang="en-GB" sz="1600" dirty="0"/>
              <a:t>in R Studio (*p=0.033). </a:t>
            </a:r>
            <a:endParaRPr lang="en-US" sz="1600" dirty="0"/>
          </a:p>
        </p:txBody>
      </p:sp>
      <p:pic>
        <p:nvPicPr>
          <p:cNvPr id="3" name="Content Placeholder 4" descr="A screenshot of a cell phone&#10;&#10;Description automatically generated">
            <a:extLst>
              <a:ext uri="{FF2B5EF4-FFF2-40B4-BE49-F238E27FC236}">
                <a16:creationId xmlns:a16="http://schemas.microsoft.com/office/drawing/2014/main" id="{208FA6B6-B895-A64D-B989-2698C31D31C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694185" y="611306"/>
            <a:ext cx="4351338" cy="4351338"/>
          </a:xfrm>
          <a:prstGeom prst="rect">
            <a:avLst/>
          </a:prstGeom>
        </p:spPr>
      </p:pic>
    </p:spTree>
    <p:extLst>
      <p:ext uri="{BB962C8B-B14F-4D97-AF65-F5344CB8AC3E}">
        <p14:creationId xmlns:p14="http://schemas.microsoft.com/office/powerpoint/2010/main" val="308355689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4A193A9-CDC5-5648-AC64-D4E378748F51}"/>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18041" r="40638" b="13243"/>
          <a:stretch/>
        </p:blipFill>
        <p:spPr>
          <a:xfrm>
            <a:off x="564459" y="808113"/>
            <a:ext cx="2037653" cy="1780635"/>
          </a:xfrm>
          <a:prstGeom prst="rect">
            <a:avLst/>
          </a:prstGeom>
        </p:spPr>
      </p:pic>
      <p:pic>
        <p:nvPicPr>
          <p:cNvPr id="5" name="Picture 4">
            <a:extLst>
              <a:ext uri="{FF2B5EF4-FFF2-40B4-BE49-F238E27FC236}">
                <a16:creationId xmlns:a16="http://schemas.microsoft.com/office/drawing/2014/main" id="{8EDAF33B-D3DA-2642-B561-5D45108C16C9}"/>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6177" t="17320" r="41079" b="13746"/>
          <a:stretch/>
        </p:blipFill>
        <p:spPr>
          <a:xfrm>
            <a:off x="678023" y="3104333"/>
            <a:ext cx="1810524" cy="1786270"/>
          </a:xfrm>
          <a:prstGeom prst="rect">
            <a:avLst/>
          </a:prstGeom>
        </p:spPr>
      </p:pic>
      <p:sp>
        <p:nvSpPr>
          <p:cNvPr id="6" name="TextBox 5">
            <a:extLst>
              <a:ext uri="{FF2B5EF4-FFF2-40B4-BE49-F238E27FC236}">
                <a16:creationId xmlns:a16="http://schemas.microsoft.com/office/drawing/2014/main" id="{1DC15826-1DA9-7C42-94E8-3ABD2A8A150B}"/>
              </a:ext>
            </a:extLst>
          </p:cNvPr>
          <p:cNvSpPr txBox="1"/>
          <p:nvPr/>
        </p:nvSpPr>
        <p:spPr>
          <a:xfrm>
            <a:off x="225851" y="5972066"/>
            <a:ext cx="11714512" cy="830997"/>
          </a:xfrm>
          <a:prstGeom prst="rect">
            <a:avLst/>
          </a:prstGeom>
          <a:noFill/>
        </p:spPr>
        <p:txBody>
          <a:bodyPr wrap="square" rtlCol="0">
            <a:spAutoFit/>
          </a:bodyPr>
          <a:lstStyle/>
          <a:p>
            <a:r>
              <a:rPr lang="en-GB" sz="1600" b="1" dirty="0"/>
              <a:t>Supplementary Figure 7: (a) </a:t>
            </a:r>
            <a:r>
              <a:rPr lang="en-GB" sz="1600" baseline="30000" dirty="0"/>
              <a:t>1</a:t>
            </a:r>
            <a:r>
              <a:rPr lang="en-GB" sz="1600" dirty="0"/>
              <a:t>H NMR metabolic at t=0 for EPS+ and</a:t>
            </a:r>
            <a:r>
              <a:rPr lang="en-GB" sz="1600" b="1" dirty="0"/>
              <a:t> </a:t>
            </a:r>
            <a:r>
              <a:rPr lang="en-GB" sz="1600" dirty="0"/>
              <a:t>EPS- vessels. (</a:t>
            </a:r>
            <a:r>
              <a:rPr lang="en-GB" sz="1600" b="1" dirty="0"/>
              <a:t>b</a:t>
            </a:r>
            <a:r>
              <a:rPr lang="en-GB" sz="1600" dirty="0"/>
              <a:t>) Spearman correlation between top 20 bacteria genera against all identified metabolites by </a:t>
            </a:r>
            <a:r>
              <a:rPr lang="en-GB" sz="1600" baseline="30000" dirty="0"/>
              <a:t>1</a:t>
            </a:r>
            <a:r>
              <a:rPr lang="en-GB" sz="1600" dirty="0"/>
              <a:t>H NMR. *p &lt; 0.05; **p&lt;0.01; ***p&lt;0.001; + indicates metabolite concentrations below detectable limits.</a:t>
            </a:r>
          </a:p>
        </p:txBody>
      </p:sp>
      <p:sp>
        <p:nvSpPr>
          <p:cNvPr id="7" name="TextBox 6">
            <a:extLst>
              <a:ext uri="{FF2B5EF4-FFF2-40B4-BE49-F238E27FC236}">
                <a16:creationId xmlns:a16="http://schemas.microsoft.com/office/drawing/2014/main" id="{B866B9AE-CAEF-E043-A254-EC5217678069}"/>
              </a:ext>
            </a:extLst>
          </p:cNvPr>
          <p:cNvSpPr txBox="1"/>
          <p:nvPr/>
        </p:nvSpPr>
        <p:spPr>
          <a:xfrm>
            <a:off x="448523" y="144462"/>
            <a:ext cx="359394" cy="369332"/>
          </a:xfrm>
          <a:prstGeom prst="rect">
            <a:avLst/>
          </a:prstGeom>
          <a:noFill/>
        </p:spPr>
        <p:txBody>
          <a:bodyPr wrap="none" rtlCol="0">
            <a:spAutoFit/>
          </a:bodyPr>
          <a:lstStyle/>
          <a:p>
            <a:r>
              <a:rPr lang="en-GB" b="1" dirty="0"/>
              <a:t>a.</a:t>
            </a:r>
          </a:p>
        </p:txBody>
      </p:sp>
      <p:sp>
        <p:nvSpPr>
          <p:cNvPr id="8" name="TextBox 7">
            <a:extLst>
              <a:ext uri="{FF2B5EF4-FFF2-40B4-BE49-F238E27FC236}">
                <a16:creationId xmlns:a16="http://schemas.microsoft.com/office/drawing/2014/main" id="{FCCEC159-255A-D74F-8B7A-D9F27B0C6A09}"/>
              </a:ext>
            </a:extLst>
          </p:cNvPr>
          <p:cNvSpPr txBox="1"/>
          <p:nvPr/>
        </p:nvSpPr>
        <p:spPr>
          <a:xfrm>
            <a:off x="4813313" y="144462"/>
            <a:ext cx="369012" cy="369332"/>
          </a:xfrm>
          <a:prstGeom prst="rect">
            <a:avLst/>
          </a:prstGeom>
          <a:noFill/>
        </p:spPr>
        <p:txBody>
          <a:bodyPr wrap="none" rtlCol="0">
            <a:spAutoFit/>
          </a:bodyPr>
          <a:lstStyle/>
          <a:p>
            <a:r>
              <a:rPr lang="en-GB" b="1" dirty="0"/>
              <a:t>b.</a:t>
            </a:r>
          </a:p>
        </p:txBody>
      </p:sp>
      <p:sp>
        <p:nvSpPr>
          <p:cNvPr id="9" name="TextBox 8">
            <a:extLst>
              <a:ext uri="{FF2B5EF4-FFF2-40B4-BE49-F238E27FC236}">
                <a16:creationId xmlns:a16="http://schemas.microsoft.com/office/drawing/2014/main" id="{7E959B71-D378-9E45-BEE4-53A05B34DA2F}"/>
              </a:ext>
            </a:extLst>
          </p:cNvPr>
          <p:cNvSpPr txBox="1"/>
          <p:nvPr/>
        </p:nvSpPr>
        <p:spPr>
          <a:xfrm>
            <a:off x="597276" y="365655"/>
            <a:ext cx="1972019" cy="369332"/>
          </a:xfrm>
          <a:prstGeom prst="rect">
            <a:avLst/>
          </a:prstGeom>
          <a:noFill/>
        </p:spPr>
        <p:txBody>
          <a:bodyPr wrap="square" rtlCol="0">
            <a:spAutoFit/>
          </a:bodyPr>
          <a:lstStyle/>
          <a:p>
            <a:pPr algn="ctr"/>
            <a:r>
              <a:rPr lang="en-US" u="sng" dirty="0"/>
              <a:t>EPS + vessel</a:t>
            </a:r>
          </a:p>
        </p:txBody>
      </p:sp>
      <p:sp>
        <p:nvSpPr>
          <p:cNvPr id="10" name="TextBox 9">
            <a:extLst>
              <a:ext uri="{FF2B5EF4-FFF2-40B4-BE49-F238E27FC236}">
                <a16:creationId xmlns:a16="http://schemas.microsoft.com/office/drawing/2014/main" id="{7F29462D-CF21-F044-8167-050437DA1ACF}"/>
              </a:ext>
            </a:extLst>
          </p:cNvPr>
          <p:cNvSpPr txBox="1"/>
          <p:nvPr/>
        </p:nvSpPr>
        <p:spPr>
          <a:xfrm>
            <a:off x="597276" y="2661874"/>
            <a:ext cx="1972019" cy="369332"/>
          </a:xfrm>
          <a:prstGeom prst="rect">
            <a:avLst/>
          </a:prstGeom>
          <a:noFill/>
        </p:spPr>
        <p:txBody>
          <a:bodyPr wrap="square" rtlCol="0">
            <a:spAutoFit/>
          </a:bodyPr>
          <a:lstStyle/>
          <a:p>
            <a:pPr algn="ctr"/>
            <a:r>
              <a:rPr lang="en-US" u="sng" dirty="0"/>
              <a:t>EPS - vessel</a:t>
            </a:r>
          </a:p>
        </p:txBody>
      </p:sp>
      <p:pic>
        <p:nvPicPr>
          <p:cNvPr id="11" name="Picture 10">
            <a:extLst>
              <a:ext uri="{FF2B5EF4-FFF2-40B4-BE49-F238E27FC236}">
                <a16:creationId xmlns:a16="http://schemas.microsoft.com/office/drawing/2014/main" id="{B745DA7F-414C-604D-8B6B-E2C22CBC8DAE}"/>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63463" t="24641" b="20777"/>
          <a:stretch/>
        </p:blipFill>
        <p:spPr>
          <a:xfrm>
            <a:off x="2744493" y="3806456"/>
            <a:ext cx="1706516" cy="1924493"/>
          </a:xfrm>
          <a:prstGeom prst="rect">
            <a:avLst/>
          </a:prstGeom>
        </p:spPr>
      </p:pic>
      <p:pic>
        <p:nvPicPr>
          <p:cNvPr id="4" name="Picture 3">
            <a:extLst>
              <a:ext uri="{FF2B5EF4-FFF2-40B4-BE49-F238E27FC236}">
                <a16:creationId xmlns:a16="http://schemas.microsoft.com/office/drawing/2014/main" id="{00FFEF7C-490F-4946-8D2E-F9E1FC97F288}"/>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997819" y="485666"/>
            <a:ext cx="6400800" cy="5486400"/>
          </a:xfrm>
          <a:prstGeom prst="rect">
            <a:avLst/>
          </a:prstGeom>
        </p:spPr>
      </p:pic>
    </p:spTree>
    <p:extLst>
      <p:ext uri="{BB962C8B-B14F-4D97-AF65-F5344CB8AC3E}">
        <p14:creationId xmlns:p14="http://schemas.microsoft.com/office/powerpoint/2010/main" val="78996209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9" name="Abgerundetes Rechteck 88"/>
          <p:cNvSpPr/>
          <p:nvPr/>
        </p:nvSpPr>
        <p:spPr>
          <a:xfrm>
            <a:off x="6634234" y="241933"/>
            <a:ext cx="1691375" cy="4965015"/>
          </a:xfrm>
          <a:prstGeom prst="roundRect">
            <a:avLst/>
          </a:prstGeom>
          <a:solidFill>
            <a:schemeClr val="bg2">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de-DE"/>
          </a:p>
        </p:txBody>
      </p:sp>
      <p:sp>
        <p:nvSpPr>
          <p:cNvPr id="88" name="Abgerundetes Rechteck 87"/>
          <p:cNvSpPr/>
          <p:nvPr/>
        </p:nvSpPr>
        <p:spPr>
          <a:xfrm>
            <a:off x="2917534" y="175366"/>
            <a:ext cx="1691375" cy="4965015"/>
          </a:xfrm>
          <a:prstGeom prst="roundRect">
            <a:avLst/>
          </a:prstGeom>
          <a:solidFill>
            <a:schemeClr val="bg2">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de-DE"/>
          </a:p>
        </p:txBody>
      </p:sp>
      <p:sp>
        <p:nvSpPr>
          <p:cNvPr id="84" name="Rechteck 83"/>
          <p:cNvSpPr/>
          <p:nvPr/>
        </p:nvSpPr>
        <p:spPr>
          <a:xfrm>
            <a:off x="2205135" y="2300088"/>
            <a:ext cx="1002524" cy="983585"/>
          </a:xfrm>
          <a:prstGeom prst="rect">
            <a:avLst/>
          </a:prstGeom>
          <a:solidFill>
            <a:schemeClr val="bg1"/>
          </a:solidFill>
        </p:spPr>
        <p:style>
          <a:lnRef idx="2">
            <a:schemeClr val="dk1"/>
          </a:lnRef>
          <a:fillRef idx="1">
            <a:schemeClr val="lt1"/>
          </a:fillRef>
          <a:effectRef idx="0">
            <a:schemeClr val="dk1"/>
          </a:effectRef>
          <a:fontRef idx="minor">
            <a:schemeClr val="dk1"/>
          </a:fontRef>
        </p:style>
        <p:txBody>
          <a:bodyPr rtlCol="0" anchor="ctr"/>
          <a:lstStyle/>
          <a:p>
            <a:pPr algn="ctr"/>
            <a:endParaRPr lang="de-DE" dirty="0">
              <a:solidFill>
                <a:schemeClr val="tx1"/>
              </a:solidFill>
            </a:endParaRPr>
          </a:p>
        </p:txBody>
      </p:sp>
      <p:sp>
        <p:nvSpPr>
          <p:cNvPr id="2" name="TextBox 5"/>
          <p:cNvSpPr txBox="1"/>
          <p:nvPr/>
        </p:nvSpPr>
        <p:spPr>
          <a:xfrm>
            <a:off x="233854" y="5816973"/>
            <a:ext cx="11691983" cy="584775"/>
          </a:xfrm>
          <a:prstGeom prst="rect">
            <a:avLst/>
          </a:prstGeom>
          <a:noFill/>
        </p:spPr>
        <p:txBody>
          <a:bodyPr wrap="square" rtlCol="0">
            <a:spAutoFit/>
          </a:bodyPr>
          <a:lstStyle/>
          <a:p>
            <a:r>
              <a:rPr lang="en-GB" sz="1600" b="1" dirty="0"/>
              <a:t>Supplementary Figure 8: </a:t>
            </a:r>
            <a:r>
              <a:rPr lang="en-GB" sz="1600" dirty="0"/>
              <a:t>Predicted EPS-mediated cross-feeding example in the microbial community, of primary and secondary EPS degrader with respective increase of metabolites. </a:t>
            </a:r>
          </a:p>
        </p:txBody>
      </p:sp>
      <p:grpSp>
        <p:nvGrpSpPr>
          <p:cNvPr id="3" name="Group 228">
            <a:extLst>
              <a:ext uri="{FF2B5EF4-FFF2-40B4-BE49-F238E27FC236}">
                <a16:creationId xmlns:a16="http://schemas.microsoft.com/office/drawing/2014/main" id="{CF33CAFE-4CB2-41E9-AB60-0347380F9C65}"/>
              </a:ext>
            </a:extLst>
          </p:cNvPr>
          <p:cNvGrpSpPr/>
          <p:nvPr/>
        </p:nvGrpSpPr>
        <p:grpSpPr>
          <a:xfrm>
            <a:off x="591239" y="2291508"/>
            <a:ext cx="466380" cy="815249"/>
            <a:chOff x="706190" y="3691479"/>
            <a:chExt cx="185503" cy="321864"/>
          </a:xfrm>
          <a:effectLst>
            <a:glow rad="139700">
              <a:schemeClr val="accent1">
                <a:satMod val="175000"/>
                <a:alpha val="40000"/>
              </a:schemeClr>
            </a:glow>
          </a:effectLst>
        </p:grpSpPr>
        <p:sp>
          <p:nvSpPr>
            <p:cNvPr id="4" name="L-Shape 240">
              <a:extLst>
                <a:ext uri="{FF2B5EF4-FFF2-40B4-BE49-F238E27FC236}">
                  <a16:creationId xmlns:a16="http://schemas.microsoft.com/office/drawing/2014/main" id="{DF1B6FB2-49FE-42A7-A710-86A08DF57BEE}"/>
                </a:ext>
              </a:extLst>
            </p:cNvPr>
            <p:cNvSpPr/>
            <p:nvPr/>
          </p:nvSpPr>
          <p:spPr>
            <a:xfrm rot="18919872">
              <a:off x="706190" y="3691479"/>
              <a:ext cx="185503" cy="167393"/>
            </a:xfrm>
            <a:custGeom>
              <a:avLst/>
              <a:gdLst>
                <a:gd name="connsiteX0" fmla="*/ 0 w 477919"/>
                <a:gd name="connsiteY0" fmla="*/ 0 h 455660"/>
                <a:gd name="connsiteX1" fmla="*/ 158820 w 477919"/>
                <a:gd name="connsiteY1" fmla="*/ 0 h 455660"/>
                <a:gd name="connsiteX2" fmla="*/ 158820 w 477919"/>
                <a:gd name="connsiteY2" fmla="*/ 305465 h 455660"/>
                <a:gd name="connsiteX3" fmla="*/ 477919 w 477919"/>
                <a:gd name="connsiteY3" fmla="*/ 305465 h 455660"/>
                <a:gd name="connsiteX4" fmla="*/ 477919 w 477919"/>
                <a:gd name="connsiteY4" fmla="*/ 455660 h 455660"/>
                <a:gd name="connsiteX5" fmla="*/ 0 w 477919"/>
                <a:gd name="connsiteY5" fmla="*/ 455660 h 455660"/>
                <a:gd name="connsiteX6" fmla="*/ 0 w 477919"/>
                <a:gd name="connsiteY6" fmla="*/ 0 h 455660"/>
                <a:gd name="connsiteX0" fmla="*/ 0 w 477919"/>
                <a:gd name="connsiteY0" fmla="*/ 8993 h 464653"/>
                <a:gd name="connsiteX1" fmla="*/ 133065 w 477919"/>
                <a:gd name="connsiteY1" fmla="*/ 0 h 464653"/>
                <a:gd name="connsiteX2" fmla="*/ 158820 w 477919"/>
                <a:gd name="connsiteY2" fmla="*/ 314458 h 464653"/>
                <a:gd name="connsiteX3" fmla="*/ 477919 w 477919"/>
                <a:gd name="connsiteY3" fmla="*/ 314458 h 464653"/>
                <a:gd name="connsiteX4" fmla="*/ 477919 w 477919"/>
                <a:gd name="connsiteY4" fmla="*/ 464653 h 464653"/>
                <a:gd name="connsiteX5" fmla="*/ 0 w 477919"/>
                <a:gd name="connsiteY5" fmla="*/ 464653 h 464653"/>
                <a:gd name="connsiteX6" fmla="*/ 0 w 477919"/>
                <a:gd name="connsiteY6" fmla="*/ 8993 h 464653"/>
                <a:gd name="connsiteX0" fmla="*/ 0 w 477919"/>
                <a:gd name="connsiteY0" fmla="*/ 0 h 455660"/>
                <a:gd name="connsiteX1" fmla="*/ 120821 w 477919"/>
                <a:gd name="connsiteY1" fmla="*/ 14649 h 455660"/>
                <a:gd name="connsiteX2" fmla="*/ 158820 w 477919"/>
                <a:gd name="connsiteY2" fmla="*/ 305465 h 455660"/>
                <a:gd name="connsiteX3" fmla="*/ 477919 w 477919"/>
                <a:gd name="connsiteY3" fmla="*/ 305465 h 455660"/>
                <a:gd name="connsiteX4" fmla="*/ 477919 w 477919"/>
                <a:gd name="connsiteY4" fmla="*/ 455660 h 455660"/>
                <a:gd name="connsiteX5" fmla="*/ 0 w 477919"/>
                <a:gd name="connsiteY5" fmla="*/ 455660 h 455660"/>
                <a:gd name="connsiteX6" fmla="*/ 0 w 477919"/>
                <a:gd name="connsiteY6" fmla="*/ 0 h 455660"/>
                <a:gd name="connsiteX0" fmla="*/ 0 w 477919"/>
                <a:gd name="connsiteY0" fmla="*/ 0 h 455660"/>
                <a:gd name="connsiteX1" fmla="*/ 120821 w 477919"/>
                <a:gd name="connsiteY1" fmla="*/ 14649 h 455660"/>
                <a:gd name="connsiteX2" fmla="*/ 158820 w 477919"/>
                <a:gd name="connsiteY2" fmla="*/ 305465 h 455660"/>
                <a:gd name="connsiteX3" fmla="*/ 477919 w 477919"/>
                <a:gd name="connsiteY3" fmla="*/ 305465 h 455660"/>
                <a:gd name="connsiteX4" fmla="*/ 477919 w 477919"/>
                <a:gd name="connsiteY4" fmla="*/ 455660 h 455660"/>
                <a:gd name="connsiteX5" fmla="*/ 0 w 477919"/>
                <a:gd name="connsiteY5" fmla="*/ 455660 h 455660"/>
                <a:gd name="connsiteX6" fmla="*/ 0 w 477919"/>
                <a:gd name="connsiteY6" fmla="*/ 0 h 455660"/>
                <a:gd name="connsiteX0" fmla="*/ 0 w 477919"/>
                <a:gd name="connsiteY0" fmla="*/ 0 h 455660"/>
                <a:gd name="connsiteX1" fmla="*/ 120821 w 477919"/>
                <a:gd name="connsiteY1" fmla="*/ 14649 h 455660"/>
                <a:gd name="connsiteX2" fmla="*/ 158820 w 477919"/>
                <a:gd name="connsiteY2" fmla="*/ 305465 h 455660"/>
                <a:gd name="connsiteX3" fmla="*/ 477919 w 477919"/>
                <a:gd name="connsiteY3" fmla="*/ 305465 h 455660"/>
                <a:gd name="connsiteX4" fmla="*/ 477919 w 477919"/>
                <a:gd name="connsiteY4" fmla="*/ 455660 h 455660"/>
                <a:gd name="connsiteX5" fmla="*/ 0 w 477919"/>
                <a:gd name="connsiteY5" fmla="*/ 455660 h 455660"/>
                <a:gd name="connsiteX6" fmla="*/ 0 w 477919"/>
                <a:gd name="connsiteY6" fmla="*/ 0 h 455660"/>
                <a:gd name="connsiteX0" fmla="*/ 0 w 477919"/>
                <a:gd name="connsiteY0" fmla="*/ 0 h 455660"/>
                <a:gd name="connsiteX1" fmla="*/ 111658 w 477919"/>
                <a:gd name="connsiteY1" fmla="*/ 22616 h 455660"/>
                <a:gd name="connsiteX2" fmla="*/ 158820 w 477919"/>
                <a:gd name="connsiteY2" fmla="*/ 305465 h 455660"/>
                <a:gd name="connsiteX3" fmla="*/ 477919 w 477919"/>
                <a:gd name="connsiteY3" fmla="*/ 305465 h 455660"/>
                <a:gd name="connsiteX4" fmla="*/ 477919 w 477919"/>
                <a:gd name="connsiteY4" fmla="*/ 455660 h 455660"/>
                <a:gd name="connsiteX5" fmla="*/ 0 w 477919"/>
                <a:gd name="connsiteY5" fmla="*/ 455660 h 455660"/>
                <a:gd name="connsiteX6" fmla="*/ 0 w 477919"/>
                <a:gd name="connsiteY6" fmla="*/ 0 h 455660"/>
                <a:gd name="connsiteX0" fmla="*/ 26552 w 477919"/>
                <a:gd name="connsiteY0" fmla="*/ 0 h 447186"/>
                <a:gd name="connsiteX1" fmla="*/ 111658 w 477919"/>
                <a:gd name="connsiteY1" fmla="*/ 14142 h 447186"/>
                <a:gd name="connsiteX2" fmla="*/ 158820 w 477919"/>
                <a:gd name="connsiteY2" fmla="*/ 296991 h 447186"/>
                <a:gd name="connsiteX3" fmla="*/ 477919 w 477919"/>
                <a:gd name="connsiteY3" fmla="*/ 296991 h 447186"/>
                <a:gd name="connsiteX4" fmla="*/ 477919 w 477919"/>
                <a:gd name="connsiteY4" fmla="*/ 447186 h 447186"/>
                <a:gd name="connsiteX5" fmla="*/ 0 w 477919"/>
                <a:gd name="connsiteY5" fmla="*/ 447186 h 447186"/>
                <a:gd name="connsiteX6" fmla="*/ 26552 w 477919"/>
                <a:gd name="connsiteY6" fmla="*/ 0 h 447186"/>
                <a:gd name="connsiteX0" fmla="*/ 43253 w 477919"/>
                <a:gd name="connsiteY0" fmla="*/ 0 h 449331"/>
                <a:gd name="connsiteX1" fmla="*/ 111658 w 477919"/>
                <a:gd name="connsiteY1" fmla="*/ 16287 h 449331"/>
                <a:gd name="connsiteX2" fmla="*/ 158820 w 477919"/>
                <a:gd name="connsiteY2" fmla="*/ 299136 h 449331"/>
                <a:gd name="connsiteX3" fmla="*/ 477919 w 477919"/>
                <a:gd name="connsiteY3" fmla="*/ 299136 h 449331"/>
                <a:gd name="connsiteX4" fmla="*/ 477919 w 477919"/>
                <a:gd name="connsiteY4" fmla="*/ 449331 h 449331"/>
                <a:gd name="connsiteX5" fmla="*/ 0 w 477919"/>
                <a:gd name="connsiteY5" fmla="*/ 449331 h 449331"/>
                <a:gd name="connsiteX6" fmla="*/ 43253 w 477919"/>
                <a:gd name="connsiteY6" fmla="*/ 0 h 449331"/>
                <a:gd name="connsiteX0" fmla="*/ 43253 w 477919"/>
                <a:gd name="connsiteY0" fmla="*/ 3356 h 452687"/>
                <a:gd name="connsiteX1" fmla="*/ 111658 w 477919"/>
                <a:gd name="connsiteY1" fmla="*/ 19643 h 452687"/>
                <a:gd name="connsiteX2" fmla="*/ 158820 w 477919"/>
                <a:gd name="connsiteY2" fmla="*/ 302492 h 452687"/>
                <a:gd name="connsiteX3" fmla="*/ 477919 w 477919"/>
                <a:gd name="connsiteY3" fmla="*/ 302492 h 452687"/>
                <a:gd name="connsiteX4" fmla="*/ 477919 w 477919"/>
                <a:gd name="connsiteY4" fmla="*/ 452687 h 452687"/>
                <a:gd name="connsiteX5" fmla="*/ 0 w 477919"/>
                <a:gd name="connsiteY5" fmla="*/ 452687 h 452687"/>
                <a:gd name="connsiteX6" fmla="*/ 43253 w 477919"/>
                <a:gd name="connsiteY6" fmla="*/ 3356 h 452687"/>
                <a:gd name="connsiteX0" fmla="*/ 43253 w 477919"/>
                <a:gd name="connsiteY0" fmla="*/ 3356 h 452687"/>
                <a:gd name="connsiteX1" fmla="*/ 111658 w 477919"/>
                <a:gd name="connsiteY1" fmla="*/ 19643 h 452687"/>
                <a:gd name="connsiteX2" fmla="*/ 158820 w 477919"/>
                <a:gd name="connsiteY2" fmla="*/ 302492 h 452687"/>
                <a:gd name="connsiteX3" fmla="*/ 477919 w 477919"/>
                <a:gd name="connsiteY3" fmla="*/ 302492 h 452687"/>
                <a:gd name="connsiteX4" fmla="*/ 477919 w 477919"/>
                <a:gd name="connsiteY4" fmla="*/ 452687 h 452687"/>
                <a:gd name="connsiteX5" fmla="*/ 0 w 477919"/>
                <a:gd name="connsiteY5" fmla="*/ 452687 h 452687"/>
                <a:gd name="connsiteX6" fmla="*/ 43253 w 477919"/>
                <a:gd name="connsiteY6" fmla="*/ 3356 h 452687"/>
                <a:gd name="connsiteX0" fmla="*/ 43253 w 477919"/>
                <a:gd name="connsiteY0" fmla="*/ 3356 h 452687"/>
                <a:gd name="connsiteX1" fmla="*/ 111658 w 477919"/>
                <a:gd name="connsiteY1" fmla="*/ 19643 h 452687"/>
                <a:gd name="connsiteX2" fmla="*/ 158820 w 477919"/>
                <a:gd name="connsiteY2" fmla="*/ 302492 h 452687"/>
                <a:gd name="connsiteX3" fmla="*/ 450599 w 477919"/>
                <a:gd name="connsiteY3" fmla="*/ 314488 h 452687"/>
                <a:gd name="connsiteX4" fmla="*/ 477919 w 477919"/>
                <a:gd name="connsiteY4" fmla="*/ 452687 h 452687"/>
                <a:gd name="connsiteX5" fmla="*/ 0 w 477919"/>
                <a:gd name="connsiteY5" fmla="*/ 452687 h 452687"/>
                <a:gd name="connsiteX6" fmla="*/ 43253 w 477919"/>
                <a:gd name="connsiteY6" fmla="*/ 3356 h 452687"/>
                <a:gd name="connsiteX0" fmla="*/ 43253 w 482096"/>
                <a:gd name="connsiteY0" fmla="*/ 3356 h 452687"/>
                <a:gd name="connsiteX1" fmla="*/ 111658 w 482096"/>
                <a:gd name="connsiteY1" fmla="*/ 19643 h 452687"/>
                <a:gd name="connsiteX2" fmla="*/ 158820 w 482096"/>
                <a:gd name="connsiteY2" fmla="*/ 302492 h 452687"/>
                <a:gd name="connsiteX3" fmla="*/ 450599 w 482096"/>
                <a:gd name="connsiteY3" fmla="*/ 314488 h 452687"/>
                <a:gd name="connsiteX4" fmla="*/ 477919 w 482096"/>
                <a:gd name="connsiteY4" fmla="*/ 452687 h 452687"/>
                <a:gd name="connsiteX5" fmla="*/ 0 w 482096"/>
                <a:gd name="connsiteY5" fmla="*/ 452687 h 452687"/>
                <a:gd name="connsiteX6" fmla="*/ 43253 w 482096"/>
                <a:gd name="connsiteY6" fmla="*/ 3356 h 452687"/>
                <a:gd name="connsiteX0" fmla="*/ 43253 w 473854"/>
                <a:gd name="connsiteY0" fmla="*/ 3356 h 452687"/>
                <a:gd name="connsiteX1" fmla="*/ 111658 w 473854"/>
                <a:gd name="connsiteY1" fmla="*/ 19643 h 452687"/>
                <a:gd name="connsiteX2" fmla="*/ 158820 w 473854"/>
                <a:gd name="connsiteY2" fmla="*/ 302492 h 452687"/>
                <a:gd name="connsiteX3" fmla="*/ 450599 w 473854"/>
                <a:gd name="connsiteY3" fmla="*/ 314488 h 452687"/>
                <a:gd name="connsiteX4" fmla="*/ 451537 w 473854"/>
                <a:gd name="connsiteY4" fmla="*/ 432308 h 452687"/>
                <a:gd name="connsiteX5" fmla="*/ 0 w 473854"/>
                <a:gd name="connsiteY5" fmla="*/ 452687 h 452687"/>
                <a:gd name="connsiteX6" fmla="*/ 43253 w 473854"/>
                <a:gd name="connsiteY6" fmla="*/ 3356 h 452687"/>
                <a:gd name="connsiteX0" fmla="*/ 43253 w 485386"/>
                <a:gd name="connsiteY0" fmla="*/ 3356 h 452687"/>
                <a:gd name="connsiteX1" fmla="*/ 111658 w 485386"/>
                <a:gd name="connsiteY1" fmla="*/ 19643 h 452687"/>
                <a:gd name="connsiteX2" fmla="*/ 158820 w 485386"/>
                <a:gd name="connsiteY2" fmla="*/ 302492 h 452687"/>
                <a:gd name="connsiteX3" fmla="*/ 450599 w 485386"/>
                <a:gd name="connsiteY3" fmla="*/ 314488 h 452687"/>
                <a:gd name="connsiteX4" fmla="*/ 451537 w 485386"/>
                <a:gd name="connsiteY4" fmla="*/ 432308 h 452687"/>
                <a:gd name="connsiteX5" fmla="*/ 0 w 485386"/>
                <a:gd name="connsiteY5" fmla="*/ 452687 h 452687"/>
                <a:gd name="connsiteX6" fmla="*/ 43253 w 485386"/>
                <a:gd name="connsiteY6" fmla="*/ 3356 h 452687"/>
                <a:gd name="connsiteX0" fmla="*/ 43253 w 484502"/>
                <a:gd name="connsiteY0" fmla="*/ 3356 h 452687"/>
                <a:gd name="connsiteX1" fmla="*/ 111658 w 484502"/>
                <a:gd name="connsiteY1" fmla="*/ 19643 h 452687"/>
                <a:gd name="connsiteX2" fmla="*/ 158820 w 484502"/>
                <a:gd name="connsiteY2" fmla="*/ 302492 h 452687"/>
                <a:gd name="connsiteX3" fmla="*/ 450599 w 484502"/>
                <a:gd name="connsiteY3" fmla="*/ 314488 h 452687"/>
                <a:gd name="connsiteX4" fmla="*/ 449394 w 484502"/>
                <a:gd name="connsiteY4" fmla="*/ 415606 h 452687"/>
                <a:gd name="connsiteX5" fmla="*/ 0 w 484502"/>
                <a:gd name="connsiteY5" fmla="*/ 452687 h 452687"/>
                <a:gd name="connsiteX6" fmla="*/ 43253 w 484502"/>
                <a:gd name="connsiteY6" fmla="*/ 3356 h 452687"/>
                <a:gd name="connsiteX0" fmla="*/ 43253 w 489855"/>
                <a:gd name="connsiteY0" fmla="*/ 3356 h 452687"/>
                <a:gd name="connsiteX1" fmla="*/ 111658 w 489855"/>
                <a:gd name="connsiteY1" fmla="*/ 19643 h 452687"/>
                <a:gd name="connsiteX2" fmla="*/ 158820 w 489855"/>
                <a:gd name="connsiteY2" fmla="*/ 302492 h 452687"/>
                <a:gd name="connsiteX3" fmla="*/ 450599 w 489855"/>
                <a:gd name="connsiteY3" fmla="*/ 314488 h 452687"/>
                <a:gd name="connsiteX4" fmla="*/ 449394 w 489855"/>
                <a:gd name="connsiteY4" fmla="*/ 415606 h 452687"/>
                <a:gd name="connsiteX5" fmla="*/ 0 w 489855"/>
                <a:gd name="connsiteY5" fmla="*/ 452687 h 452687"/>
                <a:gd name="connsiteX6" fmla="*/ 43253 w 489855"/>
                <a:gd name="connsiteY6" fmla="*/ 3356 h 45268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89855" h="452687">
                  <a:moveTo>
                    <a:pt x="43253" y="3356"/>
                  </a:moveTo>
                  <a:cubicBezTo>
                    <a:pt x="73676" y="-2378"/>
                    <a:pt x="64015" y="-2968"/>
                    <a:pt x="111658" y="19643"/>
                  </a:cubicBezTo>
                  <a:cubicBezTo>
                    <a:pt x="135112" y="94825"/>
                    <a:pt x="146154" y="205553"/>
                    <a:pt x="158820" y="302492"/>
                  </a:cubicBezTo>
                  <a:lnTo>
                    <a:pt x="450599" y="314488"/>
                  </a:lnTo>
                  <a:cubicBezTo>
                    <a:pt x="506729" y="369796"/>
                    <a:pt x="499382" y="367045"/>
                    <a:pt x="449394" y="415606"/>
                  </a:cubicBezTo>
                  <a:lnTo>
                    <a:pt x="0" y="452687"/>
                  </a:lnTo>
                  <a:cubicBezTo>
                    <a:pt x="14418" y="302910"/>
                    <a:pt x="31552" y="28858"/>
                    <a:pt x="43253" y="3356"/>
                  </a:cubicBezTo>
                  <a:close/>
                </a:path>
              </a:pathLst>
            </a:cu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defTabSz="475945"/>
              <a:endParaRPr lang="en-GB" sz="1874">
                <a:solidFill>
                  <a:prstClr val="white"/>
                </a:solidFill>
                <a:latin typeface="Calibri" panose="020F0502020204030204"/>
              </a:endParaRPr>
            </a:p>
          </p:txBody>
        </p:sp>
        <p:sp>
          <p:nvSpPr>
            <p:cNvPr id="5" name="Rectangle: Rounded Corners 241">
              <a:extLst>
                <a:ext uri="{FF2B5EF4-FFF2-40B4-BE49-F238E27FC236}">
                  <a16:creationId xmlns:a16="http://schemas.microsoft.com/office/drawing/2014/main" id="{0FEB3C1F-4A67-4822-A3EC-4253396BA041}"/>
                </a:ext>
              </a:extLst>
            </p:cNvPr>
            <p:cNvSpPr/>
            <p:nvPr/>
          </p:nvSpPr>
          <p:spPr>
            <a:xfrm rot="36258">
              <a:off x="746452" y="3834979"/>
              <a:ext cx="90210" cy="178364"/>
            </a:xfrm>
            <a:custGeom>
              <a:avLst/>
              <a:gdLst>
                <a:gd name="connsiteX0" fmla="*/ 0 w 122899"/>
                <a:gd name="connsiteY0" fmla="*/ 20484 h 506421"/>
                <a:gd name="connsiteX1" fmla="*/ 20484 w 122899"/>
                <a:gd name="connsiteY1" fmla="*/ 0 h 506421"/>
                <a:gd name="connsiteX2" fmla="*/ 102415 w 122899"/>
                <a:gd name="connsiteY2" fmla="*/ 0 h 506421"/>
                <a:gd name="connsiteX3" fmla="*/ 122899 w 122899"/>
                <a:gd name="connsiteY3" fmla="*/ 20484 h 506421"/>
                <a:gd name="connsiteX4" fmla="*/ 122899 w 122899"/>
                <a:gd name="connsiteY4" fmla="*/ 485937 h 506421"/>
                <a:gd name="connsiteX5" fmla="*/ 102415 w 122899"/>
                <a:gd name="connsiteY5" fmla="*/ 506421 h 506421"/>
                <a:gd name="connsiteX6" fmla="*/ 20484 w 122899"/>
                <a:gd name="connsiteY6" fmla="*/ 506421 h 506421"/>
                <a:gd name="connsiteX7" fmla="*/ 0 w 122899"/>
                <a:gd name="connsiteY7" fmla="*/ 485937 h 506421"/>
                <a:gd name="connsiteX8" fmla="*/ 0 w 122899"/>
                <a:gd name="connsiteY8" fmla="*/ 20484 h 506421"/>
                <a:gd name="connsiteX0" fmla="*/ 0 w 123852"/>
                <a:gd name="connsiteY0" fmla="*/ 121507 h 506421"/>
                <a:gd name="connsiteX1" fmla="*/ 21437 w 123852"/>
                <a:gd name="connsiteY1" fmla="*/ 0 h 506421"/>
                <a:gd name="connsiteX2" fmla="*/ 103368 w 123852"/>
                <a:gd name="connsiteY2" fmla="*/ 0 h 506421"/>
                <a:gd name="connsiteX3" fmla="*/ 123852 w 123852"/>
                <a:gd name="connsiteY3" fmla="*/ 20484 h 506421"/>
                <a:gd name="connsiteX4" fmla="*/ 123852 w 123852"/>
                <a:gd name="connsiteY4" fmla="*/ 485937 h 506421"/>
                <a:gd name="connsiteX5" fmla="*/ 103368 w 123852"/>
                <a:gd name="connsiteY5" fmla="*/ 506421 h 506421"/>
                <a:gd name="connsiteX6" fmla="*/ 21437 w 123852"/>
                <a:gd name="connsiteY6" fmla="*/ 506421 h 506421"/>
                <a:gd name="connsiteX7" fmla="*/ 953 w 123852"/>
                <a:gd name="connsiteY7" fmla="*/ 485937 h 506421"/>
                <a:gd name="connsiteX8" fmla="*/ 0 w 123852"/>
                <a:gd name="connsiteY8" fmla="*/ 121507 h 506421"/>
                <a:gd name="connsiteX0" fmla="*/ 0 w 123852"/>
                <a:gd name="connsiteY0" fmla="*/ 121507 h 506421"/>
                <a:gd name="connsiteX1" fmla="*/ 21437 w 123852"/>
                <a:gd name="connsiteY1" fmla="*/ 0 h 506421"/>
                <a:gd name="connsiteX2" fmla="*/ 65754 w 123852"/>
                <a:gd name="connsiteY2" fmla="*/ 60265 h 506421"/>
                <a:gd name="connsiteX3" fmla="*/ 123852 w 123852"/>
                <a:gd name="connsiteY3" fmla="*/ 20484 h 506421"/>
                <a:gd name="connsiteX4" fmla="*/ 123852 w 123852"/>
                <a:gd name="connsiteY4" fmla="*/ 485937 h 506421"/>
                <a:gd name="connsiteX5" fmla="*/ 103368 w 123852"/>
                <a:gd name="connsiteY5" fmla="*/ 506421 h 506421"/>
                <a:gd name="connsiteX6" fmla="*/ 21437 w 123852"/>
                <a:gd name="connsiteY6" fmla="*/ 506421 h 506421"/>
                <a:gd name="connsiteX7" fmla="*/ 953 w 123852"/>
                <a:gd name="connsiteY7" fmla="*/ 485937 h 506421"/>
                <a:gd name="connsiteX8" fmla="*/ 0 w 123852"/>
                <a:gd name="connsiteY8" fmla="*/ 121507 h 506421"/>
                <a:gd name="connsiteX0" fmla="*/ 0 w 124478"/>
                <a:gd name="connsiteY0" fmla="*/ 121507 h 506421"/>
                <a:gd name="connsiteX1" fmla="*/ 21437 w 124478"/>
                <a:gd name="connsiteY1" fmla="*/ 0 h 506421"/>
                <a:gd name="connsiteX2" fmla="*/ 65754 w 124478"/>
                <a:gd name="connsiteY2" fmla="*/ 60265 h 506421"/>
                <a:gd name="connsiteX3" fmla="*/ 124478 w 124478"/>
                <a:gd name="connsiteY3" fmla="*/ 61240 h 506421"/>
                <a:gd name="connsiteX4" fmla="*/ 123852 w 124478"/>
                <a:gd name="connsiteY4" fmla="*/ 485937 h 506421"/>
                <a:gd name="connsiteX5" fmla="*/ 103368 w 124478"/>
                <a:gd name="connsiteY5" fmla="*/ 506421 h 506421"/>
                <a:gd name="connsiteX6" fmla="*/ 21437 w 124478"/>
                <a:gd name="connsiteY6" fmla="*/ 506421 h 506421"/>
                <a:gd name="connsiteX7" fmla="*/ 953 w 124478"/>
                <a:gd name="connsiteY7" fmla="*/ 485937 h 506421"/>
                <a:gd name="connsiteX8" fmla="*/ 0 w 124478"/>
                <a:gd name="connsiteY8" fmla="*/ 121507 h 506421"/>
                <a:gd name="connsiteX0" fmla="*/ 0 w 124478"/>
                <a:gd name="connsiteY0" fmla="*/ 121507 h 506421"/>
                <a:gd name="connsiteX1" fmla="*/ 21437 w 124478"/>
                <a:gd name="connsiteY1" fmla="*/ 0 h 506421"/>
                <a:gd name="connsiteX2" fmla="*/ 65754 w 124478"/>
                <a:gd name="connsiteY2" fmla="*/ 60265 h 506421"/>
                <a:gd name="connsiteX3" fmla="*/ 124478 w 124478"/>
                <a:gd name="connsiteY3" fmla="*/ 61240 h 506421"/>
                <a:gd name="connsiteX4" fmla="*/ 123852 w 124478"/>
                <a:gd name="connsiteY4" fmla="*/ 485937 h 506421"/>
                <a:gd name="connsiteX5" fmla="*/ 103368 w 124478"/>
                <a:gd name="connsiteY5" fmla="*/ 506421 h 506421"/>
                <a:gd name="connsiteX6" fmla="*/ 21437 w 124478"/>
                <a:gd name="connsiteY6" fmla="*/ 506421 h 506421"/>
                <a:gd name="connsiteX7" fmla="*/ 953 w 124478"/>
                <a:gd name="connsiteY7" fmla="*/ 485937 h 506421"/>
                <a:gd name="connsiteX8" fmla="*/ 0 w 124478"/>
                <a:gd name="connsiteY8" fmla="*/ 121507 h 506421"/>
                <a:gd name="connsiteX0" fmla="*/ 0 w 123853"/>
                <a:gd name="connsiteY0" fmla="*/ 121507 h 506421"/>
                <a:gd name="connsiteX1" fmla="*/ 21437 w 123853"/>
                <a:gd name="connsiteY1" fmla="*/ 0 h 506421"/>
                <a:gd name="connsiteX2" fmla="*/ 65754 w 123853"/>
                <a:gd name="connsiteY2" fmla="*/ 60265 h 506421"/>
                <a:gd name="connsiteX3" fmla="*/ 113458 w 123853"/>
                <a:gd name="connsiteY3" fmla="*/ 122766 h 506421"/>
                <a:gd name="connsiteX4" fmla="*/ 123852 w 123853"/>
                <a:gd name="connsiteY4" fmla="*/ 485937 h 506421"/>
                <a:gd name="connsiteX5" fmla="*/ 103368 w 123853"/>
                <a:gd name="connsiteY5" fmla="*/ 506421 h 506421"/>
                <a:gd name="connsiteX6" fmla="*/ 21437 w 123853"/>
                <a:gd name="connsiteY6" fmla="*/ 506421 h 506421"/>
                <a:gd name="connsiteX7" fmla="*/ 953 w 123853"/>
                <a:gd name="connsiteY7" fmla="*/ 485937 h 506421"/>
                <a:gd name="connsiteX8" fmla="*/ 0 w 123853"/>
                <a:gd name="connsiteY8" fmla="*/ 121507 h 506421"/>
                <a:gd name="connsiteX0" fmla="*/ 30672 w 122900"/>
                <a:gd name="connsiteY0" fmla="*/ 160535 h 506421"/>
                <a:gd name="connsiteX1" fmla="*/ 20484 w 122900"/>
                <a:gd name="connsiteY1" fmla="*/ 0 h 506421"/>
                <a:gd name="connsiteX2" fmla="*/ 64801 w 122900"/>
                <a:gd name="connsiteY2" fmla="*/ 60265 h 506421"/>
                <a:gd name="connsiteX3" fmla="*/ 112505 w 122900"/>
                <a:gd name="connsiteY3" fmla="*/ 122766 h 506421"/>
                <a:gd name="connsiteX4" fmla="*/ 122899 w 122900"/>
                <a:gd name="connsiteY4" fmla="*/ 485937 h 506421"/>
                <a:gd name="connsiteX5" fmla="*/ 102415 w 122900"/>
                <a:gd name="connsiteY5" fmla="*/ 506421 h 506421"/>
                <a:gd name="connsiteX6" fmla="*/ 20484 w 122900"/>
                <a:gd name="connsiteY6" fmla="*/ 506421 h 506421"/>
                <a:gd name="connsiteX7" fmla="*/ 0 w 122900"/>
                <a:gd name="connsiteY7" fmla="*/ 485937 h 506421"/>
                <a:gd name="connsiteX8" fmla="*/ 30672 w 122900"/>
                <a:gd name="connsiteY8" fmla="*/ 160535 h 506421"/>
                <a:gd name="connsiteX0" fmla="*/ 89447 w 181675"/>
                <a:gd name="connsiteY0" fmla="*/ 135679 h 481565"/>
                <a:gd name="connsiteX1" fmla="*/ 893 w 181675"/>
                <a:gd name="connsiteY1" fmla="*/ 0 h 481565"/>
                <a:gd name="connsiteX2" fmla="*/ 123576 w 181675"/>
                <a:gd name="connsiteY2" fmla="*/ 35409 h 481565"/>
                <a:gd name="connsiteX3" fmla="*/ 171280 w 181675"/>
                <a:gd name="connsiteY3" fmla="*/ 97910 h 481565"/>
                <a:gd name="connsiteX4" fmla="*/ 181674 w 181675"/>
                <a:gd name="connsiteY4" fmla="*/ 461081 h 481565"/>
                <a:gd name="connsiteX5" fmla="*/ 161190 w 181675"/>
                <a:gd name="connsiteY5" fmla="*/ 481565 h 481565"/>
                <a:gd name="connsiteX6" fmla="*/ 79259 w 181675"/>
                <a:gd name="connsiteY6" fmla="*/ 481565 h 481565"/>
                <a:gd name="connsiteX7" fmla="*/ 58775 w 181675"/>
                <a:gd name="connsiteY7" fmla="*/ 461081 h 481565"/>
                <a:gd name="connsiteX8" fmla="*/ 89447 w 181675"/>
                <a:gd name="connsiteY8" fmla="*/ 135679 h 481565"/>
                <a:gd name="connsiteX0" fmla="*/ 58348 w 182045"/>
                <a:gd name="connsiteY0" fmla="*/ 115848 h 481565"/>
                <a:gd name="connsiteX1" fmla="*/ 1263 w 182045"/>
                <a:gd name="connsiteY1" fmla="*/ 0 h 481565"/>
                <a:gd name="connsiteX2" fmla="*/ 123946 w 182045"/>
                <a:gd name="connsiteY2" fmla="*/ 35409 h 481565"/>
                <a:gd name="connsiteX3" fmla="*/ 171650 w 182045"/>
                <a:gd name="connsiteY3" fmla="*/ 97910 h 481565"/>
                <a:gd name="connsiteX4" fmla="*/ 182044 w 182045"/>
                <a:gd name="connsiteY4" fmla="*/ 461081 h 481565"/>
                <a:gd name="connsiteX5" fmla="*/ 161560 w 182045"/>
                <a:gd name="connsiteY5" fmla="*/ 481565 h 481565"/>
                <a:gd name="connsiteX6" fmla="*/ 79629 w 182045"/>
                <a:gd name="connsiteY6" fmla="*/ 481565 h 481565"/>
                <a:gd name="connsiteX7" fmla="*/ 59145 w 182045"/>
                <a:gd name="connsiteY7" fmla="*/ 461081 h 481565"/>
                <a:gd name="connsiteX8" fmla="*/ 58348 w 182045"/>
                <a:gd name="connsiteY8" fmla="*/ 115848 h 481565"/>
                <a:gd name="connsiteX0" fmla="*/ 58348 w 182508"/>
                <a:gd name="connsiteY0" fmla="*/ 115848 h 481565"/>
                <a:gd name="connsiteX1" fmla="*/ 1263 w 182508"/>
                <a:gd name="connsiteY1" fmla="*/ 0 h 481565"/>
                <a:gd name="connsiteX2" fmla="*/ 123946 w 182508"/>
                <a:gd name="connsiteY2" fmla="*/ 35409 h 481565"/>
                <a:gd name="connsiteX3" fmla="*/ 182508 w 182508"/>
                <a:gd name="connsiteY3" fmla="*/ 89256 h 481565"/>
                <a:gd name="connsiteX4" fmla="*/ 182044 w 182508"/>
                <a:gd name="connsiteY4" fmla="*/ 461081 h 481565"/>
                <a:gd name="connsiteX5" fmla="*/ 161560 w 182508"/>
                <a:gd name="connsiteY5" fmla="*/ 481565 h 481565"/>
                <a:gd name="connsiteX6" fmla="*/ 79629 w 182508"/>
                <a:gd name="connsiteY6" fmla="*/ 481565 h 481565"/>
                <a:gd name="connsiteX7" fmla="*/ 59145 w 182508"/>
                <a:gd name="connsiteY7" fmla="*/ 461081 h 481565"/>
                <a:gd name="connsiteX8" fmla="*/ 58348 w 182508"/>
                <a:gd name="connsiteY8" fmla="*/ 115848 h 481565"/>
                <a:gd name="connsiteX0" fmla="*/ 58348 w 182508"/>
                <a:gd name="connsiteY0" fmla="*/ 115848 h 481565"/>
                <a:gd name="connsiteX1" fmla="*/ 1263 w 182508"/>
                <a:gd name="connsiteY1" fmla="*/ 0 h 481565"/>
                <a:gd name="connsiteX2" fmla="*/ 123946 w 182508"/>
                <a:gd name="connsiteY2" fmla="*/ 35409 h 481565"/>
                <a:gd name="connsiteX3" fmla="*/ 182508 w 182508"/>
                <a:gd name="connsiteY3" fmla="*/ 89256 h 481565"/>
                <a:gd name="connsiteX4" fmla="*/ 162386 w 182508"/>
                <a:gd name="connsiteY4" fmla="*/ 331574 h 481565"/>
                <a:gd name="connsiteX5" fmla="*/ 161560 w 182508"/>
                <a:gd name="connsiteY5" fmla="*/ 481565 h 481565"/>
                <a:gd name="connsiteX6" fmla="*/ 79629 w 182508"/>
                <a:gd name="connsiteY6" fmla="*/ 481565 h 481565"/>
                <a:gd name="connsiteX7" fmla="*/ 59145 w 182508"/>
                <a:gd name="connsiteY7" fmla="*/ 461081 h 481565"/>
                <a:gd name="connsiteX8" fmla="*/ 58348 w 182508"/>
                <a:gd name="connsiteY8" fmla="*/ 115848 h 481565"/>
                <a:gd name="connsiteX0" fmla="*/ 58348 w 182508"/>
                <a:gd name="connsiteY0" fmla="*/ 115848 h 481724"/>
                <a:gd name="connsiteX1" fmla="*/ 1263 w 182508"/>
                <a:gd name="connsiteY1" fmla="*/ 0 h 481724"/>
                <a:gd name="connsiteX2" fmla="*/ 123946 w 182508"/>
                <a:gd name="connsiteY2" fmla="*/ 35409 h 481724"/>
                <a:gd name="connsiteX3" fmla="*/ 182508 w 182508"/>
                <a:gd name="connsiteY3" fmla="*/ 89256 h 481724"/>
                <a:gd name="connsiteX4" fmla="*/ 162386 w 182508"/>
                <a:gd name="connsiteY4" fmla="*/ 331574 h 481724"/>
                <a:gd name="connsiteX5" fmla="*/ 178397 w 182508"/>
                <a:gd name="connsiteY5" fmla="*/ 481724 h 481724"/>
                <a:gd name="connsiteX6" fmla="*/ 79629 w 182508"/>
                <a:gd name="connsiteY6" fmla="*/ 481565 h 481724"/>
                <a:gd name="connsiteX7" fmla="*/ 59145 w 182508"/>
                <a:gd name="connsiteY7" fmla="*/ 461081 h 481724"/>
                <a:gd name="connsiteX8" fmla="*/ 58348 w 182508"/>
                <a:gd name="connsiteY8" fmla="*/ 115848 h 481724"/>
                <a:gd name="connsiteX0" fmla="*/ 58348 w 182508"/>
                <a:gd name="connsiteY0" fmla="*/ 115848 h 481724"/>
                <a:gd name="connsiteX1" fmla="*/ 1263 w 182508"/>
                <a:gd name="connsiteY1" fmla="*/ 0 h 481724"/>
                <a:gd name="connsiteX2" fmla="*/ 123946 w 182508"/>
                <a:gd name="connsiteY2" fmla="*/ 35409 h 481724"/>
                <a:gd name="connsiteX3" fmla="*/ 182508 w 182508"/>
                <a:gd name="connsiteY3" fmla="*/ 89256 h 481724"/>
                <a:gd name="connsiteX4" fmla="*/ 160813 w 182508"/>
                <a:gd name="connsiteY4" fmla="*/ 319771 h 481724"/>
                <a:gd name="connsiteX5" fmla="*/ 178397 w 182508"/>
                <a:gd name="connsiteY5" fmla="*/ 481724 h 481724"/>
                <a:gd name="connsiteX6" fmla="*/ 79629 w 182508"/>
                <a:gd name="connsiteY6" fmla="*/ 481565 h 481724"/>
                <a:gd name="connsiteX7" fmla="*/ 59145 w 182508"/>
                <a:gd name="connsiteY7" fmla="*/ 461081 h 481724"/>
                <a:gd name="connsiteX8" fmla="*/ 58348 w 182508"/>
                <a:gd name="connsiteY8" fmla="*/ 115848 h 481724"/>
                <a:gd name="connsiteX0" fmla="*/ 58348 w 182508"/>
                <a:gd name="connsiteY0" fmla="*/ 115848 h 481724"/>
                <a:gd name="connsiteX1" fmla="*/ 1263 w 182508"/>
                <a:gd name="connsiteY1" fmla="*/ 0 h 481724"/>
                <a:gd name="connsiteX2" fmla="*/ 123946 w 182508"/>
                <a:gd name="connsiteY2" fmla="*/ 35409 h 481724"/>
                <a:gd name="connsiteX3" fmla="*/ 182508 w 182508"/>
                <a:gd name="connsiteY3" fmla="*/ 89256 h 481724"/>
                <a:gd name="connsiteX4" fmla="*/ 160813 w 182508"/>
                <a:gd name="connsiteY4" fmla="*/ 319771 h 481724"/>
                <a:gd name="connsiteX5" fmla="*/ 178397 w 182508"/>
                <a:gd name="connsiteY5" fmla="*/ 481724 h 481724"/>
                <a:gd name="connsiteX6" fmla="*/ 79629 w 182508"/>
                <a:gd name="connsiteY6" fmla="*/ 481565 h 481724"/>
                <a:gd name="connsiteX7" fmla="*/ 59145 w 182508"/>
                <a:gd name="connsiteY7" fmla="*/ 461081 h 481724"/>
                <a:gd name="connsiteX8" fmla="*/ 58348 w 182508"/>
                <a:gd name="connsiteY8" fmla="*/ 115848 h 481724"/>
                <a:gd name="connsiteX0" fmla="*/ 58348 w 213825"/>
                <a:gd name="connsiteY0" fmla="*/ 115848 h 481724"/>
                <a:gd name="connsiteX1" fmla="*/ 1263 w 213825"/>
                <a:gd name="connsiteY1" fmla="*/ 0 h 481724"/>
                <a:gd name="connsiteX2" fmla="*/ 123946 w 213825"/>
                <a:gd name="connsiteY2" fmla="*/ 35409 h 481724"/>
                <a:gd name="connsiteX3" fmla="*/ 213825 w 213825"/>
                <a:gd name="connsiteY3" fmla="*/ 53854 h 481724"/>
                <a:gd name="connsiteX4" fmla="*/ 160813 w 213825"/>
                <a:gd name="connsiteY4" fmla="*/ 319771 h 481724"/>
                <a:gd name="connsiteX5" fmla="*/ 178397 w 213825"/>
                <a:gd name="connsiteY5" fmla="*/ 481724 h 481724"/>
                <a:gd name="connsiteX6" fmla="*/ 79629 w 213825"/>
                <a:gd name="connsiteY6" fmla="*/ 481565 h 481724"/>
                <a:gd name="connsiteX7" fmla="*/ 59145 w 213825"/>
                <a:gd name="connsiteY7" fmla="*/ 461081 h 481724"/>
                <a:gd name="connsiteX8" fmla="*/ 58348 w 213825"/>
                <a:gd name="connsiteY8" fmla="*/ 115848 h 481724"/>
                <a:gd name="connsiteX0" fmla="*/ 58348 w 238216"/>
                <a:gd name="connsiteY0" fmla="*/ 115848 h 481724"/>
                <a:gd name="connsiteX1" fmla="*/ 1263 w 238216"/>
                <a:gd name="connsiteY1" fmla="*/ 0 h 481724"/>
                <a:gd name="connsiteX2" fmla="*/ 123946 w 238216"/>
                <a:gd name="connsiteY2" fmla="*/ 35409 h 481724"/>
                <a:gd name="connsiteX3" fmla="*/ 238216 w 238216"/>
                <a:gd name="connsiteY3" fmla="*/ 38593 h 481724"/>
                <a:gd name="connsiteX4" fmla="*/ 160813 w 238216"/>
                <a:gd name="connsiteY4" fmla="*/ 319771 h 481724"/>
                <a:gd name="connsiteX5" fmla="*/ 178397 w 238216"/>
                <a:gd name="connsiteY5" fmla="*/ 481724 h 481724"/>
                <a:gd name="connsiteX6" fmla="*/ 79629 w 238216"/>
                <a:gd name="connsiteY6" fmla="*/ 481565 h 481724"/>
                <a:gd name="connsiteX7" fmla="*/ 59145 w 238216"/>
                <a:gd name="connsiteY7" fmla="*/ 461081 h 481724"/>
                <a:gd name="connsiteX8" fmla="*/ 58348 w 238216"/>
                <a:gd name="connsiteY8" fmla="*/ 115848 h 481724"/>
                <a:gd name="connsiteX0" fmla="*/ 58348 w 238216"/>
                <a:gd name="connsiteY0" fmla="*/ 115848 h 481724"/>
                <a:gd name="connsiteX1" fmla="*/ 1263 w 238216"/>
                <a:gd name="connsiteY1" fmla="*/ 0 h 481724"/>
                <a:gd name="connsiteX2" fmla="*/ 123946 w 238216"/>
                <a:gd name="connsiteY2" fmla="*/ 35409 h 481724"/>
                <a:gd name="connsiteX3" fmla="*/ 238216 w 238216"/>
                <a:gd name="connsiteY3" fmla="*/ 38593 h 481724"/>
                <a:gd name="connsiteX4" fmla="*/ 180014 w 238216"/>
                <a:gd name="connsiteY4" fmla="*/ 283580 h 481724"/>
                <a:gd name="connsiteX5" fmla="*/ 178397 w 238216"/>
                <a:gd name="connsiteY5" fmla="*/ 481724 h 481724"/>
                <a:gd name="connsiteX6" fmla="*/ 79629 w 238216"/>
                <a:gd name="connsiteY6" fmla="*/ 481565 h 481724"/>
                <a:gd name="connsiteX7" fmla="*/ 59145 w 238216"/>
                <a:gd name="connsiteY7" fmla="*/ 461081 h 481724"/>
                <a:gd name="connsiteX8" fmla="*/ 58348 w 238216"/>
                <a:gd name="connsiteY8" fmla="*/ 115848 h 481724"/>
                <a:gd name="connsiteX0" fmla="*/ 58348 w 238216"/>
                <a:gd name="connsiteY0" fmla="*/ 115848 h 482357"/>
                <a:gd name="connsiteX1" fmla="*/ 1263 w 238216"/>
                <a:gd name="connsiteY1" fmla="*/ 0 h 482357"/>
                <a:gd name="connsiteX2" fmla="*/ 123946 w 238216"/>
                <a:gd name="connsiteY2" fmla="*/ 35409 h 482357"/>
                <a:gd name="connsiteX3" fmla="*/ 238216 w 238216"/>
                <a:gd name="connsiteY3" fmla="*/ 38593 h 482357"/>
                <a:gd name="connsiteX4" fmla="*/ 180014 w 238216"/>
                <a:gd name="connsiteY4" fmla="*/ 283580 h 482357"/>
                <a:gd name="connsiteX5" fmla="*/ 209712 w 238216"/>
                <a:gd name="connsiteY5" fmla="*/ 482357 h 482357"/>
                <a:gd name="connsiteX6" fmla="*/ 79629 w 238216"/>
                <a:gd name="connsiteY6" fmla="*/ 481565 h 482357"/>
                <a:gd name="connsiteX7" fmla="*/ 59145 w 238216"/>
                <a:gd name="connsiteY7" fmla="*/ 461081 h 482357"/>
                <a:gd name="connsiteX8" fmla="*/ 58348 w 238216"/>
                <a:gd name="connsiteY8" fmla="*/ 115848 h 482357"/>
                <a:gd name="connsiteX0" fmla="*/ 58348 w 238216"/>
                <a:gd name="connsiteY0" fmla="*/ 115848 h 482357"/>
                <a:gd name="connsiteX1" fmla="*/ 1263 w 238216"/>
                <a:gd name="connsiteY1" fmla="*/ 0 h 482357"/>
                <a:gd name="connsiteX2" fmla="*/ 123946 w 238216"/>
                <a:gd name="connsiteY2" fmla="*/ 35409 h 482357"/>
                <a:gd name="connsiteX3" fmla="*/ 238216 w 238216"/>
                <a:gd name="connsiteY3" fmla="*/ 38593 h 482357"/>
                <a:gd name="connsiteX4" fmla="*/ 200788 w 238216"/>
                <a:gd name="connsiteY4" fmla="*/ 259191 h 482357"/>
                <a:gd name="connsiteX5" fmla="*/ 209712 w 238216"/>
                <a:gd name="connsiteY5" fmla="*/ 482357 h 482357"/>
                <a:gd name="connsiteX6" fmla="*/ 79629 w 238216"/>
                <a:gd name="connsiteY6" fmla="*/ 481565 h 482357"/>
                <a:gd name="connsiteX7" fmla="*/ 59145 w 238216"/>
                <a:gd name="connsiteY7" fmla="*/ 461081 h 482357"/>
                <a:gd name="connsiteX8" fmla="*/ 58348 w 238216"/>
                <a:gd name="connsiteY8" fmla="*/ 115848 h 48235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8216" h="482357">
                  <a:moveTo>
                    <a:pt x="58348" y="115848"/>
                  </a:moveTo>
                  <a:cubicBezTo>
                    <a:pt x="58348" y="104535"/>
                    <a:pt x="-10050" y="0"/>
                    <a:pt x="1263" y="0"/>
                  </a:cubicBezTo>
                  <a:lnTo>
                    <a:pt x="123946" y="35409"/>
                  </a:lnTo>
                  <a:cubicBezTo>
                    <a:pt x="135259" y="35409"/>
                    <a:pt x="238216" y="27280"/>
                    <a:pt x="238216" y="38593"/>
                  </a:cubicBezTo>
                  <a:cubicBezTo>
                    <a:pt x="221646" y="129488"/>
                    <a:pt x="212328" y="94495"/>
                    <a:pt x="200788" y="259191"/>
                  </a:cubicBezTo>
                  <a:cubicBezTo>
                    <a:pt x="200788" y="270504"/>
                    <a:pt x="221025" y="482357"/>
                    <a:pt x="209712" y="482357"/>
                  </a:cubicBezTo>
                  <a:lnTo>
                    <a:pt x="79629" y="481565"/>
                  </a:lnTo>
                  <a:cubicBezTo>
                    <a:pt x="68316" y="481565"/>
                    <a:pt x="59145" y="472394"/>
                    <a:pt x="59145" y="461081"/>
                  </a:cubicBezTo>
                  <a:cubicBezTo>
                    <a:pt x="59145" y="305930"/>
                    <a:pt x="58348" y="270999"/>
                    <a:pt x="58348" y="115848"/>
                  </a:cubicBezTo>
                  <a:close/>
                </a:path>
              </a:pathLst>
            </a:custGeom>
            <a:solidFill>
              <a:srgbClr val="7030A0"/>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defTabSz="475945"/>
              <a:endParaRPr lang="en-GB" sz="1874">
                <a:solidFill>
                  <a:prstClr val="white"/>
                </a:solidFill>
                <a:latin typeface="Calibri" panose="020F0502020204030204"/>
              </a:endParaRPr>
            </a:p>
          </p:txBody>
        </p:sp>
      </p:grpSp>
      <p:grpSp>
        <p:nvGrpSpPr>
          <p:cNvPr id="6" name="Group 228">
            <a:extLst>
              <a:ext uri="{FF2B5EF4-FFF2-40B4-BE49-F238E27FC236}">
                <a16:creationId xmlns:a16="http://schemas.microsoft.com/office/drawing/2014/main" id="{CF33CAFE-4CB2-41E9-AB60-0347380F9C65}"/>
              </a:ext>
            </a:extLst>
          </p:cNvPr>
          <p:cNvGrpSpPr/>
          <p:nvPr/>
        </p:nvGrpSpPr>
        <p:grpSpPr>
          <a:xfrm>
            <a:off x="2507255" y="2292691"/>
            <a:ext cx="466380" cy="815250"/>
            <a:chOff x="706190" y="3691479"/>
            <a:chExt cx="185503" cy="321864"/>
          </a:xfrm>
          <a:effectLst>
            <a:glow rad="139700">
              <a:schemeClr val="accent1">
                <a:satMod val="175000"/>
                <a:alpha val="40000"/>
              </a:schemeClr>
            </a:glow>
          </a:effectLst>
        </p:grpSpPr>
        <p:sp>
          <p:nvSpPr>
            <p:cNvPr id="7" name="L-Shape 240">
              <a:extLst>
                <a:ext uri="{FF2B5EF4-FFF2-40B4-BE49-F238E27FC236}">
                  <a16:creationId xmlns:a16="http://schemas.microsoft.com/office/drawing/2014/main" id="{DF1B6FB2-49FE-42A7-A710-86A08DF57BEE}"/>
                </a:ext>
              </a:extLst>
            </p:cNvPr>
            <p:cNvSpPr/>
            <p:nvPr/>
          </p:nvSpPr>
          <p:spPr>
            <a:xfrm rot="18919872">
              <a:off x="706190" y="3691479"/>
              <a:ext cx="185503" cy="167393"/>
            </a:xfrm>
            <a:custGeom>
              <a:avLst/>
              <a:gdLst>
                <a:gd name="connsiteX0" fmla="*/ 0 w 477919"/>
                <a:gd name="connsiteY0" fmla="*/ 0 h 455660"/>
                <a:gd name="connsiteX1" fmla="*/ 158820 w 477919"/>
                <a:gd name="connsiteY1" fmla="*/ 0 h 455660"/>
                <a:gd name="connsiteX2" fmla="*/ 158820 w 477919"/>
                <a:gd name="connsiteY2" fmla="*/ 305465 h 455660"/>
                <a:gd name="connsiteX3" fmla="*/ 477919 w 477919"/>
                <a:gd name="connsiteY3" fmla="*/ 305465 h 455660"/>
                <a:gd name="connsiteX4" fmla="*/ 477919 w 477919"/>
                <a:gd name="connsiteY4" fmla="*/ 455660 h 455660"/>
                <a:gd name="connsiteX5" fmla="*/ 0 w 477919"/>
                <a:gd name="connsiteY5" fmla="*/ 455660 h 455660"/>
                <a:gd name="connsiteX6" fmla="*/ 0 w 477919"/>
                <a:gd name="connsiteY6" fmla="*/ 0 h 455660"/>
                <a:gd name="connsiteX0" fmla="*/ 0 w 477919"/>
                <a:gd name="connsiteY0" fmla="*/ 8993 h 464653"/>
                <a:gd name="connsiteX1" fmla="*/ 133065 w 477919"/>
                <a:gd name="connsiteY1" fmla="*/ 0 h 464653"/>
                <a:gd name="connsiteX2" fmla="*/ 158820 w 477919"/>
                <a:gd name="connsiteY2" fmla="*/ 314458 h 464653"/>
                <a:gd name="connsiteX3" fmla="*/ 477919 w 477919"/>
                <a:gd name="connsiteY3" fmla="*/ 314458 h 464653"/>
                <a:gd name="connsiteX4" fmla="*/ 477919 w 477919"/>
                <a:gd name="connsiteY4" fmla="*/ 464653 h 464653"/>
                <a:gd name="connsiteX5" fmla="*/ 0 w 477919"/>
                <a:gd name="connsiteY5" fmla="*/ 464653 h 464653"/>
                <a:gd name="connsiteX6" fmla="*/ 0 w 477919"/>
                <a:gd name="connsiteY6" fmla="*/ 8993 h 464653"/>
                <a:gd name="connsiteX0" fmla="*/ 0 w 477919"/>
                <a:gd name="connsiteY0" fmla="*/ 0 h 455660"/>
                <a:gd name="connsiteX1" fmla="*/ 120821 w 477919"/>
                <a:gd name="connsiteY1" fmla="*/ 14649 h 455660"/>
                <a:gd name="connsiteX2" fmla="*/ 158820 w 477919"/>
                <a:gd name="connsiteY2" fmla="*/ 305465 h 455660"/>
                <a:gd name="connsiteX3" fmla="*/ 477919 w 477919"/>
                <a:gd name="connsiteY3" fmla="*/ 305465 h 455660"/>
                <a:gd name="connsiteX4" fmla="*/ 477919 w 477919"/>
                <a:gd name="connsiteY4" fmla="*/ 455660 h 455660"/>
                <a:gd name="connsiteX5" fmla="*/ 0 w 477919"/>
                <a:gd name="connsiteY5" fmla="*/ 455660 h 455660"/>
                <a:gd name="connsiteX6" fmla="*/ 0 w 477919"/>
                <a:gd name="connsiteY6" fmla="*/ 0 h 455660"/>
                <a:gd name="connsiteX0" fmla="*/ 0 w 477919"/>
                <a:gd name="connsiteY0" fmla="*/ 0 h 455660"/>
                <a:gd name="connsiteX1" fmla="*/ 120821 w 477919"/>
                <a:gd name="connsiteY1" fmla="*/ 14649 h 455660"/>
                <a:gd name="connsiteX2" fmla="*/ 158820 w 477919"/>
                <a:gd name="connsiteY2" fmla="*/ 305465 h 455660"/>
                <a:gd name="connsiteX3" fmla="*/ 477919 w 477919"/>
                <a:gd name="connsiteY3" fmla="*/ 305465 h 455660"/>
                <a:gd name="connsiteX4" fmla="*/ 477919 w 477919"/>
                <a:gd name="connsiteY4" fmla="*/ 455660 h 455660"/>
                <a:gd name="connsiteX5" fmla="*/ 0 w 477919"/>
                <a:gd name="connsiteY5" fmla="*/ 455660 h 455660"/>
                <a:gd name="connsiteX6" fmla="*/ 0 w 477919"/>
                <a:gd name="connsiteY6" fmla="*/ 0 h 455660"/>
                <a:gd name="connsiteX0" fmla="*/ 0 w 477919"/>
                <a:gd name="connsiteY0" fmla="*/ 0 h 455660"/>
                <a:gd name="connsiteX1" fmla="*/ 120821 w 477919"/>
                <a:gd name="connsiteY1" fmla="*/ 14649 h 455660"/>
                <a:gd name="connsiteX2" fmla="*/ 158820 w 477919"/>
                <a:gd name="connsiteY2" fmla="*/ 305465 h 455660"/>
                <a:gd name="connsiteX3" fmla="*/ 477919 w 477919"/>
                <a:gd name="connsiteY3" fmla="*/ 305465 h 455660"/>
                <a:gd name="connsiteX4" fmla="*/ 477919 w 477919"/>
                <a:gd name="connsiteY4" fmla="*/ 455660 h 455660"/>
                <a:gd name="connsiteX5" fmla="*/ 0 w 477919"/>
                <a:gd name="connsiteY5" fmla="*/ 455660 h 455660"/>
                <a:gd name="connsiteX6" fmla="*/ 0 w 477919"/>
                <a:gd name="connsiteY6" fmla="*/ 0 h 455660"/>
                <a:gd name="connsiteX0" fmla="*/ 0 w 477919"/>
                <a:gd name="connsiteY0" fmla="*/ 0 h 455660"/>
                <a:gd name="connsiteX1" fmla="*/ 111658 w 477919"/>
                <a:gd name="connsiteY1" fmla="*/ 22616 h 455660"/>
                <a:gd name="connsiteX2" fmla="*/ 158820 w 477919"/>
                <a:gd name="connsiteY2" fmla="*/ 305465 h 455660"/>
                <a:gd name="connsiteX3" fmla="*/ 477919 w 477919"/>
                <a:gd name="connsiteY3" fmla="*/ 305465 h 455660"/>
                <a:gd name="connsiteX4" fmla="*/ 477919 w 477919"/>
                <a:gd name="connsiteY4" fmla="*/ 455660 h 455660"/>
                <a:gd name="connsiteX5" fmla="*/ 0 w 477919"/>
                <a:gd name="connsiteY5" fmla="*/ 455660 h 455660"/>
                <a:gd name="connsiteX6" fmla="*/ 0 w 477919"/>
                <a:gd name="connsiteY6" fmla="*/ 0 h 455660"/>
                <a:gd name="connsiteX0" fmla="*/ 26552 w 477919"/>
                <a:gd name="connsiteY0" fmla="*/ 0 h 447186"/>
                <a:gd name="connsiteX1" fmla="*/ 111658 w 477919"/>
                <a:gd name="connsiteY1" fmla="*/ 14142 h 447186"/>
                <a:gd name="connsiteX2" fmla="*/ 158820 w 477919"/>
                <a:gd name="connsiteY2" fmla="*/ 296991 h 447186"/>
                <a:gd name="connsiteX3" fmla="*/ 477919 w 477919"/>
                <a:gd name="connsiteY3" fmla="*/ 296991 h 447186"/>
                <a:gd name="connsiteX4" fmla="*/ 477919 w 477919"/>
                <a:gd name="connsiteY4" fmla="*/ 447186 h 447186"/>
                <a:gd name="connsiteX5" fmla="*/ 0 w 477919"/>
                <a:gd name="connsiteY5" fmla="*/ 447186 h 447186"/>
                <a:gd name="connsiteX6" fmla="*/ 26552 w 477919"/>
                <a:gd name="connsiteY6" fmla="*/ 0 h 447186"/>
                <a:gd name="connsiteX0" fmla="*/ 43253 w 477919"/>
                <a:gd name="connsiteY0" fmla="*/ 0 h 449331"/>
                <a:gd name="connsiteX1" fmla="*/ 111658 w 477919"/>
                <a:gd name="connsiteY1" fmla="*/ 16287 h 449331"/>
                <a:gd name="connsiteX2" fmla="*/ 158820 w 477919"/>
                <a:gd name="connsiteY2" fmla="*/ 299136 h 449331"/>
                <a:gd name="connsiteX3" fmla="*/ 477919 w 477919"/>
                <a:gd name="connsiteY3" fmla="*/ 299136 h 449331"/>
                <a:gd name="connsiteX4" fmla="*/ 477919 w 477919"/>
                <a:gd name="connsiteY4" fmla="*/ 449331 h 449331"/>
                <a:gd name="connsiteX5" fmla="*/ 0 w 477919"/>
                <a:gd name="connsiteY5" fmla="*/ 449331 h 449331"/>
                <a:gd name="connsiteX6" fmla="*/ 43253 w 477919"/>
                <a:gd name="connsiteY6" fmla="*/ 0 h 449331"/>
                <a:gd name="connsiteX0" fmla="*/ 43253 w 477919"/>
                <a:gd name="connsiteY0" fmla="*/ 3356 h 452687"/>
                <a:gd name="connsiteX1" fmla="*/ 111658 w 477919"/>
                <a:gd name="connsiteY1" fmla="*/ 19643 h 452687"/>
                <a:gd name="connsiteX2" fmla="*/ 158820 w 477919"/>
                <a:gd name="connsiteY2" fmla="*/ 302492 h 452687"/>
                <a:gd name="connsiteX3" fmla="*/ 477919 w 477919"/>
                <a:gd name="connsiteY3" fmla="*/ 302492 h 452687"/>
                <a:gd name="connsiteX4" fmla="*/ 477919 w 477919"/>
                <a:gd name="connsiteY4" fmla="*/ 452687 h 452687"/>
                <a:gd name="connsiteX5" fmla="*/ 0 w 477919"/>
                <a:gd name="connsiteY5" fmla="*/ 452687 h 452687"/>
                <a:gd name="connsiteX6" fmla="*/ 43253 w 477919"/>
                <a:gd name="connsiteY6" fmla="*/ 3356 h 452687"/>
                <a:gd name="connsiteX0" fmla="*/ 43253 w 477919"/>
                <a:gd name="connsiteY0" fmla="*/ 3356 h 452687"/>
                <a:gd name="connsiteX1" fmla="*/ 111658 w 477919"/>
                <a:gd name="connsiteY1" fmla="*/ 19643 h 452687"/>
                <a:gd name="connsiteX2" fmla="*/ 158820 w 477919"/>
                <a:gd name="connsiteY2" fmla="*/ 302492 h 452687"/>
                <a:gd name="connsiteX3" fmla="*/ 477919 w 477919"/>
                <a:gd name="connsiteY3" fmla="*/ 302492 h 452687"/>
                <a:gd name="connsiteX4" fmla="*/ 477919 w 477919"/>
                <a:gd name="connsiteY4" fmla="*/ 452687 h 452687"/>
                <a:gd name="connsiteX5" fmla="*/ 0 w 477919"/>
                <a:gd name="connsiteY5" fmla="*/ 452687 h 452687"/>
                <a:gd name="connsiteX6" fmla="*/ 43253 w 477919"/>
                <a:gd name="connsiteY6" fmla="*/ 3356 h 452687"/>
                <a:gd name="connsiteX0" fmla="*/ 43253 w 477919"/>
                <a:gd name="connsiteY0" fmla="*/ 3356 h 452687"/>
                <a:gd name="connsiteX1" fmla="*/ 111658 w 477919"/>
                <a:gd name="connsiteY1" fmla="*/ 19643 h 452687"/>
                <a:gd name="connsiteX2" fmla="*/ 158820 w 477919"/>
                <a:gd name="connsiteY2" fmla="*/ 302492 h 452687"/>
                <a:gd name="connsiteX3" fmla="*/ 450599 w 477919"/>
                <a:gd name="connsiteY3" fmla="*/ 314488 h 452687"/>
                <a:gd name="connsiteX4" fmla="*/ 477919 w 477919"/>
                <a:gd name="connsiteY4" fmla="*/ 452687 h 452687"/>
                <a:gd name="connsiteX5" fmla="*/ 0 w 477919"/>
                <a:gd name="connsiteY5" fmla="*/ 452687 h 452687"/>
                <a:gd name="connsiteX6" fmla="*/ 43253 w 477919"/>
                <a:gd name="connsiteY6" fmla="*/ 3356 h 452687"/>
                <a:gd name="connsiteX0" fmla="*/ 43253 w 482096"/>
                <a:gd name="connsiteY0" fmla="*/ 3356 h 452687"/>
                <a:gd name="connsiteX1" fmla="*/ 111658 w 482096"/>
                <a:gd name="connsiteY1" fmla="*/ 19643 h 452687"/>
                <a:gd name="connsiteX2" fmla="*/ 158820 w 482096"/>
                <a:gd name="connsiteY2" fmla="*/ 302492 h 452687"/>
                <a:gd name="connsiteX3" fmla="*/ 450599 w 482096"/>
                <a:gd name="connsiteY3" fmla="*/ 314488 h 452687"/>
                <a:gd name="connsiteX4" fmla="*/ 477919 w 482096"/>
                <a:gd name="connsiteY4" fmla="*/ 452687 h 452687"/>
                <a:gd name="connsiteX5" fmla="*/ 0 w 482096"/>
                <a:gd name="connsiteY5" fmla="*/ 452687 h 452687"/>
                <a:gd name="connsiteX6" fmla="*/ 43253 w 482096"/>
                <a:gd name="connsiteY6" fmla="*/ 3356 h 452687"/>
                <a:gd name="connsiteX0" fmla="*/ 43253 w 473854"/>
                <a:gd name="connsiteY0" fmla="*/ 3356 h 452687"/>
                <a:gd name="connsiteX1" fmla="*/ 111658 w 473854"/>
                <a:gd name="connsiteY1" fmla="*/ 19643 h 452687"/>
                <a:gd name="connsiteX2" fmla="*/ 158820 w 473854"/>
                <a:gd name="connsiteY2" fmla="*/ 302492 h 452687"/>
                <a:gd name="connsiteX3" fmla="*/ 450599 w 473854"/>
                <a:gd name="connsiteY3" fmla="*/ 314488 h 452687"/>
                <a:gd name="connsiteX4" fmla="*/ 451537 w 473854"/>
                <a:gd name="connsiteY4" fmla="*/ 432308 h 452687"/>
                <a:gd name="connsiteX5" fmla="*/ 0 w 473854"/>
                <a:gd name="connsiteY5" fmla="*/ 452687 h 452687"/>
                <a:gd name="connsiteX6" fmla="*/ 43253 w 473854"/>
                <a:gd name="connsiteY6" fmla="*/ 3356 h 452687"/>
                <a:gd name="connsiteX0" fmla="*/ 43253 w 485386"/>
                <a:gd name="connsiteY0" fmla="*/ 3356 h 452687"/>
                <a:gd name="connsiteX1" fmla="*/ 111658 w 485386"/>
                <a:gd name="connsiteY1" fmla="*/ 19643 h 452687"/>
                <a:gd name="connsiteX2" fmla="*/ 158820 w 485386"/>
                <a:gd name="connsiteY2" fmla="*/ 302492 h 452687"/>
                <a:gd name="connsiteX3" fmla="*/ 450599 w 485386"/>
                <a:gd name="connsiteY3" fmla="*/ 314488 h 452687"/>
                <a:gd name="connsiteX4" fmla="*/ 451537 w 485386"/>
                <a:gd name="connsiteY4" fmla="*/ 432308 h 452687"/>
                <a:gd name="connsiteX5" fmla="*/ 0 w 485386"/>
                <a:gd name="connsiteY5" fmla="*/ 452687 h 452687"/>
                <a:gd name="connsiteX6" fmla="*/ 43253 w 485386"/>
                <a:gd name="connsiteY6" fmla="*/ 3356 h 452687"/>
                <a:gd name="connsiteX0" fmla="*/ 43253 w 484502"/>
                <a:gd name="connsiteY0" fmla="*/ 3356 h 452687"/>
                <a:gd name="connsiteX1" fmla="*/ 111658 w 484502"/>
                <a:gd name="connsiteY1" fmla="*/ 19643 h 452687"/>
                <a:gd name="connsiteX2" fmla="*/ 158820 w 484502"/>
                <a:gd name="connsiteY2" fmla="*/ 302492 h 452687"/>
                <a:gd name="connsiteX3" fmla="*/ 450599 w 484502"/>
                <a:gd name="connsiteY3" fmla="*/ 314488 h 452687"/>
                <a:gd name="connsiteX4" fmla="*/ 449394 w 484502"/>
                <a:gd name="connsiteY4" fmla="*/ 415606 h 452687"/>
                <a:gd name="connsiteX5" fmla="*/ 0 w 484502"/>
                <a:gd name="connsiteY5" fmla="*/ 452687 h 452687"/>
                <a:gd name="connsiteX6" fmla="*/ 43253 w 484502"/>
                <a:gd name="connsiteY6" fmla="*/ 3356 h 452687"/>
                <a:gd name="connsiteX0" fmla="*/ 43253 w 489855"/>
                <a:gd name="connsiteY0" fmla="*/ 3356 h 452687"/>
                <a:gd name="connsiteX1" fmla="*/ 111658 w 489855"/>
                <a:gd name="connsiteY1" fmla="*/ 19643 h 452687"/>
                <a:gd name="connsiteX2" fmla="*/ 158820 w 489855"/>
                <a:gd name="connsiteY2" fmla="*/ 302492 h 452687"/>
                <a:gd name="connsiteX3" fmla="*/ 450599 w 489855"/>
                <a:gd name="connsiteY3" fmla="*/ 314488 h 452687"/>
                <a:gd name="connsiteX4" fmla="*/ 449394 w 489855"/>
                <a:gd name="connsiteY4" fmla="*/ 415606 h 452687"/>
                <a:gd name="connsiteX5" fmla="*/ 0 w 489855"/>
                <a:gd name="connsiteY5" fmla="*/ 452687 h 452687"/>
                <a:gd name="connsiteX6" fmla="*/ 43253 w 489855"/>
                <a:gd name="connsiteY6" fmla="*/ 3356 h 45268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89855" h="452687">
                  <a:moveTo>
                    <a:pt x="43253" y="3356"/>
                  </a:moveTo>
                  <a:cubicBezTo>
                    <a:pt x="73676" y="-2378"/>
                    <a:pt x="64015" y="-2968"/>
                    <a:pt x="111658" y="19643"/>
                  </a:cubicBezTo>
                  <a:cubicBezTo>
                    <a:pt x="135112" y="94825"/>
                    <a:pt x="146154" y="205553"/>
                    <a:pt x="158820" y="302492"/>
                  </a:cubicBezTo>
                  <a:lnTo>
                    <a:pt x="450599" y="314488"/>
                  </a:lnTo>
                  <a:cubicBezTo>
                    <a:pt x="506729" y="369796"/>
                    <a:pt x="499382" y="367045"/>
                    <a:pt x="449394" y="415606"/>
                  </a:cubicBezTo>
                  <a:lnTo>
                    <a:pt x="0" y="452687"/>
                  </a:lnTo>
                  <a:cubicBezTo>
                    <a:pt x="14418" y="302910"/>
                    <a:pt x="31552" y="28858"/>
                    <a:pt x="43253" y="3356"/>
                  </a:cubicBezTo>
                  <a:close/>
                </a:path>
              </a:pathLst>
            </a:custGeom>
            <a:noFill/>
            <a:ln>
              <a:solidFill>
                <a:srgbClr val="AED8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defTabSz="475945"/>
              <a:endParaRPr lang="en-GB" sz="1874">
                <a:solidFill>
                  <a:prstClr val="white"/>
                </a:solidFill>
                <a:latin typeface="Calibri" panose="020F0502020204030204"/>
              </a:endParaRPr>
            </a:p>
          </p:txBody>
        </p:sp>
        <p:sp>
          <p:nvSpPr>
            <p:cNvPr id="8" name="Rectangle: Rounded Corners 241">
              <a:extLst>
                <a:ext uri="{FF2B5EF4-FFF2-40B4-BE49-F238E27FC236}">
                  <a16:creationId xmlns:a16="http://schemas.microsoft.com/office/drawing/2014/main" id="{0FEB3C1F-4A67-4822-A3EC-4253396BA041}"/>
                </a:ext>
              </a:extLst>
            </p:cNvPr>
            <p:cNvSpPr/>
            <p:nvPr/>
          </p:nvSpPr>
          <p:spPr>
            <a:xfrm rot="36258">
              <a:off x="746452" y="3834979"/>
              <a:ext cx="90210" cy="178364"/>
            </a:xfrm>
            <a:custGeom>
              <a:avLst/>
              <a:gdLst>
                <a:gd name="connsiteX0" fmla="*/ 0 w 122899"/>
                <a:gd name="connsiteY0" fmla="*/ 20484 h 506421"/>
                <a:gd name="connsiteX1" fmla="*/ 20484 w 122899"/>
                <a:gd name="connsiteY1" fmla="*/ 0 h 506421"/>
                <a:gd name="connsiteX2" fmla="*/ 102415 w 122899"/>
                <a:gd name="connsiteY2" fmla="*/ 0 h 506421"/>
                <a:gd name="connsiteX3" fmla="*/ 122899 w 122899"/>
                <a:gd name="connsiteY3" fmla="*/ 20484 h 506421"/>
                <a:gd name="connsiteX4" fmla="*/ 122899 w 122899"/>
                <a:gd name="connsiteY4" fmla="*/ 485937 h 506421"/>
                <a:gd name="connsiteX5" fmla="*/ 102415 w 122899"/>
                <a:gd name="connsiteY5" fmla="*/ 506421 h 506421"/>
                <a:gd name="connsiteX6" fmla="*/ 20484 w 122899"/>
                <a:gd name="connsiteY6" fmla="*/ 506421 h 506421"/>
                <a:gd name="connsiteX7" fmla="*/ 0 w 122899"/>
                <a:gd name="connsiteY7" fmla="*/ 485937 h 506421"/>
                <a:gd name="connsiteX8" fmla="*/ 0 w 122899"/>
                <a:gd name="connsiteY8" fmla="*/ 20484 h 506421"/>
                <a:gd name="connsiteX0" fmla="*/ 0 w 123852"/>
                <a:gd name="connsiteY0" fmla="*/ 121507 h 506421"/>
                <a:gd name="connsiteX1" fmla="*/ 21437 w 123852"/>
                <a:gd name="connsiteY1" fmla="*/ 0 h 506421"/>
                <a:gd name="connsiteX2" fmla="*/ 103368 w 123852"/>
                <a:gd name="connsiteY2" fmla="*/ 0 h 506421"/>
                <a:gd name="connsiteX3" fmla="*/ 123852 w 123852"/>
                <a:gd name="connsiteY3" fmla="*/ 20484 h 506421"/>
                <a:gd name="connsiteX4" fmla="*/ 123852 w 123852"/>
                <a:gd name="connsiteY4" fmla="*/ 485937 h 506421"/>
                <a:gd name="connsiteX5" fmla="*/ 103368 w 123852"/>
                <a:gd name="connsiteY5" fmla="*/ 506421 h 506421"/>
                <a:gd name="connsiteX6" fmla="*/ 21437 w 123852"/>
                <a:gd name="connsiteY6" fmla="*/ 506421 h 506421"/>
                <a:gd name="connsiteX7" fmla="*/ 953 w 123852"/>
                <a:gd name="connsiteY7" fmla="*/ 485937 h 506421"/>
                <a:gd name="connsiteX8" fmla="*/ 0 w 123852"/>
                <a:gd name="connsiteY8" fmla="*/ 121507 h 506421"/>
                <a:gd name="connsiteX0" fmla="*/ 0 w 123852"/>
                <a:gd name="connsiteY0" fmla="*/ 121507 h 506421"/>
                <a:gd name="connsiteX1" fmla="*/ 21437 w 123852"/>
                <a:gd name="connsiteY1" fmla="*/ 0 h 506421"/>
                <a:gd name="connsiteX2" fmla="*/ 65754 w 123852"/>
                <a:gd name="connsiteY2" fmla="*/ 60265 h 506421"/>
                <a:gd name="connsiteX3" fmla="*/ 123852 w 123852"/>
                <a:gd name="connsiteY3" fmla="*/ 20484 h 506421"/>
                <a:gd name="connsiteX4" fmla="*/ 123852 w 123852"/>
                <a:gd name="connsiteY4" fmla="*/ 485937 h 506421"/>
                <a:gd name="connsiteX5" fmla="*/ 103368 w 123852"/>
                <a:gd name="connsiteY5" fmla="*/ 506421 h 506421"/>
                <a:gd name="connsiteX6" fmla="*/ 21437 w 123852"/>
                <a:gd name="connsiteY6" fmla="*/ 506421 h 506421"/>
                <a:gd name="connsiteX7" fmla="*/ 953 w 123852"/>
                <a:gd name="connsiteY7" fmla="*/ 485937 h 506421"/>
                <a:gd name="connsiteX8" fmla="*/ 0 w 123852"/>
                <a:gd name="connsiteY8" fmla="*/ 121507 h 506421"/>
                <a:gd name="connsiteX0" fmla="*/ 0 w 124478"/>
                <a:gd name="connsiteY0" fmla="*/ 121507 h 506421"/>
                <a:gd name="connsiteX1" fmla="*/ 21437 w 124478"/>
                <a:gd name="connsiteY1" fmla="*/ 0 h 506421"/>
                <a:gd name="connsiteX2" fmla="*/ 65754 w 124478"/>
                <a:gd name="connsiteY2" fmla="*/ 60265 h 506421"/>
                <a:gd name="connsiteX3" fmla="*/ 124478 w 124478"/>
                <a:gd name="connsiteY3" fmla="*/ 61240 h 506421"/>
                <a:gd name="connsiteX4" fmla="*/ 123852 w 124478"/>
                <a:gd name="connsiteY4" fmla="*/ 485937 h 506421"/>
                <a:gd name="connsiteX5" fmla="*/ 103368 w 124478"/>
                <a:gd name="connsiteY5" fmla="*/ 506421 h 506421"/>
                <a:gd name="connsiteX6" fmla="*/ 21437 w 124478"/>
                <a:gd name="connsiteY6" fmla="*/ 506421 h 506421"/>
                <a:gd name="connsiteX7" fmla="*/ 953 w 124478"/>
                <a:gd name="connsiteY7" fmla="*/ 485937 h 506421"/>
                <a:gd name="connsiteX8" fmla="*/ 0 w 124478"/>
                <a:gd name="connsiteY8" fmla="*/ 121507 h 506421"/>
                <a:gd name="connsiteX0" fmla="*/ 0 w 124478"/>
                <a:gd name="connsiteY0" fmla="*/ 121507 h 506421"/>
                <a:gd name="connsiteX1" fmla="*/ 21437 w 124478"/>
                <a:gd name="connsiteY1" fmla="*/ 0 h 506421"/>
                <a:gd name="connsiteX2" fmla="*/ 65754 w 124478"/>
                <a:gd name="connsiteY2" fmla="*/ 60265 h 506421"/>
                <a:gd name="connsiteX3" fmla="*/ 124478 w 124478"/>
                <a:gd name="connsiteY3" fmla="*/ 61240 h 506421"/>
                <a:gd name="connsiteX4" fmla="*/ 123852 w 124478"/>
                <a:gd name="connsiteY4" fmla="*/ 485937 h 506421"/>
                <a:gd name="connsiteX5" fmla="*/ 103368 w 124478"/>
                <a:gd name="connsiteY5" fmla="*/ 506421 h 506421"/>
                <a:gd name="connsiteX6" fmla="*/ 21437 w 124478"/>
                <a:gd name="connsiteY6" fmla="*/ 506421 h 506421"/>
                <a:gd name="connsiteX7" fmla="*/ 953 w 124478"/>
                <a:gd name="connsiteY7" fmla="*/ 485937 h 506421"/>
                <a:gd name="connsiteX8" fmla="*/ 0 w 124478"/>
                <a:gd name="connsiteY8" fmla="*/ 121507 h 506421"/>
                <a:gd name="connsiteX0" fmla="*/ 0 w 123853"/>
                <a:gd name="connsiteY0" fmla="*/ 121507 h 506421"/>
                <a:gd name="connsiteX1" fmla="*/ 21437 w 123853"/>
                <a:gd name="connsiteY1" fmla="*/ 0 h 506421"/>
                <a:gd name="connsiteX2" fmla="*/ 65754 w 123853"/>
                <a:gd name="connsiteY2" fmla="*/ 60265 h 506421"/>
                <a:gd name="connsiteX3" fmla="*/ 113458 w 123853"/>
                <a:gd name="connsiteY3" fmla="*/ 122766 h 506421"/>
                <a:gd name="connsiteX4" fmla="*/ 123852 w 123853"/>
                <a:gd name="connsiteY4" fmla="*/ 485937 h 506421"/>
                <a:gd name="connsiteX5" fmla="*/ 103368 w 123853"/>
                <a:gd name="connsiteY5" fmla="*/ 506421 h 506421"/>
                <a:gd name="connsiteX6" fmla="*/ 21437 w 123853"/>
                <a:gd name="connsiteY6" fmla="*/ 506421 h 506421"/>
                <a:gd name="connsiteX7" fmla="*/ 953 w 123853"/>
                <a:gd name="connsiteY7" fmla="*/ 485937 h 506421"/>
                <a:gd name="connsiteX8" fmla="*/ 0 w 123853"/>
                <a:gd name="connsiteY8" fmla="*/ 121507 h 506421"/>
                <a:gd name="connsiteX0" fmla="*/ 30672 w 122900"/>
                <a:gd name="connsiteY0" fmla="*/ 160535 h 506421"/>
                <a:gd name="connsiteX1" fmla="*/ 20484 w 122900"/>
                <a:gd name="connsiteY1" fmla="*/ 0 h 506421"/>
                <a:gd name="connsiteX2" fmla="*/ 64801 w 122900"/>
                <a:gd name="connsiteY2" fmla="*/ 60265 h 506421"/>
                <a:gd name="connsiteX3" fmla="*/ 112505 w 122900"/>
                <a:gd name="connsiteY3" fmla="*/ 122766 h 506421"/>
                <a:gd name="connsiteX4" fmla="*/ 122899 w 122900"/>
                <a:gd name="connsiteY4" fmla="*/ 485937 h 506421"/>
                <a:gd name="connsiteX5" fmla="*/ 102415 w 122900"/>
                <a:gd name="connsiteY5" fmla="*/ 506421 h 506421"/>
                <a:gd name="connsiteX6" fmla="*/ 20484 w 122900"/>
                <a:gd name="connsiteY6" fmla="*/ 506421 h 506421"/>
                <a:gd name="connsiteX7" fmla="*/ 0 w 122900"/>
                <a:gd name="connsiteY7" fmla="*/ 485937 h 506421"/>
                <a:gd name="connsiteX8" fmla="*/ 30672 w 122900"/>
                <a:gd name="connsiteY8" fmla="*/ 160535 h 506421"/>
                <a:gd name="connsiteX0" fmla="*/ 89447 w 181675"/>
                <a:gd name="connsiteY0" fmla="*/ 135679 h 481565"/>
                <a:gd name="connsiteX1" fmla="*/ 893 w 181675"/>
                <a:gd name="connsiteY1" fmla="*/ 0 h 481565"/>
                <a:gd name="connsiteX2" fmla="*/ 123576 w 181675"/>
                <a:gd name="connsiteY2" fmla="*/ 35409 h 481565"/>
                <a:gd name="connsiteX3" fmla="*/ 171280 w 181675"/>
                <a:gd name="connsiteY3" fmla="*/ 97910 h 481565"/>
                <a:gd name="connsiteX4" fmla="*/ 181674 w 181675"/>
                <a:gd name="connsiteY4" fmla="*/ 461081 h 481565"/>
                <a:gd name="connsiteX5" fmla="*/ 161190 w 181675"/>
                <a:gd name="connsiteY5" fmla="*/ 481565 h 481565"/>
                <a:gd name="connsiteX6" fmla="*/ 79259 w 181675"/>
                <a:gd name="connsiteY6" fmla="*/ 481565 h 481565"/>
                <a:gd name="connsiteX7" fmla="*/ 58775 w 181675"/>
                <a:gd name="connsiteY7" fmla="*/ 461081 h 481565"/>
                <a:gd name="connsiteX8" fmla="*/ 89447 w 181675"/>
                <a:gd name="connsiteY8" fmla="*/ 135679 h 481565"/>
                <a:gd name="connsiteX0" fmla="*/ 58348 w 182045"/>
                <a:gd name="connsiteY0" fmla="*/ 115848 h 481565"/>
                <a:gd name="connsiteX1" fmla="*/ 1263 w 182045"/>
                <a:gd name="connsiteY1" fmla="*/ 0 h 481565"/>
                <a:gd name="connsiteX2" fmla="*/ 123946 w 182045"/>
                <a:gd name="connsiteY2" fmla="*/ 35409 h 481565"/>
                <a:gd name="connsiteX3" fmla="*/ 171650 w 182045"/>
                <a:gd name="connsiteY3" fmla="*/ 97910 h 481565"/>
                <a:gd name="connsiteX4" fmla="*/ 182044 w 182045"/>
                <a:gd name="connsiteY4" fmla="*/ 461081 h 481565"/>
                <a:gd name="connsiteX5" fmla="*/ 161560 w 182045"/>
                <a:gd name="connsiteY5" fmla="*/ 481565 h 481565"/>
                <a:gd name="connsiteX6" fmla="*/ 79629 w 182045"/>
                <a:gd name="connsiteY6" fmla="*/ 481565 h 481565"/>
                <a:gd name="connsiteX7" fmla="*/ 59145 w 182045"/>
                <a:gd name="connsiteY7" fmla="*/ 461081 h 481565"/>
                <a:gd name="connsiteX8" fmla="*/ 58348 w 182045"/>
                <a:gd name="connsiteY8" fmla="*/ 115848 h 481565"/>
                <a:gd name="connsiteX0" fmla="*/ 58348 w 182508"/>
                <a:gd name="connsiteY0" fmla="*/ 115848 h 481565"/>
                <a:gd name="connsiteX1" fmla="*/ 1263 w 182508"/>
                <a:gd name="connsiteY1" fmla="*/ 0 h 481565"/>
                <a:gd name="connsiteX2" fmla="*/ 123946 w 182508"/>
                <a:gd name="connsiteY2" fmla="*/ 35409 h 481565"/>
                <a:gd name="connsiteX3" fmla="*/ 182508 w 182508"/>
                <a:gd name="connsiteY3" fmla="*/ 89256 h 481565"/>
                <a:gd name="connsiteX4" fmla="*/ 182044 w 182508"/>
                <a:gd name="connsiteY4" fmla="*/ 461081 h 481565"/>
                <a:gd name="connsiteX5" fmla="*/ 161560 w 182508"/>
                <a:gd name="connsiteY5" fmla="*/ 481565 h 481565"/>
                <a:gd name="connsiteX6" fmla="*/ 79629 w 182508"/>
                <a:gd name="connsiteY6" fmla="*/ 481565 h 481565"/>
                <a:gd name="connsiteX7" fmla="*/ 59145 w 182508"/>
                <a:gd name="connsiteY7" fmla="*/ 461081 h 481565"/>
                <a:gd name="connsiteX8" fmla="*/ 58348 w 182508"/>
                <a:gd name="connsiteY8" fmla="*/ 115848 h 481565"/>
                <a:gd name="connsiteX0" fmla="*/ 58348 w 182508"/>
                <a:gd name="connsiteY0" fmla="*/ 115848 h 481565"/>
                <a:gd name="connsiteX1" fmla="*/ 1263 w 182508"/>
                <a:gd name="connsiteY1" fmla="*/ 0 h 481565"/>
                <a:gd name="connsiteX2" fmla="*/ 123946 w 182508"/>
                <a:gd name="connsiteY2" fmla="*/ 35409 h 481565"/>
                <a:gd name="connsiteX3" fmla="*/ 182508 w 182508"/>
                <a:gd name="connsiteY3" fmla="*/ 89256 h 481565"/>
                <a:gd name="connsiteX4" fmla="*/ 162386 w 182508"/>
                <a:gd name="connsiteY4" fmla="*/ 331574 h 481565"/>
                <a:gd name="connsiteX5" fmla="*/ 161560 w 182508"/>
                <a:gd name="connsiteY5" fmla="*/ 481565 h 481565"/>
                <a:gd name="connsiteX6" fmla="*/ 79629 w 182508"/>
                <a:gd name="connsiteY6" fmla="*/ 481565 h 481565"/>
                <a:gd name="connsiteX7" fmla="*/ 59145 w 182508"/>
                <a:gd name="connsiteY7" fmla="*/ 461081 h 481565"/>
                <a:gd name="connsiteX8" fmla="*/ 58348 w 182508"/>
                <a:gd name="connsiteY8" fmla="*/ 115848 h 481565"/>
                <a:gd name="connsiteX0" fmla="*/ 58348 w 182508"/>
                <a:gd name="connsiteY0" fmla="*/ 115848 h 481724"/>
                <a:gd name="connsiteX1" fmla="*/ 1263 w 182508"/>
                <a:gd name="connsiteY1" fmla="*/ 0 h 481724"/>
                <a:gd name="connsiteX2" fmla="*/ 123946 w 182508"/>
                <a:gd name="connsiteY2" fmla="*/ 35409 h 481724"/>
                <a:gd name="connsiteX3" fmla="*/ 182508 w 182508"/>
                <a:gd name="connsiteY3" fmla="*/ 89256 h 481724"/>
                <a:gd name="connsiteX4" fmla="*/ 162386 w 182508"/>
                <a:gd name="connsiteY4" fmla="*/ 331574 h 481724"/>
                <a:gd name="connsiteX5" fmla="*/ 178397 w 182508"/>
                <a:gd name="connsiteY5" fmla="*/ 481724 h 481724"/>
                <a:gd name="connsiteX6" fmla="*/ 79629 w 182508"/>
                <a:gd name="connsiteY6" fmla="*/ 481565 h 481724"/>
                <a:gd name="connsiteX7" fmla="*/ 59145 w 182508"/>
                <a:gd name="connsiteY7" fmla="*/ 461081 h 481724"/>
                <a:gd name="connsiteX8" fmla="*/ 58348 w 182508"/>
                <a:gd name="connsiteY8" fmla="*/ 115848 h 481724"/>
                <a:gd name="connsiteX0" fmla="*/ 58348 w 182508"/>
                <a:gd name="connsiteY0" fmla="*/ 115848 h 481724"/>
                <a:gd name="connsiteX1" fmla="*/ 1263 w 182508"/>
                <a:gd name="connsiteY1" fmla="*/ 0 h 481724"/>
                <a:gd name="connsiteX2" fmla="*/ 123946 w 182508"/>
                <a:gd name="connsiteY2" fmla="*/ 35409 h 481724"/>
                <a:gd name="connsiteX3" fmla="*/ 182508 w 182508"/>
                <a:gd name="connsiteY3" fmla="*/ 89256 h 481724"/>
                <a:gd name="connsiteX4" fmla="*/ 160813 w 182508"/>
                <a:gd name="connsiteY4" fmla="*/ 319771 h 481724"/>
                <a:gd name="connsiteX5" fmla="*/ 178397 w 182508"/>
                <a:gd name="connsiteY5" fmla="*/ 481724 h 481724"/>
                <a:gd name="connsiteX6" fmla="*/ 79629 w 182508"/>
                <a:gd name="connsiteY6" fmla="*/ 481565 h 481724"/>
                <a:gd name="connsiteX7" fmla="*/ 59145 w 182508"/>
                <a:gd name="connsiteY7" fmla="*/ 461081 h 481724"/>
                <a:gd name="connsiteX8" fmla="*/ 58348 w 182508"/>
                <a:gd name="connsiteY8" fmla="*/ 115848 h 481724"/>
                <a:gd name="connsiteX0" fmla="*/ 58348 w 182508"/>
                <a:gd name="connsiteY0" fmla="*/ 115848 h 481724"/>
                <a:gd name="connsiteX1" fmla="*/ 1263 w 182508"/>
                <a:gd name="connsiteY1" fmla="*/ 0 h 481724"/>
                <a:gd name="connsiteX2" fmla="*/ 123946 w 182508"/>
                <a:gd name="connsiteY2" fmla="*/ 35409 h 481724"/>
                <a:gd name="connsiteX3" fmla="*/ 182508 w 182508"/>
                <a:gd name="connsiteY3" fmla="*/ 89256 h 481724"/>
                <a:gd name="connsiteX4" fmla="*/ 160813 w 182508"/>
                <a:gd name="connsiteY4" fmla="*/ 319771 h 481724"/>
                <a:gd name="connsiteX5" fmla="*/ 178397 w 182508"/>
                <a:gd name="connsiteY5" fmla="*/ 481724 h 481724"/>
                <a:gd name="connsiteX6" fmla="*/ 79629 w 182508"/>
                <a:gd name="connsiteY6" fmla="*/ 481565 h 481724"/>
                <a:gd name="connsiteX7" fmla="*/ 59145 w 182508"/>
                <a:gd name="connsiteY7" fmla="*/ 461081 h 481724"/>
                <a:gd name="connsiteX8" fmla="*/ 58348 w 182508"/>
                <a:gd name="connsiteY8" fmla="*/ 115848 h 481724"/>
                <a:gd name="connsiteX0" fmla="*/ 58348 w 213825"/>
                <a:gd name="connsiteY0" fmla="*/ 115848 h 481724"/>
                <a:gd name="connsiteX1" fmla="*/ 1263 w 213825"/>
                <a:gd name="connsiteY1" fmla="*/ 0 h 481724"/>
                <a:gd name="connsiteX2" fmla="*/ 123946 w 213825"/>
                <a:gd name="connsiteY2" fmla="*/ 35409 h 481724"/>
                <a:gd name="connsiteX3" fmla="*/ 213825 w 213825"/>
                <a:gd name="connsiteY3" fmla="*/ 53854 h 481724"/>
                <a:gd name="connsiteX4" fmla="*/ 160813 w 213825"/>
                <a:gd name="connsiteY4" fmla="*/ 319771 h 481724"/>
                <a:gd name="connsiteX5" fmla="*/ 178397 w 213825"/>
                <a:gd name="connsiteY5" fmla="*/ 481724 h 481724"/>
                <a:gd name="connsiteX6" fmla="*/ 79629 w 213825"/>
                <a:gd name="connsiteY6" fmla="*/ 481565 h 481724"/>
                <a:gd name="connsiteX7" fmla="*/ 59145 w 213825"/>
                <a:gd name="connsiteY7" fmla="*/ 461081 h 481724"/>
                <a:gd name="connsiteX8" fmla="*/ 58348 w 213825"/>
                <a:gd name="connsiteY8" fmla="*/ 115848 h 481724"/>
                <a:gd name="connsiteX0" fmla="*/ 58348 w 238216"/>
                <a:gd name="connsiteY0" fmla="*/ 115848 h 481724"/>
                <a:gd name="connsiteX1" fmla="*/ 1263 w 238216"/>
                <a:gd name="connsiteY1" fmla="*/ 0 h 481724"/>
                <a:gd name="connsiteX2" fmla="*/ 123946 w 238216"/>
                <a:gd name="connsiteY2" fmla="*/ 35409 h 481724"/>
                <a:gd name="connsiteX3" fmla="*/ 238216 w 238216"/>
                <a:gd name="connsiteY3" fmla="*/ 38593 h 481724"/>
                <a:gd name="connsiteX4" fmla="*/ 160813 w 238216"/>
                <a:gd name="connsiteY4" fmla="*/ 319771 h 481724"/>
                <a:gd name="connsiteX5" fmla="*/ 178397 w 238216"/>
                <a:gd name="connsiteY5" fmla="*/ 481724 h 481724"/>
                <a:gd name="connsiteX6" fmla="*/ 79629 w 238216"/>
                <a:gd name="connsiteY6" fmla="*/ 481565 h 481724"/>
                <a:gd name="connsiteX7" fmla="*/ 59145 w 238216"/>
                <a:gd name="connsiteY7" fmla="*/ 461081 h 481724"/>
                <a:gd name="connsiteX8" fmla="*/ 58348 w 238216"/>
                <a:gd name="connsiteY8" fmla="*/ 115848 h 481724"/>
                <a:gd name="connsiteX0" fmla="*/ 58348 w 238216"/>
                <a:gd name="connsiteY0" fmla="*/ 115848 h 481724"/>
                <a:gd name="connsiteX1" fmla="*/ 1263 w 238216"/>
                <a:gd name="connsiteY1" fmla="*/ 0 h 481724"/>
                <a:gd name="connsiteX2" fmla="*/ 123946 w 238216"/>
                <a:gd name="connsiteY2" fmla="*/ 35409 h 481724"/>
                <a:gd name="connsiteX3" fmla="*/ 238216 w 238216"/>
                <a:gd name="connsiteY3" fmla="*/ 38593 h 481724"/>
                <a:gd name="connsiteX4" fmla="*/ 180014 w 238216"/>
                <a:gd name="connsiteY4" fmla="*/ 283580 h 481724"/>
                <a:gd name="connsiteX5" fmla="*/ 178397 w 238216"/>
                <a:gd name="connsiteY5" fmla="*/ 481724 h 481724"/>
                <a:gd name="connsiteX6" fmla="*/ 79629 w 238216"/>
                <a:gd name="connsiteY6" fmla="*/ 481565 h 481724"/>
                <a:gd name="connsiteX7" fmla="*/ 59145 w 238216"/>
                <a:gd name="connsiteY7" fmla="*/ 461081 h 481724"/>
                <a:gd name="connsiteX8" fmla="*/ 58348 w 238216"/>
                <a:gd name="connsiteY8" fmla="*/ 115848 h 481724"/>
                <a:gd name="connsiteX0" fmla="*/ 58348 w 238216"/>
                <a:gd name="connsiteY0" fmla="*/ 115848 h 482357"/>
                <a:gd name="connsiteX1" fmla="*/ 1263 w 238216"/>
                <a:gd name="connsiteY1" fmla="*/ 0 h 482357"/>
                <a:gd name="connsiteX2" fmla="*/ 123946 w 238216"/>
                <a:gd name="connsiteY2" fmla="*/ 35409 h 482357"/>
                <a:gd name="connsiteX3" fmla="*/ 238216 w 238216"/>
                <a:gd name="connsiteY3" fmla="*/ 38593 h 482357"/>
                <a:gd name="connsiteX4" fmla="*/ 180014 w 238216"/>
                <a:gd name="connsiteY4" fmla="*/ 283580 h 482357"/>
                <a:gd name="connsiteX5" fmla="*/ 209712 w 238216"/>
                <a:gd name="connsiteY5" fmla="*/ 482357 h 482357"/>
                <a:gd name="connsiteX6" fmla="*/ 79629 w 238216"/>
                <a:gd name="connsiteY6" fmla="*/ 481565 h 482357"/>
                <a:gd name="connsiteX7" fmla="*/ 59145 w 238216"/>
                <a:gd name="connsiteY7" fmla="*/ 461081 h 482357"/>
                <a:gd name="connsiteX8" fmla="*/ 58348 w 238216"/>
                <a:gd name="connsiteY8" fmla="*/ 115848 h 482357"/>
                <a:gd name="connsiteX0" fmla="*/ 58348 w 238216"/>
                <a:gd name="connsiteY0" fmla="*/ 115848 h 482357"/>
                <a:gd name="connsiteX1" fmla="*/ 1263 w 238216"/>
                <a:gd name="connsiteY1" fmla="*/ 0 h 482357"/>
                <a:gd name="connsiteX2" fmla="*/ 123946 w 238216"/>
                <a:gd name="connsiteY2" fmla="*/ 35409 h 482357"/>
                <a:gd name="connsiteX3" fmla="*/ 238216 w 238216"/>
                <a:gd name="connsiteY3" fmla="*/ 38593 h 482357"/>
                <a:gd name="connsiteX4" fmla="*/ 200788 w 238216"/>
                <a:gd name="connsiteY4" fmla="*/ 259191 h 482357"/>
                <a:gd name="connsiteX5" fmla="*/ 209712 w 238216"/>
                <a:gd name="connsiteY5" fmla="*/ 482357 h 482357"/>
                <a:gd name="connsiteX6" fmla="*/ 79629 w 238216"/>
                <a:gd name="connsiteY6" fmla="*/ 481565 h 482357"/>
                <a:gd name="connsiteX7" fmla="*/ 59145 w 238216"/>
                <a:gd name="connsiteY7" fmla="*/ 461081 h 482357"/>
                <a:gd name="connsiteX8" fmla="*/ 58348 w 238216"/>
                <a:gd name="connsiteY8" fmla="*/ 115848 h 48235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8216" h="482357">
                  <a:moveTo>
                    <a:pt x="58348" y="115848"/>
                  </a:moveTo>
                  <a:cubicBezTo>
                    <a:pt x="58348" y="104535"/>
                    <a:pt x="-10050" y="0"/>
                    <a:pt x="1263" y="0"/>
                  </a:cubicBezTo>
                  <a:lnTo>
                    <a:pt x="123946" y="35409"/>
                  </a:lnTo>
                  <a:cubicBezTo>
                    <a:pt x="135259" y="35409"/>
                    <a:pt x="238216" y="27280"/>
                    <a:pt x="238216" y="38593"/>
                  </a:cubicBezTo>
                  <a:cubicBezTo>
                    <a:pt x="221646" y="129488"/>
                    <a:pt x="212328" y="94495"/>
                    <a:pt x="200788" y="259191"/>
                  </a:cubicBezTo>
                  <a:cubicBezTo>
                    <a:pt x="200788" y="270504"/>
                    <a:pt x="221025" y="482357"/>
                    <a:pt x="209712" y="482357"/>
                  </a:cubicBezTo>
                  <a:lnTo>
                    <a:pt x="79629" y="481565"/>
                  </a:lnTo>
                  <a:cubicBezTo>
                    <a:pt x="68316" y="481565"/>
                    <a:pt x="59145" y="472394"/>
                    <a:pt x="59145" y="461081"/>
                  </a:cubicBezTo>
                  <a:cubicBezTo>
                    <a:pt x="59145" y="305930"/>
                    <a:pt x="58348" y="270999"/>
                    <a:pt x="58348" y="115848"/>
                  </a:cubicBezTo>
                  <a:close/>
                </a:path>
              </a:pathLst>
            </a:custGeom>
            <a:noFill/>
            <a:ln>
              <a:solidFill>
                <a:srgbClr val="AED8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defTabSz="475945"/>
              <a:endParaRPr lang="en-GB" sz="1874">
                <a:solidFill>
                  <a:prstClr val="white"/>
                </a:solidFill>
                <a:latin typeface="Calibri" panose="020F0502020204030204"/>
              </a:endParaRPr>
            </a:p>
          </p:txBody>
        </p:sp>
      </p:grpSp>
      <p:cxnSp>
        <p:nvCxnSpPr>
          <p:cNvPr id="10" name="Gerade Verbindung mit Pfeil 9"/>
          <p:cNvCxnSpPr/>
          <p:nvPr/>
        </p:nvCxnSpPr>
        <p:spPr>
          <a:xfrm>
            <a:off x="1422400" y="2818205"/>
            <a:ext cx="749300"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cxnSp>
        <p:nvCxnSpPr>
          <p:cNvPr id="13" name="Gerade Verbindung mit Pfeil 12"/>
          <p:cNvCxnSpPr/>
          <p:nvPr/>
        </p:nvCxnSpPr>
        <p:spPr>
          <a:xfrm>
            <a:off x="6789271" y="2820043"/>
            <a:ext cx="1662579"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16" name="Bogen 15"/>
          <p:cNvSpPr/>
          <p:nvPr/>
        </p:nvSpPr>
        <p:spPr>
          <a:xfrm flipH="1">
            <a:off x="2768527" y="1625600"/>
            <a:ext cx="1971255" cy="1540503"/>
          </a:xfrm>
          <a:prstGeom prst="arc">
            <a:avLst>
              <a:gd name="adj1" fmla="val 16217295"/>
              <a:gd name="adj2" fmla="val 21106559"/>
            </a:avLst>
          </a:prstGeom>
          <a:ln w="28575">
            <a:headEnd type="none" w="med" len="med"/>
            <a:tailEnd type="none" w="med" len="med"/>
          </a:ln>
        </p:spPr>
        <p:style>
          <a:lnRef idx="1">
            <a:schemeClr val="dk1"/>
          </a:lnRef>
          <a:fillRef idx="0">
            <a:schemeClr val="dk1"/>
          </a:fillRef>
          <a:effectRef idx="0">
            <a:schemeClr val="dk1"/>
          </a:effectRef>
          <a:fontRef idx="minor">
            <a:schemeClr val="tx1"/>
          </a:fontRef>
        </p:style>
        <p:txBody>
          <a:bodyPr rtlCol="0" anchor="ctr"/>
          <a:lstStyle/>
          <a:p>
            <a:pPr algn="ctr"/>
            <a:endParaRPr lang="de-DE"/>
          </a:p>
        </p:txBody>
      </p:sp>
      <p:sp>
        <p:nvSpPr>
          <p:cNvPr id="17" name="Bogen 16"/>
          <p:cNvSpPr/>
          <p:nvPr/>
        </p:nvSpPr>
        <p:spPr>
          <a:xfrm flipH="1" flipV="1">
            <a:off x="2768527" y="2470168"/>
            <a:ext cx="1971255" cy="1540503"/>
          </a:xfrm>
          <a:prstGeom prst="arc">
            <a:avLst>
              <a:gd name="adj1" fmla="val 16356997"/>
              <a:gd name="adj2" fmla="val 21336444"/>
            </a:avLst>
          </a:prstGeom>
          <a:ln w="28575">
            <a:prstDash val="dash"/>
            <a:headEnd type="none" w="med" len="med"/>
            <a:tailEnd type="none" w="med" len="med"/>
          </a:ln>
        </p:spPr>
        <p:style>
          <a:lnRef idx="1">
            <a:schemeClr val="dk1"/>
          </a:lnRef>
          <a:fillRef idx="0">
            <a:schemeClr val="dk1"/>
          </a:fillRef>
          <a:effectRef idx="0">
            <a:schemeClr val="dk1"/>
          </a:effectRef>
          <a:fontRef idx="minor">
            <a:schemeClr val="tx1"/>
          </a:fontRef>
        </p:style>
        <p:txBody>
          <a:bodyPr rtlCol="0" anchor="ctr"/>
          <a:lstStyle/>
          <a:p>
            <a:pPr algn="ctr"/>
            <a:endParaRPr lang="de-DE"/>
          </a:p>
        </p:txBody>
      </p:sp>
      <p:cxnSp>
        <p:nvCxnSpPr>
          <p:cNvPr id="19" name="Gerade Verbindung mit Pfeil 18"/>
          <p:cNvCxnSpPr/>
          <p:nvPr/>
        </p:nvCxnSpPr>
        <p:spPr>
          <a:xfrm>
            <a:off x="3749391" y="1625600"/>
            <a:ext cx="749300"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cxnSp>
        <p:nvCxnSpPr>
          <p:cNvPr id="20" name="Gerade Verbindung mit Pfeil 19"/>
          <p:cNvCxnSpPr/>
          <p:nvPr/>
        </p:nvCxnSpPr>
        <p:spPr>
          <a:xfrm>
            <a:off x="3788569" y="4005580"/>
            <a:ext cx="703772" cy="6350"/>
          </a:xfrm>
          <a:prstGeom prst="straightConnector1">
            <a:avLst/>
          </a:prstGeom>
          <a:ln w="28575">
            <a:prstDash val="dash"/>
            <a:tailEnd type="triangle"/>
          </a:ln>
        </p:spPr>
        <p:style>
          <a:lnRef idx="1">
            <a:schemeClr val="dk1"/>
          </a:lnRef>
          <a:fillRef idx="0">
            <a:schemeClr val="dk1"/>
          </a:fillRef>
          <a:effectRef idx="0">
            <a:schemeClr val="dk1"/>
          </a:effectRef>
          <a:fontRef idx="minor">
            <a:schemeClr val="tx1"/>
          </a:fontRef>
        </p:style>
      </p:cxnSp>
      <p:sp>
        <p:nvSpPr>
          <p:cNvPr id="23" name="Flussdiagramm: Grenzstelle 238">
            <a:extLst>
              <a:ext uri="{FF2B5EF4-FFF2-40B4-BE49-F238E27FC236}">
                <a16:creationId xmlns:a16="http://schemas.microsoft.com/office/drawing/2014/main" id="{2CA79658-9113-42ED-B09B-394CDFB5514A}"/>
              </a:ext>
            </a:extLst>
          </p:cNvPr>
          <p:cNvSpPr/>
          <p:nvPr/>
        </p:nvSpPr>
        <p:spPr>
          <a:xfrm rot="10800000">
            <a:off x="3315889" y="1275415"/>
            <a:ext cx="867003" cy="232614"/>
          </a:xfrm>
          <a:custGeom>
            <a:avLst/>
            <a:gdLst>
              <a:gd name="connsiteX0" fmla="*/ 3475 w 21600"/>
              <a:gd name="connsiteY0" fmla="*/ 0 h 21600"/>
              <a:gd name="connsiteX1" fmla="*/ 18125 w 21600"/>
              <a:gd name="connsiteY1" fmla="*/ 0 h 21600"/>
              <a:gd name="connsiteX2" fmla="*/ 21600 w 21600"/>
              <a:gd name="connsiteY2" fmla="*/ 10800 h 21600"/>
              <a:gd name="connsiteX3" fmla="*/ 18125 w 21600"/>
              <a:gd name="connsiteY3" fmla="*/ 21600 h 21600"/>
              <a:gd name="connsiteX4" fmla="*/ 3475 w 21600"/>
              <a:gd name="connsiteY4" fmla="*/ 21600 h 21600"/>
              <a:gd name="connsiteX5" fmla="*/ 0 w 21600"/>
              <a:gd name="connsiteY5" fmla="*/ 10800 h 21600"/>
              <a:gd name="connsiteX6" fmla="*/ 3475 w 21600"/>
              <a:gd name="connsiteY6" fmla="*/ 0 h 21600"/>
              <a:gd name="connsiteX0" fmla="*/ 3475 w 21600"/>
              <a:gd name="connsiteY0" fmla="*/ 0 h 21600"/>
              <a:gd name="connsiteX1" fmla="*/ 18125 w 21600"/>
              <a:gd name="connsiteY1" fmla="*/ 0 h 21600"/>
              <a:gd name="connsiteX2" fmla="*/ 21600 w 21600"/>
              <a:gd name="connsiteY2" fmla="*/ 10800 h 21600"/>
              <a:gd name="connsiteX3" fmla="*/ 18125 w 21600"/>
              <a:gd name="connsiteY3" fmla="*/ 21600 h 21600"/>
              <a:gd name="connsiteX4" fmla="*/ 11344 w 21600"/>
              <a:gd name="connsiteY4" fmla="*/ 14484 h 21600"/>
              <a:gd name="connsiteX5" fmla="*/ 3475 w 21600"/>
              <a:gd name="connsiteY5" fmla="*/ 21600 h 21600"/>
              <a:gd name="connsiteX6" fmla="*/ 0 w 21600"/>
              <a:gd name="connsiteY6" fmla="*/ 10800 h 21600"/>
              <a:gd name="connsiteX7" fmla="*/ 3475 w 21600"/>
              <a:gd name="connsiteY7" fmla="*/ 0 h 21600"/>
              <a:gd name="connsiteX0" fmla="*/ 3475 w 21600"/>
              <a:gd name="connsiteY0" fmla="*/ 5902 h 27502"/>
              <a:gd name="connsiteX1" fmla="*/ 12703 w 21600"/>
              <a:gd name="connsiteY1" fmla="*/ 0 h 27502"/>
              <a:gd name="connsiteX2" fmla="*/ 18125 w 21600"/>
              <a:gd name="connsiteY2" fmla="*/ 5902 h 27502"/>
              <a:gd name="connsiteX3" fmla="*/ 21600 w 21600"/>
              <a:gd name="connsiteY3" fmla="*/ 16702 h 27502"/>
              <a:gd name="connsiteX4" fmla="*/ 18125 w 21600"/>
              <a:gd name="connsiteY4" fmla="*/ 27502 h 27502"/>
              <a:gd name="connsiteX5" fmla="*/ 11344 w 21600"/>
              <a:gd name="connsiteY5" fmla="*/ 20386 h 27502"/>
              <a:gd name="connsiteX6" fmla="*/ 3475 w 21600"/>
              <a:gd name="connsiteY6" fmla="*/ 27502 h 27502"/>
              <a:gd name="connsiteX7" fmla="*/ 0 w 21600"/>
              <a:gd name="connsiteY7" fmla="*/ 16702 h 27502"/>
              <a:gd name="connsiteX8" fmla="*/ 3475 w 21600"/>
              <a:gd name="connsiteY8" fmla="*/ 5902 h 27502"/>
              <a:gd name="connsiteX0" fmla="*/ 3475 w 21600"/>
              <a:gd name="connsiteY0" fmla="*/ 5902 h 27502"/>
              <a:gd name="connsiteX1" fmla="*/ 12703 w 21600"/>
              <a:gd name="connsiteY1" fmla="*/ 0 h 27502"/>
              <a:gd name="connsiteX2" fmla="*/ 17381 w 21600"/>
              <a:gd name="connsiteY2" fmla="*/ 1424 h 27502"/>
              <a:gd name="connsiteX3" fmla="*/ 18125 w 21600"/>
              <a:gd name="connsiteY3" fmla="*/ 5902 h 27502"/>
              <a:gd name="connsiteX4" fmla="*/ 21600 w 21600"/>
              <a:gd name="connsiteY4" fmla="*/ 16702 h 27502"/>
              <a:gd name="connsiteX5" fmla="*/ 18125 w 21600"/>
              <a:gd name="connsiteY5" fmla="*/ 27502 h 27502"/>
              <a:gd name="connsiteX6" fmla="*/ 11344 w 21600"/>
              <a:gd name="connsiteY6" fmla="*/ 20386 h 27502"/>
              <a:gd name="connsiteX7" fmla="*/ 3475 w 21600"/>
              <a:gd name="connsiteY7" fmla="*/ 27502 h 27502"/>
              <a:gd name="connsiteX8" fmla="*/ 0 w 21600"/>
              <a:gd name="connsiteY8" fmla="*/ 16702 h 27502"/>
              <a:gd name="connsiteX9" fmla="*/ 3475 w 21600"/>
              <a:gd name="connsiteY9" fmla="*/ 5902 h 27502"/>
              <a:gd name="connsiteX0" fmla="*/ 3475 w 21606"/>
              <a:gd name="connsiteY0" fmla="*/ 5902 h 27502"/>
              <a:gd name="connsiteX1" fmla="*/ 12703 w 21606"/>
              <a:gd name="connsiteY1" fmla="*/ 0 h 27502"/>
              <a:gd name="connsiteX2" fmla="*/ 17381 w 21606"/>
              <a:gd name="connsiteY2" fmla="*/ 1424 h 27502"/>
              <a:gd name="connsiteX3" fmla="*/ 18714 w 21606"/>
              <a:gd name="connsiteY3" fmla="*/ 3425 h 27502"/>
              <a:gd name="connsiteX4" fmla="*/ 21600 w 21606"/>
              <a:gd name="connsiteY4" fmla="*/ 16702 h 27502"/>
              <a:gd name="connsiteX5" fmla="*/ 18125 w 21606"/>
              <a:gd name="connsiteY5" fmla="*/ 27502 h 27502"/>
              <a:gd name="connsiteX6" fmla="*/ 11344 w 21606"/>
              <a:gd name="connsiteY6" fmla="*/ 20386 h 27502"/>
              <a:gd name="connsiteX7" fmla="*/ 3475 w 21606"/>
              <a:gd name="connsiteY7" fmla="*/ 27502 h 27502"/>
              <a:gd name="connsiteX8" fmla="*/ 0 w 21606"/>
              <a:gd name="connsiteY8" fmla="*/ 16702 h 27502"/>
              <a:gd name="connsiteX9" fmla="*/ 3475 w 21606"/>
              <a:gd name="connsiteY9" fmla="*/ 5902 h 27502"/>
              <a:gd name="connsiteX0" fmla="*/ 3475 w 21605"/>
              <a:gd name="connsiteY0" fmla="*/ 5902 h 27502"/>
              <a:gd name="connsiteX1" fmla="*/ 12703 w 21605"/>
              <a:gd name="connsiteY1" fmla="*/ 0 h 27502"/>
              <a:gd name="connsiteX2" fmla="*/ 17381 w 21605"/>
              <a:gd name="connsiteY2" fmla="*/ 1424 h 27502"/>
              <a:gd name="connsiteX3" fmla="*/ 18714 w 21605"/>
              <a:gd name="connsiteY3" fmla="*/ 3425 h 27502"/>
              <a:gd name="connsiteX4" fmla="*/ 21600 w 21605"/>
              <a:gd name="connsiteY4" fmla="*/ 16702 h 27502"/>
              <a:gd name="connsiteX5" fmla="*/ 18125 w 21605"/>
              <a:gd name="connsiteY5" fmla="*/ 27502 h 27502"/>
              <a:gd name="connsiteX6" fmla="*/ 11344 w 21605"/>
              <a:gd name="connsiteY6" fmla="*/ 20386 h 27502"/>
              <a:gd name="connsiteX7" fmla="*/ 3475 w 21605"/>
              <a:gd name="connsiteY7" fmla="*/ 27502 h 27502"/>
              <a:gd name="connsiteX8" fmla="*/ 0 w 21605"/>
              <a:gd name="connsiteY8" fmla="*/ 16702 h 27502"/>
              <a:gd name="connsiteX9" fmla="*/ 3475 w 21605"/>
              <a:gd name="connsiteY9" fmla="*/ 5902 h 27502"/>
              <a:gd name="connsiteX0" fmla="*/ 3475 w 21695"/>
              <a:gd name="connsiteY0" fmla="*/ 5902 h 27502"/>
              <a:gd name="connsiteX1" fmla="*/ 12703 w 21695"/>
              <a:gd name="connsiteY1" fmla="*/ 0 h 27502"/>
              <a:gd name="connsiteX2" fmla="*/ 17381 w 21695"/>
              <a:gd name="connsiteY2" fmla="*/ 1424 h 27502"/>
              <a:gd name="connsiteX3" fmla="*/ 19814 w 21695"/>
              <a:gd name="connsiteY3" fmla="*/ 4489 h 27502"/>
              <a:gd name="connsiteX4" fmla="*/ 21600 w 21695"/>
              <a:gd name="connsiteY4" fmla="*/ 16702 h 27502"/>
              <a:gd name="connsiteX5" fmla="*/ 18125 w 21695"/>
              <a:gd name="connsiteY5" fmla="*/ 27502 h 27502"/>
              <a:gd name="connsiteX6" fmla="*/ 11344 w 21695"/>
              <a:gd name="connsiteY6" fmla="*/ 20386 h 27502"/>
              <a:gd name="connsiteX7" fmla="*/ 3475 w 21695"/>
              <a:gd name="connsiteY7" fmla="*/ 27502 h 27502"/>
              <a:gd name="connsiteX8" fmla="*/ 0 w 21695"/>
              <a:gd name="connsiteY8" fmla="*/ 16702 h 27502"/>
              <a:gd name="connsiteX9" fmla="*/ 3475 w 21695"/>
              <a:gd name="connsiteY9" fmla="*/ 5902 h 27502"/>
              <a:gd name="connsiteX0" fmla="*/ 3475 w 21695"/>
              <a:gd name="connsiteY0" fmla="*/ 5902 h 27502"/>
              <a:gd name="connsiteX1" fmla="*/ 12703 w 21695"/>
              <a:gd name="connsiteY1" fmla="*/ 0 h 27502"/>
              <a:gd name="connsiteX2" fmla="*/ 17381 w 21695"/>
              <a:gd name="connsiteY2" fmla="*/ 1424 h 27502"/>
              <a:gd name="connsiteX3" fmla="*/ 19814 w 21695"/>
              <a:gd name="connsiteY3" fmla="*/ 4489 h 27502"/>
              <a:gd name="connsiteX4" fmla="*/ 21600 w 21695"/>
              <a:gd name="connsiteY4" fmla="*/ 16702 h 27502"/>
              <a:gd name="connsiteX5" fmla="*/ 18125 w 21695"/>
              <a:gd name="connsiteY5" fmla="*/ 27502 h 27502"/>
              <a:gd name="connsiteX6" fmla="*/ 11344 w 21695"/>
              <a:gd name="connsiteY6" fmla="*/ 20386 h 27502"/>
              <a:gd name="connsiteX7" fmla="*/ 3475 w 21695"/>
              <a:gd name="connsiteY7" fmla="*/ 27502 h 27502"/>
              <a:gd name="connsiteX8" fmla="*/ 0 w 21695"/>
              <a:gd name="connsiteY8" fmla="*/ 16702 h 27502"/>
              <a:gd name="connsiteX9" fmla="*/ 3475 w 21695"/>
              <a:gd name="connsiteY9" fmla="*/ 5902 h 27502"/>
              <a:gd name="connsiteX0" fmla="*/ 3475 w 21695"/>
              <a:gd name="connsiteY0" fmla="*/ 6620 h 28220"/>
              <a:gd name="connsiteX1" fmla="*/ 11298 w 21695"/>
              <a:gd name="connsiteY1" fmla="*/ 0 h 28220"/>
              <a:gd name="connsiteX2" fmla="*/ 17381 w 21695"/>
              <a:gd name="connsiteY2" fmla="*/ 2142 h 28220"/>
              <a:gd name="connsiteX3" fmla="*/ 19814 w 21695"/>
              <a:gd name="connsiteY3" fmla="*/ 5207 h 28220"/>
              <a:gd name="connsiteX4" fmla="*/ 21600 w 21695"/>
              <a:gd name="connsiteY4" fmla="*/ 17420 h 28220"/>
              <a:gd name="connsiteX5" fmla="*/ 18125 w 21695"/>
              <a:gd name="connsiteY5" fmla="*/ 28220 h 28220"/>
              <a:gd name="connsiteX6" fmla="*/ 11344 w 21695"/>
              <a:gd name="connsiteY6" fmla="*/ 21104 h 28220"/>
              <a:gd name="connsiteX7" fmla="*/ 3475 w 21695"/>
              <a:gd name="connsiteY7" fmla="*/ 28220 h 28220"/>
              <a:gd name="connsiteX8" fmla="*/ 0 w 21695"/>
              <a:gd name="connsiteY8" fmla="*/ 17420 h 28220"/>
              <a:gd name="connsiteX9" fmla="*/ 3475 w 21695"/>
              <a:gd name="connsiteY9" fmla="*/ 6620 h 28220"/>
              <a:gd name="connsiteX0" fmla="*/ 3475 w 21695"/>
              <a:gd name="connsiteY0" fmla="*/ 7847 h 29447"/>
              <a:gd name="connsiteX1" fmla="*/ 13014 w 21695"/>
              <a:gd name="connsiteY1" fmla="*/ 0 h 29447"/>
              <a:gd name="connsiteX2" fmla="*/ 17381 w 21695"/>
              <a:gd name="connsiteY2" fmla="*/ 3369 h 29447"/>
              <a:gd name="connsiteX3" fmla="*/ 19814 w 21695"/>
              <a:gd name="connsiteY3" fmla="*/ 6434 h 29447"/>
              <a:gd name="connsiteX4" fmla="*/ 21600 w 21695"/>
              <a:gd name="connsiteY4" fmla="*/ 18647 h 29447"/>
              <a:gd name="connsiteX5" fmla="*/ 18125 w 21695"/>
              <a:gd name="connsiteY5" fmla="*/ 29447 h 29447"/>
              <a:gd name="connsiteX6" fmla="*/ 11344 w 21695"/>
              <a:gd name="connsiteY6" fmla="*/ 22331 h 29447"/>
              <a:gd name="connsiteX7" fmla="*/ 3475 w 21695"/>
              <a:gd name="connsiteY7" fmla="*/ 29447 h 29447"/>
              <a:gd name="connsiteX8" fmla="*/ 0 w 21695"/>
              <a:gd name="connsiteY8" fmla="*/ 18647 h 29447"/>
              <a:gd name="connsiteX9" fmla="*/ 3475 w 21695"/>
              <a:gd name="connsiteY9" fmla="*/ 7847 h 29447"/>
              <a:gd name="connsiteX0" fmla="*/ 3475 w 21695"/>
              <a:gd name="connsiteY0" fmla="*/ 7847 h 29447"/>
              <a:gd name="connsiteX1" fmla="*/ 13014 w 21695"/>
              <a:gd name="connsiteY1" fmla="*/ 0 h 29447"/>
              <a:gd name="connsiteX2" fmla="*/ 17381 w 21695"/>
              <a:gd name="connsiteY2" fmla="*/ 3369 h 29447"/>
              <a:gd name="connsiteX3" fmla="*/ 19814 w 21695"/>
              <a:gd name="connsiteY3" fmla="*/ 6434 h 29447"/>
              <a:gd name="connsiteX4" fmla="*/ 21600 w 21695"/>
              <a:gd name="connsiteY4" fmla="*/ 18647 h 29447"/>
              <a:gd name="connsiteX5" fmla="*/ 18125 w 21695"/>
              <a:gd name="connsiteY5" fmla="*/ 29447 h 29447"/>
              <a:gd name="connsiteX6" fmla="*/ 11344 w 21695"/>
              <a:gd name="connsiteY6" fmla="*/ 22331 h 29447"/>
              <a:gd name="connsiteX7" fmla="*/ 3475 w 21695"/>
              <a:gd name="connsiteY7" fmla="*/ 29447 h 29447"/>
              <a:gd name="connsiteX8" fmla="*/ 0 w 21695"/>
              <a:gd name="connsiteY8" fmla="*/ 18647 h 29447"/>
              <a:gd name="connsiteX9" fmla="*/ 3475 w 21695"/>
              <a:gd name="connsiteY9" fmla="*/ 7847 h 29447"/>
              <a:gd name="connsiteX0" fmla="*/ 3475 w 21695"/>
              <a:gd name="connsiteY0" fmla="*/ 7847 h 29447"/>
              <a:gd name="connsiteX1" fmla="*/ 13014 w 21695"/>
              <a:gd name="connsiteY1" fmla="*/ 0 h 29447"/>
              <a:gd name="connsiteX2" fmla="*/ 17381 w 21695"/>
              <a:gd name="connsiteY2" fmla="*/ 3369 h 29447"/>
              <a:gd name="connsiteX3" fmla="*/ 19814 w 21695"/>
              <a:gd name="connsiteY3" fmla="*/ 6434 h 29447"/>
              <a:gd name="connsiteX4" fmla="*/ 21600 w 21695"/>
              <a:gd name="connsiteY4" fmla="*/ 18647 h 29447"/>
              <a:gd name="connsiteX5" fmla="*/ 18125 w 21695"/>
              <a:gd name="connsiteY5" fmla="*/ 29447 h 29447"/>
              <a:gd name="connsiteX6" fmla="*/ 11344 w 21695"/>
              <a:gd name="connsiteY6" fmla="*/ 22331 h 29447"/>
              <a:gd name="connsiteX7" fmla="*/ 3475 w 21695"/>
              <a:gd name="connsiteY7" fmla="*/ 29447 h 29447"/>
              <a:gd name="connsiteX8" fmla="*/ 0 w 21695"/>
              <a:gd name="connsiteY8" fmla="*/ 18647 h 29447"/>
              <a:gd name="connsiteX9" fmla="*/ 3475 w 21695"/>
              <a:gd name="connsiteY9" fmla="*/ 7847 h 29447"/>
              <a:gd name="connsiteX0" fmla="*/ 3844 w 21696"/>
              <a:gd name="connsiteY0" fmla="*/ 5476 h 29447"/>
              <a:gd name="connsiteX1" fmla="*/ 13015 w 21696"/>
              <a:gd name="connsiteY1" fmla="*/ 0 h 29447"/>
              <a:gd name="connsiteX2" fmla="*/ 17382 w 21696"/>
              <a:gd name="connsiteY2" fmla="*/ 3369 h 29447"/>
              <a:gd name="connsiteX3" fmla="*/ 19815 w 21696"/>
              <a:gd name="connsiteY3" fmla="*/ 6434 h 29447"/>
              <a:gd name="connsiteX4" fmla="*/ 21601 w 21696"/>
              <a:gd name="connsiteY4" fmla="*/ 18647 h 29447"/>
              <a:gd name="connsiteX5" fmla="*/ 18126 w 21696"/>
              <a:gd name="connsiteY5" fmla="*/ 29447 h 29447"/>
              <a:gd name="connsiteX6" fmla="*/ 11345 w 21696"/>
              <a:gd name="connsiteY6" fmla="*/ 22331 h 29447"/>
              <a:gd name="connsiteX7" fmla="*/ 3476 w 21696"/>
              <a:gd name="connsiteY7" fmla="*/ 29447 h 29447"/>
              <a:gd name="connsiteX8" fmla="*/ 1 w 21696"/>
              <a:gd name="connsiteY8" fmla="*/ 18647 h 29447"/>
              <a:gd name="connsiteX9" fmla="*/ 3844 w 21696"/>
              <a:gd name="connsiteY9" fmla="*/ 5476 h 29447"/>
              <a:gd name="connsiteX0" fmla="*/ 3844 w 21696"/>
              <a:gd name="connsiteY0" fmla="*/ 5476 h 29447"/>
              <a:gd name="connsiteX1" fmla="*/ 13015 w 21696"/>
              <a:gd name="connsiteY1" fmla="*/ 0 h 29447"/>
              <a:gd name="connsiteX2" fmla="*/ 17382 w 21696"/>
              <a:gd name="connsiteY2" fmla="*/ 3369 h 29447"/>
              <a:gd name="connsiteX3" fmla="*/ 19815 w 21696"/>
              <a:gd name="connsiteY3" fmla="*/ 6434 h 29447"/>
              <a:gd name="connsiteX4" fmla="*/ 21601 w 21696"/>
              <a:gd name="connsiteY4" fmla="*/ 18647 h 29447"/>
              <a:gd name="connsiteX5" fmla="*/ 18126 w 21696"/>
              <a:gd name="connsiteY5" fmla="*/ 29447 h 29447"/>
              <a:gd name="connsiteX6" fmla="*/ 11345 w 21696"/>
              <a:gd name="connsiteY6" fmla="*/ 22331 h 29447"/>
              <a:gd name="connsiteX7" fmla="*/ 3476 w 21696"/>
              <a:gd name="connsiteY7" fmla="*/ 29447 h 29447"/>
              <a:gd name="connsiteX8" fmla="*/ 1 w 21696"/>
              <a:gd name="connsiteY8" fmla="*/ 18647 h 29447"/>
              <a:gd name="connsiteX9" fmla="*/ 3844 w 21696"/>
              <a:gd name="connsiteY9" fmla="*/ 5476 h 29447"/>
              <a:gd name="connsiteX0" fmla="*/ 3844 w 21696"/>
              <a:gd name="connsiteY0" fmla="*/ 5476 h 29447"/>
              <a:gd name="connsiteX1" fmla="*/ 13015 w 21696"/>
              <a:gd name="connsiteY1" fmla="*/ 0 h 29447"/>
              <a:gd name="connsiteX2" fmla="*/ 17382 w 21696"/>
              <a:gd name="connsiteY2" fmla="*/ 3369 h 29447"/>
              <a:gd name="connsiteX3" fmla="*/ 19815 w 21696"/>
              <a:gd name="connsiteY3" fmla="*/ 6434 h 29447"/>
              <a:gd name="connsiteX4" fmla="*/ 21601 w 21696"/>
              <a:gd name="connsiteY4" fmla="*/ 18647 h 29447"/>
              <a:gd name="connsiteX5" fmla="*/ 18126 w 21696"/>
              <a:gd name="connsiteY5" fmla="*/ 29447 h 29447"/>
              <a:gd name="connsiteX6" fmla="*/ 11345 w 21696"/>
              <a:gd name="connsiteY6" fmla="*/ 22331 h 29447"/>
              <a:gd name="connsiteX7" fmla="*/ 3476 w 21696"/>
              <a:gd name="connsiteY7" fmla="*/ 29447 h 29447"/>
              <a:gd name="connsiteX8" fmla="*/ 1 w 21696"/>
              <a:gd name="connsiteY8" fmla="*/ 18647 h 29447"/>
              <a:gd name="connsiteX9" fmla="*/ 3844 w 21696"/>
              <a:gd name="connsiteY9" fmla="*/ 5476 h 29447"/>
              <a:gd name="connsiteX0" fmla="*/ 3844 w 21696"/>
              <a:gd name="connsiteY0" fmla="*/ 5476 h 29447"/>
              <a:gd name="connsiteX1" fmla="*/ 13015 w 21696"/>
              <a:gd name="connsiteY1" fmla="*/ 0 h 29447"/>
              <a:gd name="connsiteX2" fmla="*/ 17382 w 21696"/>
              <a:gd name="connsiteY2" fmla="*/ 3369 h 29447"/>
              <a:gd name="connsiteX3" fmla="*/ 19815 w 21696"/>
              <a:gd name="connsiteY3" fmla="*/ 6434 h 29447"/>
              <a:gd name="connsiteX4" fmla="*/ 21601 w 21696"/>
              <a:gd name="connsiteY4" fmla="*/ 18647 h 29447"/>
              <a:gd name="connsiteX5" fmla="*/ 18126 w 21696"/>
              <a:gd name="connsiteY5" fmla="*/ 29447 h 29447"/>
              <a:gd name="connsiteX6" fmla="*/ 11345 w 21696"/>
              <a:gd name="connsiteY6" fmla="*/ 22331 h 29447"/>
              <a:gd name="connsiteX7" fmla="*/ 3476 w 21696"/>
              <a:gd name="connsiteY7" fmla="*/ 29447 h 29447"/>
              <a:gd name="connsiteX8" fmla="*/ 1 w 21696"/>
              <a:gd name="connsiteY8" fmla="*/ 18647 h 29447"/>
              <a:gd name="connsiteX9" fmla="*/ 3844 w 21696"/>
              <a:gd name="connsiteY9" fmla="*/ 5476 h 29447"/>
              <a:gd name="connsiteX0" fmla="*/ 2730 w 20582"/>
              <a:gd name="connsiteY0" fmla="*/ 5476 h 29447"/>
              <a:gd name="connsiteX1" fmla="*/ 11901 w 20582"/>
              <a:gd name="connsiteY1" fmla="*/ 0 h 29447"/>
              <a:gd name="connsiteX2" fmla="*/ 16268 w 20582"/>
              <a:gd name="connsiteY2" fmla="*/ 3369 h 29447"/>
              <a:gd name="connsiteX3" fmla="*/ 18701 w 20582"/>
              <a:gd name="connsiteY3" fmla="*/ 6434 h 29447"/>
              <a:gd name="connsiteX4" fmla="*/ 20487 w 20582"/>
              <a:gd name="connsiteY4" fmla="*/ 18647 h 29447"/>
              <a:gd name="connsiteX5" fmla="*/ 17012 w 20582"/>
              <a:gd name="connsiteY5" fmla="*/ 29447 h 29447"/>
              <a:gd name="connsiteX6" fmla="*/ 10231 w 20582"/>
              <a:gd name="connsiteY6" fmla="*/ 22331 h 29447"/>
              <a:gd name="connsiteX7" fmla="*/ 2362 w 20582"/>
              <a:gd name="connsiteY7" fmla="*/ 29447 h 29447"/>
              <a:gd name="connsiteX8" fmla="*/ 5 w 20582"/>
              <a:gd name="connsiteY8" fmla="*/ 18606 h 29447"/>
              <a:gd name="connsiteX9" fmla="*/ 2730 w 20582"/>
              <a:gd name="connsiteY9" fmla="*/ 5476 h 29447"/>
              <a:gd name="connsiteX0" fmla="*/ 2730 w 20695"/>
              <a:gd name="connsiteY0" fmla="*/ 5476 h 29447"/>
              <a:gd name="connsiteX1" fmla="*/ 11901 w 20695"/>
              <a:gd name="connsiteY1" fmla="*/ 0 h 29447"/>
              <a:gd name="connsiteX2" fmla="*/ 16268 w 20695"/>
              <a:gd name="connsiteY2" fmla="*/ 3369 h 29447"/>
              <a:gd name="connsiteX3" fmla="*/ 18701 w 20695"/>
              <a:gd name="connsiteY3" fmla="*/ 6434 h 29447"/>
              <a:gd name="connsiteX4" fmla="*/ 20131 w 20695"/>
              <a:gd name="connsiteY4" fmla="*/ 12304 h 29447"/>
              <a:gd name="connsiteX5" fmla="*/ 20487 w 20695"/>
              <a:gd name="connsiteY5" fmla="*/ 18647 h 29447"/>
              <a:gd name="connsiteX6" fmla="*/ 17012 w 20695"/>
              <a:gd name="connsiteY6" fmla="*/ 29447 h 29447"/>
              <a:gd name="connsiteX7" fmla="*/ 10231 w 20695"/>
              <a:gd name="connsiteY7" fmla="*/ 22331 h 29447"/>
              <a:gd name="connsiteX8" fmla="*/ 2362 w 20695"/>
              <a:gd name="connsiteY8" fmla="*/ 29447 h 29447"/>
              <a:gd name="connsiteX9" fmla="*/ 5 w 20695"/>
              <a:gd name="connsiteY9" fmla="*/ 18606 h 29447"/>
              <a:gd name="connsiteX10" fmla="*/ 2730 w 20695"/>
              <a:gd name="connsiteY10" fmla="*/ 5476 h 29447"/>
              <a:gd name="connsiteX0" fmla="*/ 2730 w 20346"/>
              <a:gd name="connsiteY0" fmla="*/ 5476 h 29447"/>
              <a:gd name="connsiteX1" fmla="*/ 11901 w 20346"/>
              <a:gd name="connsiteY1" fmla="*/ 0 h 29447"/>
              <a:gd name="connsiteX2" fmla="*/ 16268 w 20346"/>
              <a:gd name="connsiteY2" fmla="*/ 3369 h 29447"/>
              <a:gd name="connsiteX3" fmla="*/ 18701 w 20346"/>
              <a:gd name="connsiteY3" fmla="*/ 6434 h 29447"/>
              <a:gd name="connsiteX4" fmla="*/ 20131 w 20346"/>
              <a:gd name="connsiteY4" fmla="*/ 12304 h 29447"/>
              <a:gd name="connsiteX5" fmla="*/ 19943 w 20346"/>
              <a:gd name="connsiteY5" fmla="*/ 20205 h 29447"/>
              <a:gd name="connsiteX6" fmla="*/ 17012 w 20346"/>
              <a:gd name="connsiteY6" fmla="*/ 29447 h 29447"/>
              <a:gd name="connsiteX7" fmla="*/ 10231 w 20346"/>
              <a:gd name="connsiteY7" fmla="*/ 22331 h 29447"/>
              <a:gd name="connsiteX8" fmla="*/ 2362 w 20346"/>
              <a:gd name="connsiteY8" fmla="*/ 29447 h 29447"/>
              <a:gd name="connsiteX9" fmla="*/ 5 w 20346"/>
              <a:gd name="connsiteY9" fmla="*/ 18606 h 29447"/>
              <a:gd name="connsiteX10" fmla="*/ 2730 w 20346"/>
              <a:gd name="connsiteY10" fmla="*/ 5476 h 29447"/>
              <a:gd name="connsiteX0" fmla="*/ 2730 w 20286"/>
              <a:gd name="connsiteY0" fmla="*/ 5476 h 29447"/>
              <a:gd name="connsiteX1" fmla="*/ 11901 w 20286"/>
              <a:gd name="connsiteY1" fmla="*/ 0 h 29447"/>
              <a:gd name="connsiteX2" fmla="*/ 16268 w 20286"/>
              <a:gd name="connsiteY2" fmla="*/ 3369 h 29447"/>
              <a:gd name="connsiteX3" fmla="*/ 18701 w 20286"/>
              <a:gd name="connsiteY3" fmla="*/ 6434 h 29447"/>
              <a:gd name="connsiteX4" fmla="*/ 20131 w 20286"/>
              <a:gd name="connsiteY4" fmla="*/ 12304 h 29447"/>
              <a:gd name="connsiteX5" fmla="*/ 19943 w 20286"/>
              <a:gd name="connsiteY5" fmla="*/ 20205 h 29447"/>
              <a:gd name="connsiteX6" fmla="*/ 17012 w 20286"/>
              <a:gd name="connsiteY6" fmla="*/ 29447 h 29447"/>
              <a:gd name="connsiteX7" fmla="*/ 10231 w 20286"/>
              <a:gd name="connsiteY7" fmla="*/ 22331 h 29447"/>
              <a:gd name="connsiteX8" fmla="*/ 2362 w 20286"/>
              <a:gd name="connsiteY8" fmla="*/ 29447 h 29447"/>
              <a:gd name="connsiteX9" fmla="*/ 5 w 20286"/>
              <a:gd name="connsiteY9" fmla="*/ 18606 h 29447"/>
              <a:gd name="connsiteX10" fmla="*/ 2730 w 20286"/>
              <a:gd name="connsiteY10" fmla="*/ 5476 h 29447"/>
              <a:gd name="connsiteX0" fmla="*/ 2730 w 20163"/>
              <a:gd name="connsiteY0" fmla="*/ 5476 h 29447"/>
              <a:gd name="connsiteX1" fmla="*/ 11901 w 20163"/>
              <a:gd name="connsiteY1" fmla="*/ 0 h 29447"/>
              <a:gd name="connsiteX2" fmla="*/ 16268 w 20163"/>
              <a:gd name="connsiteY2" fmla="*/ 3369 h 29447"/>
              <a:gd name="connsiteX3" fmla="*/ 18701 w 20163"/>
              <a:gd name="connsiteY3" fmla="*/ 6434 h 29447"/>
              <a:gd name="connsiteX4" fmla="*/ 20131 w 20163"/>
              <a:gd name="connsiteY4" fmla="*/ 12304 h 29447"/>
              <a:gd name="connsiteX5" fmla="*/ 19943 w 20163"/>
              <a:gd name="connsiteY5" fmla="*/ 20205 h 29447"/>
              <a:gd name="connsiteX6" fmla="*/ 17012 w 20163"/>
              <a:gd name="connsiteY6" fmla="*/ 29447 h 29447"/>
              <a:gd name="connsiteX7" fmla="*/ 10231 w 20163"/>
              <a:gd name="connsiteY7" fmla="*/ 22331 h 29447"/>
              <a:gd name="connsiteX8" fmla="*/ 2362 w 20163"/>
              <a:gd name="connsiteY8" fmla="*/ 29447 h 29447"/>
              <a:gd name="connsiteX9" fmla="*/ 5 w 20163"/>
              <a:gd name="connsiteY9" fmla="*/ 18606 h 29447"/>
              <a:gd name="connsiteX10" fmla="*/ 2730 w 20163"/>
              <a:gd name="connsiteY10" fmla="*/ 5476 h 2944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20163" h="29447">
                <a:moveTo>
                  <a:pt x="2730" y="5476"/>
                </a:moveTo>
                <a:cubicBezTo>
                  <a:pt x="5473" y="2271"/>
                  <a:pt x="4420" y="706"/>
                  <a:pt x="11901" y="0"/>
                </a:cubicBezTo>
                <a:cubicBezTo>
                  <a:pt x="14466" y="1536"/>
                  <a:pt x="14833" y="2285"/>
                  <a:pt x="16268" y="3369"/>
                </a:cubicBezTo>
                <a:cubicBezTo>
                  <a:pt x="17079" y="4391"/>
                  <a:pt x="16078" y="2697"/>
                  <a:pt x="18701" y="6434"/>
                </a:cubicBezTo>
                <a:cubicBezTo>
                  <a:pt x="19373" y="7710"/>
                  <a:pt x="19833" y="10269"/>
                  <a:pt x="20131" y="12304"/>
                </a:cubicBezTo>
                <a:cubicBezTo>
                  <a:pt x="20145" y="20158"/>
                  <a:pt x="20263" y="15551"/>
                  <a:pt x="19943" y="20205"/>
                </a:cubicBezTo>
                <a:cubicBezTo>
                  <a:pt x="19623" y="24859"/>
                  <a:pt x="19048" y="27772"/>
                  <a:pt x="17012" y="29447"/>
                </a:cubicBezTo>
                <a:cubicBezTo>
                  <a:pt x="14099" y="29196"/>
                  <a:pt x="13144" y="22582"/>
                  <a:pt x="10231" y="22331"/>
                </a:cubicBezTo>
                <a:cubicBezTo>
                  <a:pt x="8260" y="22582"/>
                  <a:pt x="4333" y="29196"/>
                  <a:pt x="2362" y="29447"/>
                </a:cubicBezTo>
                <a:cubicBezTo>
                  <a:pt x="443" y="29447"/>
                  <a:pt x="-56" y="22601"/>
                  <a:pt x="5" y="18606"/>
                </a:cubicBezTo>
                <a:cubicBezTo>
                  <a:pt x="66" y="14611"/>
                  <a:pt x="772" y="8485"/>
                  <a:pt x="2730" y="5476"/>
                </a:cubicBezTo>
                <a:close/>
              </a:path>
            </a:pathLst>
          </a:cu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5186" tIns="47593" rIns="95186" bIns="47593" numCol="1" spcCol="0" rtlCol="0" fromWordArt="0" anchor="ctr" anchorCtr="0" forceAA="0" compatLnSpc="1">
            <a:prstTxWarp prst="textNoShape">
              <a:avLst/>
            </a:prstTxWarp>
            <a:noAutofit/>
          </a:bodyP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defTabSz="475945"/>
            <a:endParaRPr lang="en-GB" sz="1873" dirty="0">
              <a:solidFill>
                <a:prstClr val="white"/>
              </a:solidFill>
              <a:latin typeface="Calibri" panose="020F0502020204030204"/>
            </a:endParaRPr>
          </a:p>
        </p:txBody>
      </p:sp>
      <p:sp>
        <p:nvSpPr>
          <p:cNvPr id="24" name="Textfeld 23"/>
          <p:cNvSpPr txBox="1"/>
          <p:nvPr/>
        </p:nvSpPr>
        <p:spPr>
          <a:xfrm>
            <a:off x="192113" y="3166103"/>
            <a:ext cx="1459054" cy="369332"/>
          </a:xfrm>
          <a:prstGeom prst="rect">
            <a:avLst/>
          </a:prstGeom>
          <a:noFill/>
        </p:spPr>
        <p:txBody>
          <a:bodyPr wrap="none" rtlCol="0">
            <a:spAutoFit/>
          </a:bodyPr>
          <a:lstStyle/>
          <a:p>
            <a:r>
              <a:rPr lang="de-DE" dirty="0"/>
              <a:t>B. Breve EPS+</a:t>
            </a:r>
          </a:p>
        </p:txBody>
      </p:sp>
      <p:sp>
        <p:nvSpPr>
          <p:cNvPr id="25" name="Textfeld 24"/>
          <p:cNvSpPr txBox="1"/>
          <p:nvPr/>
        </p:nvSpPr>
        <p:spPr>
          <a:xfrm>
            <a:off x="2492633" y="2628952"/>
            <a:ext cx="521297" cy="369332"/>
          </a:xfrm>
          <a:prstGeom prst="rect">
            <a:avLst/>
          </a:prstGeom>
          <a:noFill/>
        </p:spPr>
        <p:txBody>
          <a:bodyPr wrap="none" rtlCol="0">
            <a:spAutoFit/>
          </a:bodyPr>
          <a:lstStyle/>
          <a:p>
            <a:r>
              <a:rPr lang="de-DE" dirty="0"/>
              <a:t>EPS</a:t>
            </a:r>
          </a:p>
        </p:txBody>
      </p:sp>
      <p:sp>
        <p:nvSpPr>
          <p:cNvPr id="26" name="Textfeld 25"/>
          <p:cNvSpPr txBox="1"/>
          <p:nvPr/>
        </p:nvSpPr>
        <p:spPr>
          <a:xfrm>
            <a:off x="3207658" y="4331895"/>
            <a:ext cx="1092992" cy="369332"/>
          </a:xfrm>
          <a:prstGeom prst="rect">
            <a:avLst/>
          </a:prstGeom>
          <a:noFill/>
        </p:spPr>
        <p:txBody>
          <a:bodyPr wrap="none" rtlCol="0">
            <a:spAutoFit/>
          </a:bodyPr>
          <a:lstStyle/>
          <a:p>
            <a:r>
              <a:rPr lang="en-GB" i="1" dirty="0" err="1"/>
              <a:t>Tyzzerella</a:t>
            </a:r>
            <a:endParaRPr lang="de-DE" dirty="0"/>
          </a:p>
        </p:txBody>
      </p:sp>
      <p:sp>
        <p:nvSpPr>
          <p:cNvPr id="32" name="Freihandform 31"/>
          <p:cNvSpPr/>
          <p:nvPr/>
        </p:nvSpPr>
        <p:spPr>
          <a:xfrm>
            <a:off x="3005138" y="1338263"/>
            <a:ext cx="309562" cy="61912"/>
          </a:xfrm>
          <a:custGeom>
            <a:avLst/>
            <a:gdLst>
              <a:gd name="connsiteX0" fmla="*/ 309562 w 309562"/>
              <a:gd name="connsiteY0" fmla="*/ 61912 h 61912"/>
              <a:gd name="connsiteX1" fmla="*/ 116681 w 309562"/>
              <a:gd name="connsiteY1" fmla="*/ 45243 h 61912"/>
              <a:gd name="connsiteX2" fmla="*/ 100012 w 309562"/>
              <a:gd name="connsiteY2" fmla="*/ 30956 h 61912"/>
              <a:gd name="connsiteX3" fmla="*/ 92868 w 309562"/>
              <a:gd name="connsiteY3" fmla="*/ 28575 h 61912"/>
              <a:gd name="connsiteX4" fmla="*/ 83343 w 309562"/>
              <a:gd name="connsiteY4" fmla="*/ 14287 h 61912"/>
              <a:gd name="connsiteX5" fmla="*/ 64293 w 309562"/>
              <a:gd name="connsiteY5" fmla="*/ 2381 h 61912"/>
              <a:gd name="connsiteX6" fmla="*/ 54768 w 309562"/>
              <a:gd name="connsiteY6" fmla="*/ 0 h 61912"/>
              <a:gd name="connsiteX7" fmla="*/ 28575 w 309562"/>
              <a:gd name="connsiteY7" fmla="*/ 4762 h 61912"/>
              <a:gd name="connsiteX8" fmla="*/ 14287 w 309562"/>
              <a:gd name="connsiteY8" fmla="*/ 9525 h 61912"/>
              <a:gd name="connsiteX9" fmla="*/ 7143 w 309562"/>
              <a:gd name="connsiteY9" fmla="*/ 14287 h 61912"/>
              <a:gd name="connsiteX10" fmla="*/ 0 w 309562"/>
              <a:gd name="connsiteY10" fmla="*/ 16668 h 619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309562" h="61912">
                <a:moveTo>
                  <a:pt x="309562" y="61912"/>
                </a:moveTo>
                <a:cubicBezTo>
                  <a:pt x="245268" y="56356"/>
                  <a:pt x="180772" y="52783"/>
                  <a:pt x="116681" y="45243"/>
                </a:cubicBezTo>
                <a:cubicBezTo>
                  <a:pt x="111415" y="44623"/>
                  <a:pt x="104062" y="33656"/>
                  <a:pt x="100012" y="30956"/>
                </a:cubicBezTo>
                <a:cubicBezTo>
                  <a:pt x="97923" y="29564"/>
                  <a:pt x="95249" y="29369"/>
                  <a:pt x="92868" y="28575"/>
                </a:cubicBezTo>
                <a:cubicBezTo>
                  <a:pt x="89693" y="23812"/>
                  <a:pt x="87922" y="17721"/>
                  <a:pt x="83343" y="14287"/>
                </a:cubicBezTo>
                <a:cubicBezTo>
                  <a:pt x="75850" y="8667"/>
                  <a:pt x="73011" y="5650"/>
                  <a:pt x="64293" y="2381"/>
                </a:cubicBezTo>
                <a:cubicBezTo>
                  <a:pt x="61229" y="1232"/>
                  <a:pt x="57943" y="794"/>
                  <a:pt x="54768" y="0"/>
                </a:cubicBezTo>
                <a:cubicBezTo>
                  <a:pt x="50103" y="778"/>
                  <a:pt x="33803" y="3336"/>
                  <a:pt x="28575" y="4762"/>
                </a:cubicBezTo>
                <a:cubicBezTo>
                  <a:pt x="23732" y="6083"/>
                  <a:pt x="18464" y="6740"/>
                  <a:pt x="14287" y="9525"/>
                </a:cubicBezTo>
                <a:cubicBezTo>
                  <a:pt x="11906" y="11112"/>
                  <a:pt x="9703" y="13007"/>
                  <a:pt x="7143" y="14287"/>
                </a:cubicBezTo>
                <a:cubicBezTo>
                  <a:pt x="4898" y="15409"/>
                  <a:pt x="0" y="16668"/>
                  <a:pt x="0" y="16668"/>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4" name="Freihandform 33"/>
          <p:cNvSpPr/>
          <p:nvPr/>
        </p:nvSpPr>
        <p:spPr>
          <a:xfrm>
            <a:off x="3117056" y="1228725"/>
            <a:ext cx="190500" cy="142875"/>
          </a:xfrm>
          <a:custGeom>
            <a:avLst/>
            <a:gdLst>
              <a:gd name="connsiteX0" fmla="*/ 190500 w 190500"/>
              <a:gd name="connsiteY0" fmla="*/ 142875 h 142875"/>
              <a:gd name="connsiteX1" fmla="*/ 178594 w 190500"/>
              <a:gd name="connsiteY1" fmla="*/ 140494 h 142875"/>
              <a:gd name="connsiteX2" fmla="*/ 161925 w 190500"/>
              <a:gd name="connsiteY2" fmla="*/ 138113 h 142875"/>
              <a:gd name="connsiteX3" fmla="*/ 152400 w 190500"/>
              <a:gd name="connsiteY3" fmla="*/ 130969 h 142875"/>
              <a:gd name="connsiteX4" fmla="*/ 147637 w 190500"/>
              <a:gd name="connsiteY4" fmla="*/ 116681 h 142875"/>
              <a:gd name="connsiteX5" fmla="*/ 142875 w 190500"/>
              <a:gd name="connsiteY5" fmla="*/ 100013 h 142875"/>
              <a:gd name="connsiteX6" fmla="*/ 140494 w 190500"/>
              <a:gd name="connsiteY6" fmla="*/ 85725 h 142875"/>
              <a:gd name="connsiteX7" fmla="*/ 138112 w 190500"/>
              <a:gd name="connsiteY7" fmla="*/ 69056 h 142875"/>
              <a:gd name="connsiteX8" fmla="*/ 133350 w 190500"/>
              <a:gd name="connsiteY8" fmla="*/ 61913 h 142875"/>
              <a:gd name="connsiteX9" fmla="*/ 119062 w 190500"/>
              <a:gd name="connsiteY9" fmla="*/ 57150 h 142875"/>
              <a:gd name="connsiteX10" fmla="*/ 28575 w 190500"/>
              <a:gd name="connsiteY10" fmla="*/ 59531 h 142875"/>
              <a:gd name="connsiteX11" fmla="*/ 23812 w 190500"/>
              <a:gd name="connsiteY11" fmla="*/ 50006 h 142875"/>
              <a:gd name="connsiteX12" fmla="*/ 19050 w 190500"/>
              <a:gd name="connsiteY12" fmla="*/ 42863 h 142875"/>
              <a:gd name="connsiteX13" fmla="*/ 9525 w 190500"/>
              <a:gd name="connsiteY13" fmla="*/ 26194 h 142875"/>
              <a:gd name="connsiteX14" fmla="*/ 7144 w 190500"/>
              <a:gd name="connsiteY14" fmla="*/ 19050 h 142875"/>
              <a:gd name="connsiteX15" fmla="*/ 2381 w 190500"/>
              <a:gd name="connsiteY15" fmla="*/ 11906 h 142875"/>
              <a:gd name="connsiteX16" fmla="*/ 0 w 190500"/>
              <a:gd name="connsiteY16" fmla="*/ 0 h 1428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190500" h="142875">
                <a:moveTo>
                  <a:pt x="190500" y="142875"/>
                </a:moveTo>
                <a:cubicBezTo>
                  <a:pt x="186531" y="142081"/>
                  <a:pt x="182586" y="141159"/>
                  <a:pt x="178594" y="140494"/>
                </a:cubicBezTo>
                <a:cubicBezTo>
                  <a:pt x="173058" y="139571"/>
                  <a:pt x="167200" y="140031"/>
                  <a:pt x="161925" y="138113"/>
                </a:cubicBezTo>
                <a:cubicBezTo>
                  <a:pt x="158195" y="136757"/>
                  <a:pt x="155575" y="133350"/>
                  <a:pt x="152400" y="130969"/>
                </a:cubicBezTo>
                <a:cubicBezTo>
                  <a:pt x="150812" y="126206"/>
                  <a:pt x="148854" y="121551"/>
                  <a:pt x="147637" y="116681"/>
                </a:cubicBezTo>
                <a:cubicBezTo>
                  <a:pt x="144647" y="104721"/>
                  <a:pt x="146291" y="110261"/>
                  <a:pt x="142875" y="100013"/>
                </a:cubicBezTo>
                <a:cubicBezTo>
                  <a:pt x="142081" y="95250"/>
                  <a:pt x="141228" y="90497"/>
                  <a:pt x="140494" y="85725"/>
                </a:cubicBezTo>
                <a:cubicBezTo>
                  <a:pt x="139640" y="80177"/>
                  <a:pt x="139725" y="74432"/>
                  <a:pt x="138112" y="69056"/>
                </a:cubicBezTo>
                <a:cubicBezTo>
                  <a:pt x="137290" y="66315"/>
                  <a:pt x="135777" y="63430"/>
                  <a:pt x="133350" y="61913"/>
                </a:cubicBezTo>
                <a:cubicBezTo>
                  <a:pt x="129093" y="59252"/>
                  <a:pt x="119062" y="57150"/>
                  <a:pt x="119062" y="57150"/>
                </a:cubicBezTo>
                <a:cubicBezTo>
                  <a:pt x="98734" y="58998"/>
                  <a:pt x="51713" y="65959"/>
                  <a:pt x="28575" y="59531"/>
                </a:cubicBezTo>
                <a:cubicBezTo>
                  <a:pt x="25155" y="58581"/>
                  <a:pt x="25573" y="53088"/>
                  <a:pt x="23812" y="50006"/>
                </a:cubicBezTo>
                <a:cubicBezTo>
                  <a:pt x="22392" y="47521"/>
                  <a:pt x="20637" y="45244"/>
                  <a:pt x="19050" y="42863"/>
                </a:cubicBezTo>
                <a:cubicBezTo>
                  <a:pt x="13591" y="26483"/>
                  <a:pt x="21058" y="46377"/>
                  <a:pt x="9525" y="26194"/>
                </a:cubicBezTo>
                <a:cubicBezTo>
                  <a:pt x="8280" y="24015"/>
                  <a:pt x="8267" y="21295"/>
                  <a:pt x="7144" y="19050"/>
                </a:cubicBezTo>
                <a:cubicBezTo>
                  <a:pt x="5864" y="16490"/>
                  <a:pt x="3969" y="14287"/>
                  <a:pt x="2381" y="11906"/>
                </a:cubicBezTo>
                <a:lnTo>
                  <a:pt x="0" y="0"/>
                </a:ln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5" name="Freihandform 34"/>
          <p:cNvSpPr/>
          <p:nvPr/>
        </p:nvSpPr>
        <p:spPr>
          <a:xfrm>
            <a:off x="2983706" y="1283494"/>
            <a:ext cx="333375" cy="66675"/>
          </a:xfrm>
          <a:custGeom>
            <a:avLst/>
            <a:gdLst>
              <a:gd name="connsiteX0" fmla="*/ 333375 w 333375"/>
              <a:gd name="connsiteY0" fmla="*/ 66675 h 66675"/>
              <a:gd name="connsiteX1" fmla="*/ 330994 w 333375"/>
              <a:gd name="connsiteY1" fmla="*/ 42862 h 66675"/>
              <a:gd name="connsiteX2" fmla="*/ 321469 w 333375"/>
              <a:gd name="connsiteY2" fmla="*/ 35719 h 66675"/>
              <a:gd name="connsiteX3" fmla="*/ 304800 w 333375"/>
              <a:gd name="connsiteY3" fmla="*/ 28575 h 66675"/>
              <a:gd name="connsiteX4" fmla="*/ 285750 w 333375"/>
              <a:gd name="connsiteY4" fmla="*/ 26194 h 66675"/>
              <a:gd name="connsiteX5" fmla="*/ 107157 w 333375"/>
              <a:gd name="connsiteY5" fmla="*/ 28575 h 66675"/>
              <a:gd name="connsiteX6" fmla="*/ 97632 w 333375"/>
              <a:gd name="connsiteY6" fmla="*/ 23812 h 66675"/>
              <a:gd name="connsiteX7" fmla="*/ 85725 w 333375"/>
              <a:gd name="connsiteY7" fmla="*/ 21431 h 66675"/>
              <a:gd name="connsiteX8" fmla="*/ 73819 w 333375"/>
              <a:gd name="connsiteY8" fmla="*/ 16669 h 66675"/>
              <a:gd name="connsiteX9" fmla="*/ 57150 w 333375"/>
              <a:gd name="connsiteY9" fmla="*/ 4762 h 66675"/>
              <a:gd name="connsiteX10" fmla="*/ 40482 w 333375"/>
              <a:gd name="connsiteY10" fmla="*/ 2381 h 66675"/>
              <a:gd name="connsiteX11" fmla="*/ 0 w 333375"/>
              <a:gd name="connsiteY11" fmla="*/ 0 h 666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333375" h="66675">
                <a:moveTo>
                  <a:pt x="333375" y="66675"/>
                </a:moveTo>
                <a:cubicBezTo>
                  <a:pt x="332581" y="58737"/>
                  <a:pt x="333858" y="50308"/>
                  <a:pt x="330994" y="42862"/>
                </a:cubicBezTo>
                <a:cubicBezTo>
                  <a:pt x="329569" y="39158"/>
                  <a:pt x="324834" y="37822"/>
                  <a:pt x="321469" y="35719"/>
                </a:cubicBezTo>
                <a:cubicBezTo>
                  <a:pt x="318098" y="33612"/>
                  <a:pt x="309372" y="29406"/>
                  <a:pt x="304800" y="28575"/>
                </a:cubicBezTo>
                <a:cubicBezTo>
                  <a:pt x="298504" y="27430"/>
                  <a:pt x="292100" y="26988"/>
                  <a:pt x="285750" y="26194"/>
                </a:cubicBezTo>
                <a:cubicBezTo>
                  <a:pt x="228600" y="28575"/>
                  <a:pt x="165366" y="34208"/>
                  <a:pt x="107157" y="28575"/>
                </a:cubicBezTo>
                <a:cubicBezTo>
                  <a:pt x="103624" y="28233"/>
                  <a:pt x="101000" y="24935"/>
                  <a:pt x="97632" y="23812"/>
                </a:cubicBezTo>
                <a:cubicBezTo>
                  <a:pt x="93792" y="22532"/>
                  <a:pt x="89694" y="22225"/>
                  <a:pt x="85725" y="21431"/>
                </a:cubicBezTo>
                <a:cubicBezTo>
                  <a:pt x="81756" y="19844"/>
                  <a:pt x="77444" y="18934"/>
                  <a:pt x="73819" y="16669"/>
                </a:cubicBezTo>
                <a:cubicBezTo>
                  <a:pt x="61562" y="9009"/>
                  <a:pt x="72431" y="8930"/>
                  <a:pt x="57150" y="4762"/>
                </a:cubicBezTo>
                <a:cubicBezTo>
                  <a:pt x="51735" y="3285"/>
                  <a:pt x="46075" y="2847"/>
                  <a:pt x="40482" y="2381"/>
                </a:cubicBezTo>
                <a:cubicBezTo>
                  <a:pt x="27011" y="1259"/>
                  <a:pt x="0" y="0"/>
                  <a:pt x="0" y="0"/>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6" name="Freihandform 35"/>
          <p:cNvSpPr/>
          <p:nvPr/>
        </p:nvSpPr>
        <p:spPr>
          <a:xfrm>
            <a:off x="3588544" y="1209675"/>
            <a:ext cx="40481" cy="95250"/>
          </a:xfrm>
          <a:custGeom>
            <a:avLst/>
            <a:gdLst>
              <a:gd name="connsiteX0" fmla="*/ 40481 w 40481"/>
              <a:gd name="connsiteY0" fmla="*/ 95250 h 95250"/>
              <a:gd name="connsiteX1" fmla="*/ 0 w 40481"/>
              <a:gd name="connsiteY1" fmla="*/ 0 h 95250"/>
            </a:gdLst>
            <a:ahLst/>
            <a:cxnLst>
              <a:cxn ang="0">
                <a:pos x="connsiteX0" y="connsiteY0"/>
              </a:cxn>
              <a:cxn ang="0">
                <a:pos x="connsiteX1" y="connsiteY1"/>
              </a:cxn>
            </a:cxnLst>
            <a:rect l="l" t="t" r="r" b="b"/>
            <a:pathLst>
              <a:path w="40481" h="95250">
                <a:moveTo>
                  <a:pt x="40481" y="95250"/>
                </a:moveTo>
                <a:lnTo>
                  <a:pt x="0" y="0"/>
                </a:ln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8" name="Freihandform 37"/>
          <p:cNvSpPr/>
          <p:nvPr/>
        </p:nvSpPr>
        <p:spPr>
          <a:xfrm>
            <a:off x="3728563" y="1509713"/>
            <a:ext cx="45719" cy="59294"/>
          </a:xfrm>
          <a:custGeom>
            <a:avLst/>
            <a:gdLst>
              <a:gd name="connsiteX0" fmla="*/ 66675 w 66675"/>
              <a:gd name="connsiteY0" fmla="*/ 0 h 42863"/>
              <a:gd name="connsiteX1" fmla="*/ 0 w 66675"/>
              <a:gd name="connsiteY1" fmla="*/ 42863 h 42863"/>
            </a:gdLst>
            <a:ahLst/>
            <a:cxnLst>
              <a:cxn ang="0">
                <a:pos x="connsiteX0" y="connsiteY0"/>
              </a:cxn>
              <a:cxn ang="0">
                <a:pos x="connsiteX1" y="connsiteY1"/>
              </a:cxn>
            </a:cxnLst>
            <a:rect l="l" t="t" r="r" b="b"/>
            <a:pathLst>
              <a:path w="66675" h="42863">
                <a:moveTo>
                  <a:pt x="66675" y="0"/>
                </a:moveTo>
                <a:lnTo>
                  <a:pt x="0" y="42863"/>
                </a:ln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1" name="Freihandform 40"/>
          <p:cNvSpPr/>
          <p:nvPr/>
        </p:nvSpPr>
        <p:spPr>
          <a:xfrm>
            <a:off x="3338513" y="1469231"/>
            <a:ext cx="59531" cy="90488"/>
          </a:xfrm>
          <a:custGeom>
            <a:avLst/>
            <a:gdLst>
              <a:gd name="connsiteX0" fmla="*/ 59531 w 59531"/>
              <a:gd name="connsiteY0" fmla="*/ 0 h 90488"/>
              <a:gd name="connsiteX1" fmla="*/ 2381 w 59531"/>
              <a:gd name="connsiteY1" fmla="*/ 47625 h 90488"/>
              <a:gd name="connsiteX2" fmla="*/ 4762 w 59531"/>
              <a:gd name="connsiteY2" fmla="*/ 69057 h 90488"/>
              <a:gd name="connsiteX3" fmla="*/ 11906 w 59531"/>
              <a:gd name="connsiteY3" fmla="*/ 73819 h 90488"/>
              <a:gd name="connsiteX4" fmla="*/ 11906 w 59531"/>
              <a:gd name="connsiteY4" fmla="*/ 90488 h 90488"/>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9531" h="90488">
                <a:moveTo>
                  <a:pt x="59531" y="0"/>
                </a:moveTo>
                <a:cubicBezTo>
                  <a:pt x="40481" y="15875"/>
                  <a:pt x="20630" y="30836"/>
                  <a:pt x="2381" y="47625"/>
                </a:cubicBezTo>
                <a:cubicBezTo>
                  <a:pt x="-2705" y="52304"/>
                  <a:pt x="1441" y="66843"/>
                  <a:pt x="4762" y="69057"/>
                </a:cubicBezTo>
                <a:cubicBezTo>
                  <a:pt x="7143" y="70644"/>
                  <a:pt x="11001" y="71104"/>
                  <a:pt x="11906" y="73819"/>
                </a:cubicBezTo>
                <a:cubicBezTo>
                  <a:pt x="13663" y="79090"/>
                  <a:pt x="11906" y="84932"/>
                  <a:pt x="11906" y="90488"/>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2" name="Freihandform 41"/>
          <p:cNvSpPr/>
          <p:nvPr/>
        </p:nvSpPr>
        <p:spPr>
          <a:xfrm>
            <a:off x="3890963" y="1226344"/>
            <a:ext cx="26327" cy="83344"/>
          </a:xfrm>
          <a:custGeom>
            <a:avLst/>
            <a:gdLst>
              <a:gd name="connsiteX0" fmla="*/ 0 w 26327"/>
              <a:gd name="connsiteY0" fmla="*/ 83344 h 83344"/>
              <a:gd name="connsiteX1" fmla="*/ 23812 w 26327"/>
              <a:gd name="connsiteY1" fmla="*/ 2381 h 83344"/>
              <a:gd name="connsiteX2" fmla="*/ 23812 w 26327"/>
              <a:gd name="connsiteY2" fmla="*/ 0 h 83344"/>
            </a:gdLst>
            <a:ahLst/>
            <a:cxnLst>
              <a:cxn ang="0">
                <a:pos x="connsiteX0" y="connsiteY0"/>
              </a:cxn>
              <a:cxn ang="0">
                <a:pos x="connsiteX1" y="connsiteY1"/>
              </a:cxn>
              <a:cxn ang="0">
                <a:pos x="connsiteX2" y="connsiteY2"/>
              </a:cxn>
            </a:cxnLst>
            <a:rect l="l" t="t" r="r" b="b"/>
            <a:pathLst>
              <a:path w="26327" h="83344">
                <a:moveTo>
                  <a:pt x="0" y="83344"/>
                </a:moveTo>
                <a:cubicBezTo>
                  <a:pt x="30261" y="14566"/>
                  <a:pt x="28198" y="46243"/>
                  <a:pt x="23812" y="2381"/>
                </a:cubicBezTo>
                <a:cubicBezTo>
                  <a:pt x="23733" y="1591"/>
                  <a:pt x="23812" y="794"/>
                  <a:pt x="23812" y="0"/>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4" name="Freihandform 43"/>
          <p:cNvSpPr/>
          <p:nvPr/>
        </p:nvSpPr>
        <p:spPr>
          <a:xfrm>
            <a:off x="3773357" y="1276265"/>
            <a:ext cx="15212" cy="50091"/>
          </a:xfrm>
          <a:custGeom>
            <a:avLst/>
            <a:gdLst>
              <a:gd name="connsiteX0" fmla="*/ 924 w 15212"/>
              <a:gd name="connsiteY0" fmla="*/ 50091 h 50091"/>
              <a:gd name="connsiteX1" fmla="*/ 12831 w 15212"/>
              <a:gd name="connsiteY1" fmla="*/ 85 h 50091"/>
              <a:gd name="connsiteX2" fmla="*/ 15212 w 15212"/>
              <a:gd name="connsiteY2" fmla="*/ 85 h 50091"/>
            </a:gdLst>
            <a:ahLst/>
            <a:cxnLst>
              <a:cxn ang="0">
                <a:pos x="connsiteX0" y="connsiteY0"/>
              </a:cxn>
              <a:cxn ang="0">
                <a:pos x="connsiteX1" y="connsiteY1"/>
              </a:cxn>
              <a:cxn ang="0">
                <a:pos x="connsiteX2" y="connsiteY2"/>
              </a:cxn>
            </a:cxnLst>
            <a:rect l="l" t="t" r="r" b="b"/>
            <a:pathLst>
              <a:path w="15212" h="50091">
                <a:moveTo>
                  <a:pt x="924" y="50091"/>
                </a:moveTo>
                <a:cubicBezTo>
                  <a:pt x="4727" y="12069"/>
                  <a:pt x="-9258" y="5607"/>
                  <a:pt x="12831" y="85"/>
                </a:cubicBezTo>
                <a:cubicBezTo>
                  <a:pt x="13601" y="-107"/>
                  <a:pt x="14418" y="85"/>
                  <a:pt x="15212" y="85"/>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5" name="Freihandform 44"/>
          <p:cNvSpPr/>
          <p:nvPr/>
        </p:nvSpPr>
        <p:spPr>
          <a:xfrm>
            <a:off x="4071938" y="1209675"/>
            <a:ext cx="50006" cy="61913"/>
          </a:xfrm>
          <a:custGeom>
            <a:avLst/>
            <a:gdLst>
              <a:gd name="connsiteX0" fmla="*/ 0 w 50006"/>
              <a:gd name="connsiteY0" fmla="*/ 61913 h 61913"/>
              <a:gd name="connsiteX1" fmla="*/ 50006 w 50006"/>
              <a:gd name="connsiteY1" fmla="*/ 0 h 61913"/>
            </a:gdLst>
            <a:ahLst/>
            <a:cxnLst>
              <a:cxn ang="0">
                <a:pos x="connsiteX0" y="connsiteY0"/>
              </a:cxn>
              <a:cxn ang="0">
                <a:pos x="connsiteX1" y="connsiteY1"/>
              </a:cxn>
            </a:cxnLst>
            <a:rect l="l" t="t" r="r" b="b"/>
            <a:pathLst>
              <a:path w="50006" h="61913">
                <a:moveTo>
                  <a:pt x="0" y="61913"/>
                </a:moveTo>
                <a:cubicBezTo>
                  <a:pt x="48109" y="-629"/>
                  <a:pt x="21588" y="0"/>
                  <a:pt x="50006" y="0"/>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7" name="Freihandform 46"/>
          <p:cNvSpPr/>
          <p:nvPr/>
        </p:nvSpPr>
        <p:spPr>
          <a:xfrm>
            <a:off x="3459956" y="1231106"/>
            <a:ext cx="38415" cy="52388"/>
          </a:xfrm>
          <a:custGeom>
            <a:avLst/>
            <a:gdLst>
              <a:gd name="connsiteX0" fmla="*/ 0 w 38415"/>
              <a:gd name="connsiteY0" fmla="*/ 52388 h 52388"/>
              <a:gd name="connsiteX1" fmla="*/ 2382 w 38415"/>
              <a:gd name="connsiteY1" fmla="*/ 14288 h 52388"/>
              <a:gd name="connsiteX2" fmla="*/ 9525 w 38415"/>
              <a:gd name="connsiteY2" fmla="*/ 11907 h 52388"/>
              <a:gd name="connsiteX3" fmla="*/ 16669 w 38415"/>
              <a:gd name="connsiteY3" fmla="*/ 7144 h 52388"/>
              <a:gd name="connsiteX4" fmla="*/ 38100 w 38415"/>
              <a:gd name="connsiteY4" fmla="*/ 2382 h 52388"/>
              <a:gd name="connsiteX5" fmla="*/ 38100 w 38415"/>
              <a:gd name="connsiteY5" fmla="*/ 0 h 523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8415" h="52388">
                <a:moveTo>
                  <a:pt x="0" y="52388"/>
                </a:moveTo>
                <a:cubicBezTo>
                  <a:pt x="794" y="39688"/>
                  <a:pt x="-532" y="26675"/>
                  <a:pt x="2382" y="14288"/>
                </a:cubicBezTo>
                <a:cubicBezTo>
                  <a:pt x="2957" y="11845"/>
                  <a:pt x="7280" y="13029"/>
                  <a:pt x="9525" y="11907"/>
                </a:cubicBezTo>
                <a:cubicBezTo>
                  <a:pt x="12085" y="10627"/>
                  <a:pt x="13989" y="8149"/>
                  <a:pt x="16669" y="7144"/>
                </a:cubicBezTo>
                <a:cubicBezTo>
                  <a:pt x="19672" y="6018"/>
                  <a:pt x="34442" y="4211"/>
                  <a:pt x="38100" y="2382"/>
                </a:cubicBezTo>
                <a:cubicBezTo>
                  <a:pt x="38810" y="2027"/>
                  <a:pt x="38100" y="794"/>
                  <a:pt x="38100" y="0"/>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9" name="Freihandform 48"/>
          <p:cNvSpPr/>
          <p:nvPr/>
        </p:nvSpPr>
        <p:spPr>
          <a:xfrm>
            <a:off x="3990975" y="1481138"/>
            <a:ext cx="59060" cy="71437"/>
          </a:xfrm>
          <a:custGeom>
            <a:avLst/>
            <a:gdLst>
              <a:gd name="connsiteX0" fmla="*/ 0 w 59060"/>
              <a:gd name="connsiteY0" fmla="*/ 0 h 71437"/>
              <a:gd name="connsiteX1" fmla="*/ 57150 w 59060"/>
              <a:gd name="connsiteY1" fmla="*/ 35718 h 71437"/>
              <a:gd name="connsiteX2" fmla="*/ 54769 w 59060"/>
              <a:gd name="connsiteY2" fmla="*/ 57150 h 71437"/>
              <a:gd name="connsiteX3" fmla="*/ 52388 w 59060"/>
              <a:gd name="connsiteY3" fmla="*/ 64293 h 71437"/>
              <a:gd name="connsiteX4" fmla="*/ 45244 w 59060"/>
              <a:gd name="connsiteY4" fmla="*/ 69056 h 71437"/>
              <a:gd name="connsiteX5" fmla="*/ 38100 w 59060"/>
              <a:gd name="connsiteY5" fmla="*/ 71437 h 7143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9060" h="71437">
                <a:moveTo>
                  <a:pt x="0" y="0"/>
                </a:moveTo>
                <a:cubicBezTo>
                  <a:pt x="19050" y="11906"/>
                  <a:pt x="41607" y="19499"/>
                  <a:pt x="57150" y="35718"/>
                </a:cubicBezTo>
                <a:cubicBezTo>
                  <a:pt x="62123" y="40908"/>
                  <a:pt x="55951" y="50060"/>
                  <a:pt x="54769" y="57150"/>
                </a:cubicBezTo>
                <a:cubicBezTo>
                  <a:pt x="54356" y="59626"/>
                  <a:pt x="53956" y="62333"/>
                  <a:pt x="52388" y="64293"/>
                </a:cubicBezTo>
                <a:cubicBezTo>
                  <a:pt x="50600" y="66528"/>
                  <a:pt x="47804" y="67776"/>
                  <a:pt x="45244" y="69056"/>
                </a:cubicBezTo>
                <a:cubicBezTo>
                  <a:pt x="42999" y="70179"/>
                  <a:pt x="38100" y="71437"/>
                  <a:pt x="38100" y="71437"/>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1" name="Freihandform 50"/>
          <p:cNvSpPr/>
          <p:nvPr/>
        </p:nvSpPr>
        <p:spPr>
          <a:xfrm>
            <a:off x="4174331" y="1331894"/>
            <a:ext cx="83344" cy="20656"/>
          </a:xfrm>
          <a:custGeom>
            <a:avLst/>
            <a:gdLst>
              <a:gd name="connsiteX0" fmla="*/ 0 w 83344"/>
              <a:gd name="connsiteY0" fmla="*/ 20656 h 20656"/>
              <a:gd name="connsiteX1" fmla="*/ 7144 w 83344"/>
              <a:gd name="connsiteY1" fmla="*/ 8750 h 20656"/>
              <a:gd name="connsiteX2" fmla="*/ 30957 w 83344"/>
              <a:gd name="connsiteY2" fmla="*/ 1606 h 20656"/>
              <a:gd name="connsiteX3" fmla="*/ 80963 w 83344"/>
              <a:gd name="connsiteY3" fmla="*/ 11131 h 20656"/>
              <a:gd name="connsiteX4" fmla="*/ 83344 w 83344"/>
              <a:gd name="connsiteY4" fmla="*/ 13512 h 2065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83344" h="20656">
                <a:moveTo>
                  <a:pt x="0" y="20656"/>
                </a:moveTo>
                <a:cubicBezTo>
                  <a:pt x="2381" y="16687"/>
                  <a:pt x="3661" y="11798"/>
                  <a:pt x="7144" y="8750"/>
                </a:cubicBezTo>
                <a:cubicBezTo>
                  <a:pt x="11787" y="4687"/>
                  <a:pt x="25295" y="2738"/>
                  <a:pt x="30957" y="1606"/>
                </a:cubicBezTo>
                <a:cubicBezTo>
                  <a:pt x="88078" y="4612"/>
                  <a:pt x="66113" y="-8668"/>
                  <a:pt x="80963" y="11131"/>
                </a:cubicBezTo>
                <a:cubicBezTo>
                  <a:pt x="81636" y="12029"/>
                  <a:pt x="82550" y="12718"/>
                  <a:pt x="83344" y="13512"/>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2" name="Freihandform 51"/>
          <p:cNvSpPr/>
          <p:nvPr/>
        </p:nvSpPr>
        <p:spPr>
          <a:xfrm>
            <a:off x="4136231" y="1428750"/>
            <a:ext cx="28575" cy="64294"/>
          </a:xfrm>
          <a:custGeom>
            <a:avLst/>
            <a:gdLst>
              <a:gd name="connsiteX0" fmla="*/ 0 w 28575"/>
              <a:gd name="connsiteY0" fmla="*/ 0 h 64294"/>
              <a:gd name="connsiteX1" fmla="*/ 16669 w 28575"/>
              <a:gd name="connsiteY1" fmla="*/ 38100 h 64294"/>
              <a:gd name="connsiteX2" fmla="*/ 19050 w 28575"/>
              <a:gd name="connsiteY2" fmla="*/ 57150 h 64294"/>
              <a:gd name="connsiteX3" fmla="*/ 26194 w 28575"/>
              <a:gd name="connsiteY3" fmla="*/ 61913 h 64294"/>
              <a:gd name="connsiteX4" fmla="*/ 28575 w 28575"/>
              <a:gd name="connsiteY4" fmla="*/ 64294 h 6429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8575" h="64294">
                <a:moveTo>
                  <a:pt x="0" y="0"/>
                </a:moveTo>
                <a:cubicBezTo>
                  <a:pt x="5556" y="12700"/>
                  <a:pt x="12285" y="24949"/>
                  <a:pt x="16669" y="38100"/>
                </a:cubicBezTo>
                <a:cubicBezTo>
                  <a:pt x="18693" y="44171"/>
                  <a:pt x="16673" y="51208"/>
                  <a:pt x="19050" y="57150"/>
                </a:cubicBezTo>
                <a:cubicBezTo>
                  <a:pt x="20113" y="59807"/>
                  <a:pt x="23904" y="60196"/>
                  <a:pt x="26194" y="61913"/>
                </a:cubicBezTo>
                <a:cubicBezTo>
                  <a:pt x="27092" y="62586"/>
                  <a:pt x="27781" y="63500"/>
                  <a:pt x="28575" y="64294"/>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3" name="Freihandform 52"/>
          <p:cNvSpPr/>
          <p:nvPr/>
        </p:nvSpPr>
        <p:spPr>
          <a:xfrm>
            <a:off x="3886086" y="1507229"/>
            <a:ext cx="9076" cy="36529"/>
          </a:xfrm>
          <a:custGeom>
            <a:avLst/>
            <a:gdLst>
              <a:gd name="connsiteX0" fmla="*/ 7258 w 9076"/>
              <a:gd name="connsiteY0" fmla="*/ 102 h 36529"/>
              <a:gd name="connsiteX1" fmla="*/ 114 w 9076"/>
              <a:gd name="connsiteY1" fmla="*/ 23915 h 36529"/>
              <a:gd name="connsiteX2" fmla="*/ 2495 w 9076"/>
              <a:gd name="connsiteY2" fmla="*/ 33440 h 36529"/>
              <a:gd name="connsiteX3" fmla="*/ 7258 w 9076"/>
              <a:gd name="connsiteY3" fmla="*/ 102 h 36529"/>
            </a:gdLst>
            <a:ahLst/>
            <a:cxnLst>
              <a:cxn ang="0">
                <a:pos x="connsiteX0" y="connsiteY0"/>
              </a:cxn>
              <a:cxn ang="0">
                <a:pos x="connsiteX1" y="connsiteY1"/>
              </a:cxn>
              <a:cxn ang="0">
                <a:pos x="connsiteX2" y="connsiteY2"/>
              </a:cxn>
              <a:cxn ang="0">
                <a:pos x="connsiteX3" y="connsiteY3"/>
              </a:cxn>
            </a:cxnLst>
            <a:rect l="l" t="t" r="r" b="b"/>
            <a:pathLst>
              <a:path w="9076" h="36529">
                <a:moveTo>
                  <a:pt x="7258" y="102"/>
                </a:moveTo>
                <a:cubicBezTo>
                  <a:pt x="6861" y="-1485"/>
                  <a:pt x="1286" y="15711"/>
                  <a:pt x="114" y="23915"/>
                </a:cubicBezTo>
                <a:cubicBezTo>
                  <a:pt x="-349" y="27155"/>
                  <a:pt x="618" y="30759"/>
                  <a:pt x="2495" y="33440"/>
                </a:cubicBezTo>
                <a:cubicBezTo>
                  <a:pt x="13282" y="48849"/>
                  <a:pt x="7655" y="1689"/>
                  <a:pt x="7258" y="102"/>
                </a:cubicBezTo>
                <a:close/>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5" name="Freihandform 54"/>
          <p:cNvSpPr/>
          <p:nvPr/>
        </p:nvSpPr>
        <p:spPr>
          <a:xfrm>
            <a:off x="3552820" y="1495428"/>
            <a:ext cx="26327" cy="83344"/>
          </a:xfrm>
          <a:custGeom>
            <a:avLst/>
            <a:gdLst>
              <a:gd name="connsiteX0" fmla="*/ 0 w 26327"/>
              <a:gd name="connsiteY0" fmla="*/ 83344 h 83344"/>
              <a:gd name="connsiteX1" fmla="*/ 23812 w 26327"/>
              <a:gd name="connsiteY1" fmla="*/ 2381 h 83344"/>
              <a:gd name="connsiteX2" fmla="*/ 23812 w 26327"/>
              <a:gd name="connsiteY2" fmla="*/ 0 h 83344"/>
            </a:gdLst>
            <a:ahLst/>
            <a:cxnLst>
              <a:cxn ang="0">
                <a:pos x="connsiteX0" y="connsiteY0"/>
              </a:cxn>
              <a:cxn ang="0">
                <a:pos x="connsiteX1" y="connsiteY1"/>
              </a:cxn>
              <a:cxn ang="0">
                <a:pos x="connsiteX2" y="connsiteY2"/>
              </a:cxn>
            </a:cxnLst>
            <a:rect l="l" t="t" r="r" b="b"/>
            <a:pathLst>
              <a:path w="26327" h="83344">
                <a:moveTo>
                  <a:pt x="0" y="83344"/>
                </a:moveTo>
                <a:cubicBezTo>
                  <a:pt x="30261" y="14566"/>
                  <a:pt x="28198" y="46243"/>
                  <a:pt x="23812" y="2381"/>
                </a:cubicBezTo>
                <a:cubicBezTo>
                  <a:pt x="23733" y="1591"/>
                  <a:pt x="23812" y="794"/>
                  <a:pt x="23812" y="0"/>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6" name="Rechteck 55"/>
          <p:cNvSpPr/>
          <p:nvPr/>
        </p:nvSpPr>
        <p:spPr>
          <a:xfrm>
            <a:off x="4608911" y="1291112"/>
            <a:ext cx="1248231" cy="668974"/>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r>
              <a:rPr lang="de-DE" dirty="0">
                <a:solidFill>
                  <a:schemeClr val="tx1"/>
                </a:solidFill>
              </a:rPr>
              <a:t>N-</a:t>
            </a:r>
            <a:r>
              <a:rPr lang="de-DE" dirty="0" err="1">
                <a:solidFill>
                  <a:schemeClr val="tx1"/>
                </a:solidFill>
              </a:rPr>
              <a:t>acetyl</a:t>
            </a:r>
            <a:r>
              <a:rPr lang="de-DE" dirty="0">
                <a:solidFill>
                  <a:schemeClr val="tx1"/>
                </a:solidFill>
              </a:rPr>
              <a:t>-</a:t>
            </a:r>
            <a:r>
              <a:rPr lang="de-DE" dirty="0" err="1">
                <a:solidFill>
                  <a:schemeClr val="tx1"/>
                </a:solidFill>
              </a:rPr>
              <a:t>aspartate</a:t>
            </a:r>
            <a:endParaRPr lang="de-DE" dirty="0">
              <a:solidFill>
                <a:schemeClr val="tx1"/>
              </a:solidFill>
            </a:endParaRPr>
          </a:p>
        </p:txBody>
      </p:sp>
      <p:sp>
        <p:nvSpPr>
          <p:cNvPr id="57" name="Rechteck 56"/>
          <p:cNvSpPr/>
          <p:nvPr/>
        </p:nvSpPr>
        <p:spPr>
          <a:xfrm>
            <a:off x="4608910" y="3648616"/>
            <a:ext cx="1248231" cy="668974"/>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r>
              <a:rPr lang="de-DE" dirty="0">
                <a:solidFill>
                  <a:schemeClr val="tx1"/>
                </a:solidFill>
              </a:rPr>
              <a:t>Formate</a:t>
            </a:r>
          </a:p>
        </p:txBody>
      </p:sp>
      <p:cxnSp>
        <p:nvCxnSpPr>
          <p:cNvPr id="70" name="Gewinkelter Verbinder 69"/>
          <p:cNvCxnSpPr/>
          <p:nvPr/>
        </p:nvCxnSpPr>
        <p:spPr>
          <a:xfrm>
            <a:off x="5937021" y="1625599"/>
            <a:ext cx="1275785" cy="1194444"/>
          </a:xfrm>
          <a:prstGeom prst="bentConnector3">
            <a:avLst>
              <a:gd name="adj1" fmla="val 50000"/>
            </a:avLst>
          </a:prstGeom>
          <a:ln w="28575">
            <a:headEnd type="none" w="med" len="med"/>
            <a:tailEnd type="none" w="med" len="med"/>
          </a:ln>
        </p:spPr>
        <p:style>
          <a:lnRef idx="1">
            <a:schemeClr val="dk1"/>
          </a:lnRef>
          <a:fillRef idx="0">
            <a:schemeClr val="dk1"/>
          </a:fillRef>
          <a:effectRef idx="0">
            <a:schemeClr val="dk1"/>
          </a:effectRef>
          <a:fontRef idx="minor">
            <a:schemeClr val="tx1"/>
          </a:fontRef>
        </p:style>
      </p:cxnSp>
      <p:cxnSp>
        <p:nvCxnSpPr>
          <p:cNvPr id="73" name="Gewinkelter Verbinder 72"/>
          <p:cNvCxnSpPr/>
          <p:nvPr/>
        </p:nvCxnSpPr>
        <p:spPr>
          <a:xfrm flipV="1">
            <a:off x="5915066" y="2820043"/>
            <a:ext cx="1316790" cy="1185537"/>
          </a:xfrm>
          <a:prstGeom prst="bentConnector3">
            <a:avLst>
              <a:gd name="adj1" fmla="val 50181"/>
            </a:avLst>
          </a:prstGeom>
          <a:ln w="285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79" name="Textfeld 78"/>
          <p:cNvSpPr txBox="1"/>
          <p:nvPr/>
        </p:nvSpPr>
        <p:spPr>
          <a:xfrm>
            <a:off x="6569950" y="2134171"/>
            <a:ext cx="1786964" cy="369332"/>
          </a:xfrm>
          <a:prstGeom prst="rect">
            <a:avLst/>
          </a:prstGeom>
          <a:noFill/>
        </p:spPr>
        <p:txBody>
          <a:bodyPr wrap="none" rtlCol="0">
            <a:spAutoFit/>
          </a:bodyPr>
          <a:lstStyle/>
          <a:p>
            <a:r>
              <a:rPr lang="en-GB" i="1" dirty="0" err="1"/>
              <a:t>Faecalibacterium</a:t>
            </a:r>
            <a:endParaRPr lang="de-DE" dirty="0"/>
          </a:p>
        </p:txBody>
      </p:sp>
      <p:sp>
        <p:nvSpPr>
          <p:cNvPr id="80" name="Textfeld 79"/>
          <p:cNvSpPr txBox="1"/>
          <p:nvPr/>
        </p:nvSpPr>
        <p:spPr>
          <a:xfrm>
            <a:off x="3104345" y="942009"/>
            <a:ext cx="1282723" cy="369332"/>
          </a:xfrm>
          <a:prstGeom prst="rect">
            <a:avLst/>
          </a:prstGeom>
          <a:noFill/>
        </p:spPr>
        <p:txBody>
          <a:bodyPr wrap="none" rtlCol="0">
            <a:spAutoFit/>
          </a:bodyPr>
          <a:lstStyle/>
          <a:p>
            <a:r>
              <a:rPr lang="en-GB" i="1"/>
              <a:t>Escherichia</a:t>
            </a:r>
            <a:r>
              <a:rPr lang="en-GB"/>
              <a:t> </a:t>
            </a:r>
            <a:endParaRPr lang="de-DE" dirty="0"/>
          </a:p>
        </p:txBody>
      </p:sp>
      <p:sp>
        <p:nvSpPr>
          <p:cNvPr id="81" name="Flussdiagramm: Grenzstelle 80">
            <a:extLst>
              <a:ext uri="{FF2B5EF4-FFF2-40B4-BE49-F238E27FC236}">
                <a16:creationId xmlns:a16="http://schemas.microsoft.com/office/drawing/2014/main" id="{D6A804C8-6E99-49FC-A321-F446BFE338A9}"/>
              </a:ext>
            </a:extLst>
          </p:cNvPr>
          <p:cNvSpPr/>
          <p:nvPr/>
        </p:nvSpPr>
        <p:spPr>
          <a:xfrm rot="21194613">
            <a:off x="3597803" y="4139796"/>
            <a:ext cx="401296" cy="243337"/>
          </a:xfrm>
          <a:prstGeom prst="flowChartTerminator">
            <a:avLst/>
          </a:prstGeom>
        </p:spPr>
        <p:style>
          <a:lnRef idx="1">
            <a:schemeClr val="accent2"/>
          </a:lnRef>
          <a:fillRef idx="3">
            <a:schemeClr val="accent2"/>
          </a:fillRef>
          <a:effectRef idx="2">
            <a:schemeClr val="accent2"/>
          </a:effectRef>
          <a:fontRef idx="minor">
            <a:schemeClr val="lt1"/>
          </a:fontRef>
        </p:style>
        <p:txBody>
          <a:bodyPr rot="0" spcFirstLastPara="0" vert="horz" wrap="square" lIns="95186" tIns="47593" rIns="95186" bIns="47593" numCol="1" spcCol="0" rtlCol="0" fromWordArt="0" anchor="ctr" anchorCtr="0" forceAA="0" compatLnSpc="1">
            <a:prstTxWarp prst="textNoShape">
              <a:avLst/>
            </a:prstTxWarp>
            <a:noAutofit/>
          </a:bodyP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defTabSz="475945"/>
            <a:endParaRPr lang="en-GB" sz="1873">
              <a:solidFill>
                <a:prstClr val="white"/>
              </a:solidFill>
              <a:latin typeface="Calibri" panose="020F0502020204030204"/>
            </a:endParaRPr>
          </a:p>
        </p:txBody>
      </p:sp>
      <p:sp>
        <p:nvSpPr>
          <p:cNvPr id="83" name="Rechteck 82"/>
          <p:cNvSpPr/>
          <p:nvPr/>
        </p:nvSpPr>
        <p:spPr>
          <a:xfrm>
            <a:off x="8576235" y="2479131"/>
            <a:ext cx="1248231" cy="668974"/>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r>
              <a:rPr lang="de-DE" dirty="0" err="1">
                <a:solidFill>
                  <a:schemeClr val="tx1"/>
                </a:solidFill>
              </a:rPr>
              <a:t>Butyrate</a:t>
            </a:r>
            <a:endParaRPr lang="de-DE" dirty="0">
              <a:solidFill>
                <a:schemeClr val="tx1"/>
              </a:solidFill>
            </a:endParaRPr>
          </a:p>
        </p:txBody>
      </p:sp>
      <p:sp>
        <p:nvSpPr>
          <p:cNvPr id="87" name="Textfeld 86"/>
          <p:cNvSpPr txBox="1"/>
          <p:nvPr/>
        </p:nvSpPr>
        <p:spPr>
          <a:xfrm>
            <a:off x="2983706" y="269406"/>
            <a:ext cx="1437702" cy="646331"/>
          </a:xfrm>
          <a:prstGeom prst="rect">
            <a:avLst/>
          </a:prstGeom>
          <a:noFill/>
        </p:spPr>
        <p:txBody>
          <a:bodyPr wrap="none" rtlCol="0">
            <a:spAutoFit/>
          </a:bodyPr>
          <a:lstStyle/>
          <a:p>
            <a:pPr algn="ctr"/>
            <a:r>
              <a:rPr lang="de-DE" dirty="0"/>
              <a:t>Primary </a:t>
            </a:r>
          </a:p>
          <a:p>
            <a:pPr algn="ctr"/>
            <a:r>
              <a:rPr lang="de-DE" dirty="0" err="1"/>
              <a:t>nutrient</a:t>
            </a:r>
            <a:r>
              <a:rPr lang="de-DE" dirty="0"/>
              <a:t> </a:t>
            </a:r>
            <a:r>
              <a:rPr lang="de-DE" dirty="0" err="1"/>
              <a:t>user</a:t>
            </a:r>
            <a:endParaRPr lang="de-DE" dirty="0"/>
          </a:p>
        </p:txBody>
      </p:sp>
      <p:sp>
        <p:nvSpPr>
          <p:cNvPr id="90" name="Textfeld 89"/>
          <p:cNvSpPr txBox="1"/>
          <p:nvPr/>
        </p:nvSpPr>
        <p:spPr>
          <a:xfrm>
            <a:off x="6941763" y="245268"/>
            <a:ext cx="1076320" cy="646331"/>
          </a:xfrm>
          <a:prstGeom prst="rect">
            <a:avLst/>
          </a:prstGeom>
          <a:noFill/>
        </p:spPr>
        <p:txBody>
          <a:bodyPr wrap="none" rtlCol="0">
            <a:spAutoFit/>
          </a:bodyPr>
          <a:lstStyle/>
          <a:p>
            <a:pPr algn="ctr"/>
            <a:r>
              <a:rPr lang="de-DE" dirty="0"/>
              <a:t>Potential </a:t>
            </a:r>
          </a:p>
          <a:p>
            <a:pPr algn="ctr"/>
            <a:r>
              <a:rPr lang="de-DE" dirty="0"/>
              <a:t>2⚬ </a:t>
            </a:r>
            <a:r>
              <a:rPr lang="de-DE" dirty="0" err="1"/>
              <a:t>user</a:t>
            </a:r>
            <a:endParaRPr lang="de-DE" dirty="0"/>
          </a:p>
        </p:txBody>
      </p:sp>
      <p:sp>
        <p:nvSpPr>
          <p:cNvPr id="91" name="Flussdiagramm: Grenzstelle 90">
            <a:extLst>
              <a:ext uri="{FF2B5EF4-FFF2-40B4-BE49-F238E27FC236}">
                <a16:creationId xmlns:a16="http://schemas.microsoft.com/office/drawing/2014/main" id="{D6A804C8-6E99-49FC-A321-F446BFE338A9}"/>
              </a:ext>
            </a:extLst>
          </p:cNvPr>
          <p:cNvSpPr/>
          <p:nvPr/>
        </p:nvSpPr>
        <p:spPr>
          <a:xfrm rot="405387" flipV="1">
            <a:off x="7137563" y="2550520"/>
            <a:ext cx="772452" cy="160317"/>
          </a:xfrm>
          <a:custGeom>
            <a:avLst/>
            <a:gdLst>
              <a:gd name="connsiteX0" fmla="*/ 3475 w 21600"/>
              <a:gd name="connsiteY0" fmla="*/ 0 h 21600"/>
              <a:gd name="connsiteX1" fmla="*/ 18125 w 21600"/>
              <a:gd name="connsiteY1" fmla="*/ 0 h 21600"/>
              <a:gd name="connsiteX2" fmla="*/ 21600 w 21600"/>
              <a:gd name="connsiteY2" fmla="*/ 10800 h 21600"/>
              <a:gd name="connsiteX3" fmla="*/ 18125 w 21600"/>
              <a:gd name="connsiteY3" fmla="*/ 21600 h 21600"/>
              <a:gd name="connsiteX4" fmla="*/ 3475 w 21600"/>
              <a:gd name="connsiteY4" fmla="*/ 21600 h 21600"/>
              <a:gd name="connsiteX5" fmla="*/ 0 w 21600"/>
              <a:gd name="connsiteY5" fmla="*/ 10800 h 21600"/>
              <a:gd name="connsiteX6" fmla="*/ 3475 w 21600"/>
              <a:gd name="connsiteY6" fmla="*/ 0 h 21600"/>
              <a:gd name="connsiteX0" fmla="*/ 2084 w 21668"/>
              <a:gd name="connsiteY0" fmla="*/ 0 h 22425"/>
              <a:gd name="connsiteX1" fmla="*/ 18193 w 21668"/>
              <a:gd name="connsiteY1" fmla="*/ 825 h 22425"/>
              <a:gd name="connsiteX2" fmla="*/ 21668 w 21668"/>
              <a:gd name="connsiteY2" fmla="*/ 11625 h 22425"/>
              <a:gd name="connsiteX3" fmla="*/ 18193 w 21668"/>
              <a:gd name="connsiteY3" fmla="*/ 22425 h 22425"/>
              <a:gd name="connsiteX4" fmla="*/ 3543 w 21668"/>
              <a:gd name="connsiteY4" fmla="*/ 22425 h 22425"/>
              <a:gd name="connsiteX5" fmla="*/ 68 w 21668"/>
              <a:gd name="connsiteY5" fmla="*/ 11625 h 22425"/>
              <a:gd name="connsiteX6" fmla="*/ 2084 w 21668"/>
              <a:gd name="connsiteY6" fmla="*/ 0 h 22425"/>
              <a:gd name="connsiteX0" fmla="*/ 2020 w 21604"/>
              <a:gd name="connsiteY0" fmla="*/ 0 h 22425"/>
              <a:gd name="connsiteX1" fmla="*/ 18129 w 21604"/>
              <a:gd name="connsiteY1" fmla="*/ 825 h 22425"/>
              <a:gd name="connsiteX2" fmla="*/ 21604 w 21604"/>
              <a:gd name="connsiteY2" fmla="*/ 11625 h 22425"/>
              <a:gd name="connsiteX3" fmla="*/ 18129 w 21604"/>
              <a:gd name="connsiteY3" fmla="*/ 22425 h 22425"/>
              <a:gd name="connsiteX4" fmla="*/ 2188 w 21604"/>
              <a:gd name="connsiteY4" fmla="*/ 22283 h 22425"/>
              <a:gd name="connsiteX5" fmla="*/ 4 w 21604"/>
              <a:gd name="connsiteY5" fmla="*/ 11625 h 22425"/>
              <a:gd name="connsiteX6" fmla="*/ 2020 w 21604"/>
              <a:gd name="connsiteY6" fmla="*/ 0 h 22425"/>
              <a:gd name="connsiteX0" fmla="*/ 2020 w 21635"/>
              <a:gd name="connsiteY0" fmla="*/ 0 h 22425"/>
              <a:gd name="connsiteX1" fmla="*/ 19252 w 21635"/>
              <a:gd name="connsiteY1" fmla="*/ 283 h 22425"/>
              <a:gd name="connsiteX2" fmla="*/ 21604 w 21635"/>
              <a:gd name="connsiteY2" fmla="*/ 11625 h 22425"/>
              <a:gd name="connsiteX3" fmla="*/ 18129 w 21635"/>
              <a:gd name="connsiteY3" fmla="*/ 22425 h 22425"/>
              <a:gd name="connsiteX4" fmla="*/ 2188 w 21635"/>
              <a:gd name="connsiteY4" fmla="*/ 22283 h 22425"/>
              <a:gd name="connsiteX5" fmla="*/ 4 w 21635"/>
              <a:gd name="connsiteY5" fmla="*/ 11625 h 22425"/>
              <a:gd name="connsiteX6" fmla="*/ 2020 w 21635"/>
              <a:gd name="connsiteY6" fmla="*/ 0 h 22425"/>
              <a:gd name="connsiteX0" fmla="*/ 2020 w 21604"/>
              <a:gd name="connsiteY0" fmla="*/ 0 h 22754"/>
              <a:gd name="connsiteX1" fmla="*/ 19252 w 21604"/>
              <a:gd name="connsiteY1" fmla="*/ 283 h 22754"/>
              <a:gd name="connsiteX2" fmla="*/ 21604 w 21604"/>
              <a:gd name="connsiteY2" fmla="*/ 11625 h 22754"/>
              <a:gd name="connsiteX3" fmla="*/ 19230 w 21604"/>
              <a:gd name="connsiteY3" fmla="*/ 22754 h 22754"/>
              <a:gd name="connsiteX4" fmla="*/ 2188 w 21604"/>
              <a:gd name="connsiteY4" fmla="*/ 22283 h 22754"/>
              <a:gd name="connsiteX5" fmla="*/ 4 w 21604"/>
              <a:gd name="connsiteY5" fmla="*/ 11625 h 22754"/>
              <a:gd name="connsiteX6" fmla="*/ 2020 w 21604"/>
              <a:gd name="connsiteY6" fmla="*/ 0 h 22754"/>
              <a:gd name="connsiteX0" fmla="*/ 2020 w 21604"/>
              <a:gd name="connsiteY0" fmla="*/ 0 h 22754"/>
              <a:gd name="connsiteX1" fmla="*/ 19252 w 21604"/>
              <a:gd name="connsiteY1" fmla="*/ 283 h 22754"/>
              <a:gd name="connsiteX2" fmla="*/ 21604 w 21604"/>
              <a:gd name="connsiteY2" fmla="*/ 11625 h 22754"/>
              <a:gd name="connsiteX3" fmla="*/ 19230 w 21604"/>
              <a:gd name="connsiteY3" fmla="*/ 22754 h 22754"/>
              <a:gd name="connsiteX4" fmla="*/ 2188 w 21604"/>
              <a:gd name="connsiteY4" fmla="*/ 22283 h 22754"/>
              <a:gd name="connsiteX5" fmla="*/ 4 w 21604"/>
              <a:gd name="connsiteY5" fmla="*/ 11625 h 22754"/>
              <a:gd name="connsiteX6" fmla="*/ 2020 w 21604"/>
              <a:gd name="connsiteY6" fmla="*/ 0 h 22754"/>
              <a:gd name="connsiteX0" fmla="*/ 2020 w 21604"/>
              <a:gd name="connsiteY0" fmla="*/ 2007 h 24761"/>
              <a:gd name="connsiteX1" fmla="*/ 14087 w 21604"/>
              <a:gd name="connsiteY1" fmla="*/ 6 h 24761"/>
              <a:gd name="connsiteX2" fmla="*/ 19252 w 21604"/>
              <a:gd name="connsiteY2" fmla="*/ 2290 h 24761"/>
              <a:gd name="connsiteX3" fmla="*/ 21604 w 21604"/>
              <a:gd name="connsiteY3" fmla="*/ 13632 h 24761"/>
              <a:gd name="connsiteX4" fmla="*/ 19230 w 21604"/>
              <a:gd name="connsiteY4" fmla="*/ 24761 h 24761"/>
              <a:gd name="connsiteX5" fmla="*/ 2188 w 21604"/>
              <a:gd name="connsiteY5" fmla="*/ 24290 h 24761"/>
              <a:gd name="connsiteX6" fmla="*/ 4 w 21604"/>
              <a:gd name="connsiteY6" fmla="*/ 13632 h 24761"/>
              <a:gd name="connsiteX7" fmla="*/ 2020 w 21604"/>
              <a:gd name="connsiteY7" fmla="*/ 2007 h 24761"/>
              <a:gd name="connsiteX0" fmla="*/ 2020 w 21604"/>
              <a:gd name="connsiteY0" fmla="*/ 2013 h 24767"/>
              <a:gd name="connsiteX1" fmla="*/ 7336 w 21604"/>
              <a:gd name="connsiteY1" fmla="*/ 3846 h 24767"/>
              <a:gd name="connsiteX2" fmla="*/ 14087 w 21604"/>
              <a:gd name="connsiteY2" fmla="*/ 12 h 24767"/>
              <a:gd name="connsiteX3" fmla="*/ 19252 w 21604"/>
              <a:gd name="connsiteY3" fmla="*/ 2296 h 24767"/>
              <a:gd name="connsiteX4" fmla="*/ 21604 w 21604"/>
              <a:gd name="connsiteY4" fmla="*/ 13638 h 24767"/>
              <a:gd name="connsiteX5" fmla="*/ 19230 w 21604"/>
              <a:gd name="connsiteY5" fmla="*/ 24767 h 24767"/>
              <a:gd name="connsiteX6" fmla="*/ 2188 w 21604"/>
              <a:gd name="connsiteY6" fmla="*/ 24296 h 24767"/>
              <a:gd name="connsiteX7" fmla="*/ 4 w 21604"/>
              <a:gd name="connsiteY7" fmla="*/ 13638 h 24767"/>
              <a:gd name="connsiteX8" fmla="*/ 2020 w 21604"/>
              <a:gd name="connsiteY8" fmla="*/ 2013 h 24767"/>
              <a:gd name="connsiteX0" fmla="*/ 2020 w 21604"/>
              <a:gd name="connsiteY0" fmla="*/ 2013 h 26293"/>
              <a:gd name="connsiteX1" fmla="*/ 7336 w 21604"/>
              <a:gd name="connsiteY1" fmla="*/ 3846 h 26293"/>
              <a:gd name="connsiteX2" fmla="*/ 14087 w 21604"/>
              <a:gd name="connsiteY2" fmla="*/ 12 h 26293"/>
              <a:gd name="connsiteX3" fmla="*/ 19252 w 21604"/>
              <a:gd name="connsiteY3" fmla="*/ 2296 h 26293"/>
              <a:gd name="connsiteX4" fmla="*/ 21604 w 21604"/>
              <a:gd name="connsiteY4" fmla="*/ 13638 h 26293"/>
              <a:gd name="connsiteX5" fmla="*/ 19230 w 21604"/>
              <a:gd name="connsiteY5" fmla="*/ 24767 h 26293"/>
              <a:gd name="connsiteX6" fmla="*/ 7397 w 21604"/>
              <a:gd name="connsiteY6" fmla="*/ 26253 h 26293"/>
              <a:gd name="connsiteX7" fmla="*/ 2188 w 21604"/>
              <a:gd name="connsiteY7" fmla="*/ 24296 h 26293"/>
              <a:gd name="connsiteX8" fmla="*/ 4 w 21604"/>
              <a:gd name="connsiteY8" fmla="*/ 13638 h 26293"/>
              <a:gd name="connsiteX9" fmla="*/ 2020 w 21604"/>
              <a:gd name="connsiteY9" fmla="*/ 2013 h 26293"/>
              <a:gd name="connsiteX0" fmla="*/ 2020 w 21604"/>
              <a:gd name="connsiteY0" fmla="*/ 2013 h 26286"/>
              <a:gd name="connsiteX1" fmla="*/ 7336 w 21604"/>
              <a:gd name="connsiteY1" fmla="*/ 3846 h 26286"/>
              <a:gd name="connsiteX2" fmla="*/ 14087 w 21604"/>
              <a:gd name="connsiteY2" fmla="*/ 12 h 26286"/>
              <a:gd name="connsiteX3" fmla="*/ 19252 w 21604"/>
              <a:gd name="connsiteY3" fmla="*/ 2296 h 26286"/>
              <a:gd name="connsiteX4" fmla="*/ 21604 w 21604"/>
              <a:gd name="connsiteY4" fmla="*/ 13638 h 26286"/>
              <a:gd name="connsiteX5" fmla="*/ 19230 w 21604"/>
              <a:gd name="connsiteY5" fmla="*/ 24767 h 26286"/>
              <a:gd name="connsiteX6" fmla="*/ 16146 w 21604"/>
              <a:gd name="connsiteY6" fmla="*/ 23845 h 26286"/>
              <a:gd name="connsiteX7" fmla="*/ 7397 w 21604"/>
              <a:gd name="connsiteY7" fmla="*/ 26253 h 26286"/>
              <a:gd name="connsiteX8" fmla="*/ 2188 w 21604"/>
              <a:gd name="connsiteY8" fmla="*/ 24296 h 26286"/>
              <a:gd name="connsiteX9" fmla="*/ 4 w 21604"/>
              <a:gd name="connsiteY9" fmla="*/ 13638 h 26286"/>
              <a:gd name="connsiteX10" fmla="*/ 2020 w 21604"/>
              <a:gd name="connsiteY10" fmla="*/ 2013 h 26286"/>
              <a:gd name="connsiteX0" fmla="*/ 2020 w 21633"/>
              <a:gd name="connsiteY0" fmla="*/ 2013 h 26286"/>
              <a:gd name="connsiteX1" fmla="*/ 7336 w 21633"/>
              <a:gd name="connsiteY1" fmla="*/ 3846 h 26286"/>
              <a:gd name="connsiteX2" fmla="*/ 14087 w 21633"/>
              <a:gd name="connsiteY2" fmla="*/ 12 h 26286"/>
              <a:gd name="connsiteX3" fmla="*/ 19252 w 21633"/>
              <a:gd name="connsiteY3" fmla="*/ 2296 h 26286"/>
              <a:gd name="connsiteX4" fmla="*/ 21604 w 21633"/>
              <a:gd name="connsiteY4" fmla="*/ 13638 h 26286"/>
              <a:gd name="connsiteX5" fmla="*/ 20260 w 21633"/>
              <a:gd name="connsiteY5" fmla="*/ 22995 h 26286"/>
              <a:gd name="connsiteX6" fmla="*/ 16146 w 21633"/>
              <a:gd name="connsiteY6" fmla="*/ 23845 h 26286"/>
              <a:gd name="connsiteX7" fmla="*/ 7397 w 21633"/>
              <a:gd name="connsiteY7" fmla="*/ 26253 h 26286"/>
              <a:gd name="connsiteX8" fmla="*/ 2188 w 21633"/>
              <a:gd name="connsiteY8" fmla="*/ 24296 h 26286"/>
              <a:gd name="connsiteX9" fmla="*/ 4 w 21633"/>
              <a:gd name="connsiteY9" fmla="*/ 13638 h 26286"/>
              <a:gd name="connsiteX10" fmla="*/ 2020 w 21633"/>
              <a:gd name="connsiteY10" fmla="*/ 2013 h 262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21633" h="26286">
                <a:moveTo>
                  <a:pt x="2020" y="2013"/>
                </a:moveTo>
                <a:cubicBezTo>
                  <a:pt x="3111" y="-135"/>
                  <a:pt x="5325" y="4179"/>
                  <a:pt x="7336" y="3846"/>
                </a:cubicBezTo>
                <a:cubicBezTo>
                  <a:pt x="9347" y="3513"/>
                  <a:pt x="11970" y="-246"/>
                  <a:pt x="14087" y="12"/>
                </a:cubicBezTo>
                <a:cubicBezTo>
                  <a:pt x="16204" y="270"/>
                  <a:pt x="17713" y="403"/>
                  <a:pt x="19252" y="2296"/>
                </a:cubicBezTo>
                <a:cubicBezTo>
                  <a:pt x="21171" y="2296"/>
                  <a:pt x="21436" y="10188"/>
                  <a:pt x="21604" y="13638"/>
                </a:cubicBezTo>
                <a:cubicBezTo>
                  <a:pt x="21772" y="17088"/>
                  <a:pt x="21201" y="20870"/>
                  <a:pt x="20260" y="22995"/>
                </a:cubicBezTo>
                <a:cubicBezTo>
                  <a:pt x="19319" y="25120"/>
                  <a:pt x="18118" y="23597"/>
                  <a:pt x="16146" y="23845"/>
                </a:cubicBezTo>
                <a:cubicBezTo>
                  <a:pt x="14174" y="24093"/>
                  <a:pt x="9692" y="26602"/>
                  <a:pt x="7397" y="26253"/>
                </a:cubicBezTo>
                <a:cubicBezTo>
                  <a:pt x="5102" y="25904"/>
                  <a:pt x="3399" y="25994"/>
                  <a:pt x="2188" y="24296"/>
                </a:cubicBezTo>
                <a:cubicBezTo>
                  <a:pt x="269" y="24296"/>
                  <a:pt x="32" y="17352"/>
                  <a:pt x="4" y="13638"/>
                </a:cubicBezTo>
                <a:cubicBezTo>
                  <a:pt x="-24" y="9924"/>
                  <a:pt x="101" y="2013"/>
                  <a:pt x="2020" y="2013"/>
                </a:cubicBezTo>
                <a:close/>
              </a:path>
            </a:pathLst>
          </a:custGeom>
          <a:solidFill>
            <a:srgbClr val="FF6699"/>
          </a:solidFill>
          <a:ln>
            <a:solidFill>
              <a:srgbClr val="FF6699"/>
            </a:solidFill>
          </a:ln>
        </p:spPr>
        <p:style>
          <a:lnRef idx="1">
            <a:schemeClr val="accent2"/>
          </a:lnRef>
          <a:fillRef idx="3">
            <a:schemeClr val="accent2"/>
          </a:fillRef>
          <a:effectRef idx="2">
            <a:schemeClr val="accent2"/>
          </a:effectRef>
          <a:fontRef idx="minor">
            <a:schemeClr val="lt1"/>
          </a:fontRef>
        </p:style>
        <p:txBody>
          <a:bodyPr rot="0" spcFirstLastPara="0" vert="horz" wrap="square" lIns="95186" tIns="47593" rIns="95186" bIns="47593" numCol="1" spcCol="0" rtlCol="0" fromWordArt="0" anchor="ctr" anchorCtr="0" forceAA="0" compatLnSpc="1">
            <a:prstTxWarp prst="textNoShape">
              <a:avLst/>
            </a:prstTxWarp>
            <a:noAutofit/>
          </a:bodyP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defTabSz="475945"/>
            <a:endParaRPr lang="en-GB" sz="1873">
              <a:solidFill>
                <a:prstClr val="white"/>
              </a:solidFill>
              <a:latin typeface="Calibri" panose="020F0502020204030204"/>
            </a:endParaRPr>
          </a:p>
        </p:txBody>
      </p:sp>
    </p:spTree>
    <p:extLst>
      <p:ext uri="{BB962C8B-B14F-4D97-AF65-F5344CB8AC3E}">
        <p14:creationId xmlns:p14="http://schemas.microsoft.com/office/powerpoint/2010/main" val="316875232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79</TotalTime>
  <Words>537</Words>
  <Application>Microsoft Office PowerPoint</Application>
  <PresentationFormat>Widescreen</PresentationFormat>
  <Paragraphs>50</Paragraphs>
  <Slides>8</Slides>
  <Notes>2</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3" baseType="lpstr">
      <vt:lpstr>Arial</vt:lpstr>
      <vt:lpstr>Calibri</vt:lpstr>
      <vt:lpstr>Calibri Light</vt:lpstr>
      <vt:lpstr>Office Theme</vt:lpstr>
      <vt:lpstr>Prism 5</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NBI</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ndsay Hall (IFR)</dc:creator>
  <cp:lastModifiedBy>Lindsay Hall (QIB)</cp:lastModifiedBy>
  <cp:revision>89</cp:revision>
  <dcterms:created xsi:type="dcterms:W3CDTF">2019-04-26T13:12:16Z</dcterms:created>
  <dcterms:modified xsi:type="dcterms:W3CDTF">2019-12-16T09:57:22Z</dcterms:modified>
</cp:coreProperties>
</file>